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40" d="100"/>
          <a:sy n="140" d="100"/>
        </p:scale>
        <p:origin x="-1236" y="-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F7A9-3AEA-47DC-899A-CBA8E91BC2EE}" type="datetimeFigureOut">
              <a:rPr lang="fr-FR" smtClean="0"/>
              <a:t>28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0AEC6-411A-4B4C-A13D-0FA7A2759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030189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F7A9-3AEA-47DC-899A-CBA8E91BC2EE}" type="datetimeFigureOut">
              <a:rPr lang="fr-FR" smtClean="0"/>
              <a:t>28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0AEC6-411A-4B4C-A13D-0FA7A2759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733564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9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F7A9-3AEA-47DC-899A-CBA8E91BC2EE}" type="datetimeFigureOut">
              <a:rPr lang="fr-FR" smtClean="0"/>
              <a:t>28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0AEC6-411A-4B4C-A13D-0FA7A2759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435282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F7A9-3AEA-47DC-899A-CBA8E91BC2EE}" type="datetimeFigureOut">
              <a:rPr lang="fr-FR" smtClean="0"/>
              <a:t>28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0AEC6-411A-4B4C-A13D-0FA7A2759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023837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7"/>
            <a:ext cx="5915025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9"/>
            <a:ext cx="5915025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/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F7A9-3AEA-47DC-899A-CBA8E91BC2EE}" type="datetimeFigureOut">
              <a:rPr lang="fr-FR" smtClean="0"/>
              <a:t>28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0AEC6-411A-4B4C-A13D-0FA7A2759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768200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F7A9-3AEA-47DC-899A-CBA8E91BC2EE}" type="datetimeFigureOut">
              <a:rPr lang="fr-FR" smtClean="0"/>
              <a:t>28/02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0AEC6-411A-4B4C-A13D-0FA7A2759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096136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8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7"/>
            <a:ext cx="291554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F7A9-3AEA-47DC-899A-CBA8E91BC2EE}" type="datetimeFigureOut">
              <a:rPr lang="fr-FR" smtClean="0"/>
              <a:t>28/02/2018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0AEC6-411A-4B4C-A13D-0FA7A2759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111218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F7A9-3AEA-47DC-899A-CBA8E91BC2EE}" type="datetimeFigureOut">
              <a:rPr lang="fr-FR" smtClean="0"/>
              <a:t>28/02/2018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0AEC6-411A-4B4C-A13D-0FA7A2759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978765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F7A9-3AEA-47DC-899A-CBA8E91BC2EE}" type="datetimeFigureOut">
              <a:rPr lang="fr-FR" smtClean="0"/>
              <a:t>28/02/2018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0AEC6-411A-4B4C-A13D-0FA7A2759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584788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5"/>
            <a:ext cx="3471863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F7A9-3AEA-47DC-899A-CBA8E91BC2EE}" type="datetimeFigureOut">
              <a:rPr lang="fr-FR" smtClean="0"/>
              <a:t>28/02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0AEC6-411A-4B4C-A13D-0FA7A2759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902475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5"/>
            <a:ext cx="3471863" cy="7039681"/>
          </a:xfrm>
        </p:spPr>
        <p:txBody>
          <a:bodyPr anchor="t"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F7A9-3AEA-47DC-899A-CBA8E91BC2EE}" type="datetimeFigureOut">
              <a:rPr lang="fr-FR" smtClean="0"/>
              <a:t>28/02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0AEC6-411A-4B4C-A13D-0FA7A2759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177668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8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D5F7A9-3AEA-47DC-899A-CBA8E91BC2EE}" type="datetimeFigureOut">
              <a:rPr lang="fr-FR" smtClean="0"/>
              <a:t>28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9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C0AEC6-411A-4B4C-A13D-0FA7A2759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509065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205"/>
          <p:cNvGrpSpPr>
            <a:grpSpLocks/>
          </p:cNvGrpSpPr>
          <p:nvPr/>
        </p:nvGrpSpPr>
        <p:grpSpPr bwMode="auto">
          <a:xfrm>
            <a:off x="179388" y="227013"/>
            <a:ext cx="6067427" cy="9685338"/>
            <a:chOff x="113" y="143"/>
            <a:chExt cx="3822" cy="6101"/>
          </a:xfrm>
        </p:grpSpPr>
        <p:sp>
          <p:nvSpPr>
            <p:cNvPr id="125" name="Line 5"/>
            <p:cNvSpPr>
              <a:spLocks noChangeShapeType="1"/>
            </p:cNvSpPr>
            <p:nvPr/>
          </p:nvSpPr>
          <p:spPr bwMode="auto">
            <a:xfrm>
              <a:off x="1685" y="6129"/>
              <a:ext cx="370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26" name="Rectangle 6"/>
            <p:cNvSpPr>
              <a:spLocks noChangeArrowheads="1"/>
            </p:cNvSpPr>
            <p:nvPr/>
          </p:nvSpPr>
          <p:spPr bwMode="auto">
            <a:xfrm>
              <a:off x="1842" y="6166"/>
              <a:ext cx="73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dobe Devanagari" panose="02040503050201020203" pitchFamily="18" charset="0"/>
                </a:rPr>
                <a:t>0.6</a:t>
              </a:r>
              <a:endParaRPr kumimoji="0" lang="fr-FR" altLang="fr-FR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27" name="Freeform 7"/>
            <p:cNvSpPr>
              <a:spLocks/>
            </p:cNvSpPr>
            <p:nvPr/>
          </p:nvSpPr>
          <p:spPr bwMode="auto">
            <a:xfrm>
              <a:off x="1640" y="3845"/>
              <a:ext cx="1987" cy="106"/>
            </a:xfrm>
            <a:custGeom>
              <a:avLst/>
              <a:gdLst>
                <a:gd name="T0" fmla="*/ 0 w 16237"/>
                <a:gd name="T1" fmla="*/ 0 h 661"/>
                <a:gd name="T2" fmla="*/ 0 w 16237"/>
                <a:gd name="T3" fmla="*/ 330 h 661"/>
                <a:gd name="T4" fmla="*/ 0 w 16237"/>
                <a:gd name="T5" fmla="*/ 661 h 661"/>
                <a:gd name="T6" fmla="*/ 16237 w 16237"/>
                <a:gd name="T7" fmla="*/ 661 h 661"/>
                <a:gd name="T8" fmla="*/ 16237 w 16237"/>
                <a:gd name="T9" fmla="*/ 220 h 661"/>
                <a:gd name="T10" fmla="*/ 398 w 16237"/>
                <a:gd name="T11" fmla="*/ 220 h 661"/>
                <a:gd name="T12" fmla="*/ 398 w 16237"/>
                <a:gd name="T13" fmla="*/ 0 h 661"/>
                <a:gd name="T14" fmla="*/ 0 w 16237"/>
                <a:gd name="T15" fmla="*/ 0 h 6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6237" h="661">
                  <a:moveTo>
                    <a:pt x="0" y="0"/>
                  </a:moveTo>
                  <a:lnTo>
                    <a:pt x="0" y="330"/>
                  </a:lnTo>
                  <a:lnTo>
                    <a:pt x="0" y="661"/>
                  </a:lnTo>
                  <a:lnTo>
                    <a:pt x="16237" y="661"/>
                  </a:lnTo>
                  <a:lnTo>
                    <a:pt x="16237" y="220"/>
                  </a:lnTo>
                  <a:lnTo>
                    <a:pt x="398" y="220"/>
                  </a:lnTo>
                  <a:lnTo>
                    <a:pt x="398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28" name="Freeform 8"/>
            <p:cNvSpPr>
              <a:spLocks/>
            </p:cNvSpPr>
            <p:nvPr/>
          </p:nvSpPr>
          <p:spPr bwMode="auto">
            <a:xfrm>
              <a:off x="2575" y="5573"/>
              <a:ext cx="1052" cy="106"/>
            </a:xfrm>
            <a:custGeom>
              <a:avLst/>
              <a:gdLst>
                <a:gd name="T0" fmla="*/ 0 w 8599"/>
                <a:gd name="T1" fmla="*/ 0 h 661"/>
                <a:gd name="T2" fmla="*/ 0 w 8599"/>
                <a:gd name="T3" fmla="*/ 331 h 661"/>
                <a:gd name="T4" fmla="*/ 0 w 8599"/>
                <a:gd name="T5" fmla="*/ 661 h 661"/>
                <a:gd name="T6" fmla="*/ 397 w 8599"/>
                <a:gd name="T7" fmla="*/ 661 h 661"/>
                <a:gd name="T8" fmla="*/ 397 w 8599"/>
                <a:gd name="T9" fmla="*/ 441 h 661"/>
                <a:gd name="T10" fmla="*/ 8599 w 8599"/>
                <a:gd name="T11" fmla="*/ 441 h 661"/>
                <a:gd name="T12" fmla="*/ 8599 w 8599"/>
                <a:gd name="T13" fmla="*/ 0 h 661"/>
                <a:gd name="T14" fmla="*/ 0 w 8599"/>
                <a:gd name="T15" fmla="*/ 0 h 6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8599" h="661">
                  <a:moveTo>
                    <a:pt x="0" y="0"/>
                  </a:moveTo>
                  <a:lnTo>
                    <a:pt x="0" y="331"/>
                  </a:lnTo>
                  <a:lnTo>
                    <a:pt x="0" y="661"/>
                  </a:lnTo>
                  <a:lnTo>
                    <a:pt x="397" y="661"/>
                  </a:lnTo>
                  <a:lnTo>
                    <a:pt x="397" y="441"/>
                  </a:lnTo>
                  <a:lnTo>
                    <a:pt x="8599" y="441"/>
                  </a:lnTo>
                  <a:lnTo>
                    <a:pt x="8599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29" name="Freeform 9"/>
            <p:cNvSpPr>
              <a:spLocks/>
            </p:cNvSpPr>
            <p:nvPr/>
          </p:nvSpPr>
          <p:spPr bwMode="auto">
            <a:xfrm>
              <a:off x="3284" y="5079"/>
              <a:ext cx="343" cy="71"/>
            </a:xfrm>
            <a:custGeom>
              <a:avLst/>
              <a:gdLst>
                <a:gd name="T0" fmla="*/ 0 w 2803"/>
                <a:gd name="T1" fmla="*/ 0 h 441"/>
                <a:gd name="T2" fmla="*/ 0 w 2803"/>
                <a:gd name="T3" fmla="*/ 221 h 441"/>
                <a:gd name="T4" fmla="*/ 0 w 2803"/>
                <a:gd name="T5" fmla="*/ 441 h 441"/>
                <a:gd name="T6" fmla="*/ 2803 w 2803"/>
                <a:gd name="T7" fmla="*/ 441 h 441"/>
                <a:gd name="T8" fmla="*/ 2803 w 2803"/>
                <a:gd name="T9" fmla="*/ 0 h 441"/>
                <a:gd name="T10" fmla="*/ 0 w 2803"/>
                <a:gd name="T11" fmla="*/ 0 h 4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803" h="441">
                  <a:moveTo>
                    <a:pt x="0" y="0"/>
                  </a:moveTo>
                  <a:lnTo>
                    <a:pt x="0" y="221"/>
                  </a:lnTo>
                  <a:lnTo>
                    <a:pt x="0" y="441"/>
                  </a:lnTo>
                  <a:lnTo>
                    <a:pt x="2803" y="441"/>
                  </a:lnTo>
                  <a:lnTo>
                    <a:pt x="2803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30" name="Freeform 10"/>
            <p:cNvSpPr>
              <a:spLocks/>
            </p:cNvSpPr>
            <p:nvPr/>
          </p:nvSpPr>
          <p:spPr bwMode="auto">
            <a:xfrm>
              <a:off x="2590" y="5167"/>
              <a:ext cx="1037" cy="124"/>
            </a:xfrm>
            <a:custGeom>
              <a:avLst/>
              <a:gdLst>
                <a:gd name="T0" fmla="*/ 0 w 8479"/>
                <a:gd name="T1" fmla="*/ 0 h 772"/>
                <a:gd name="T2" fmla="*/ 0 w 8479"/>
                <a:gd name="T3" fmla="*/ 386 h 772"/>
                <a:gd name="T4" fmla="*/ 0 w 8479"/>
                <a:gd name="T5" fmla="*/ 772 h 772"/>
                <a:gd name="T6" fmla="*/ 8479 w 8479"/>
                <a:gd name="T7" fmla="*/ 772 h 772"/>
                <a:gd name="T8" fmla="*/ 8479 w 8479"/>
                <a:gd name="T9" fmla="*/ 331 h 772"/>
                <a:gd name="T10" fmla="*/ 1179 w 8479"/>
                <a:gd name="T11" fmla="*/ 331 h 772"/>
                <a:gd name="T12" fmla="*/ 1179 w 8479"/>
                <a:gd name="T13" fmla="*/ 0 h 772"/>
                <a:gd name="T14" fmla="*/ 0 w 8479"/>
                <a:gd name="T15" fmla="*/ 0 h 7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8479" h="772">
                  <a:moveTo>
                    <a:pt x="0" y="0"/>
                  </a:moveTo>
                  <a:lnTo>
                    <a:pt x="0" y="386"/>
                  </a:lnTo>
                  <a:lnTo>
                    <a:pt x="0" y="772"/>
                  </a:lnTo>
                  <a:lnTo>
                    <a:pt x="8479" y="772"/>
                  </a:lnTo>
                  <a:lnTo>
                    <a:pt x="8479" y="331"/>
                  </a:lnTo>
                  <a:lnTo>
                    <a:pt x="1179" y="331"/>
                  </a:lnTo>
                  <a:lnTo>
                    <a:pt x="1179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31" name="Freeform 11"/>
            <p:cNvSpPr>
              <a:spLocks/>
            </p:cNvSpPr>
            <p:nvPr/>
          </p:nvSpPr>
          <p:spPr bwMode="auto">
            <a:xfrm>
              <a:off x="2346" y="3669"/>
              <a:ext cx="1281" cy="70"/>
            </a:xfrm>
            <a:custGeom>
              <a:avLst/>
              <a:gdLst>
                <a:gd name="T0" fmla="*/ 0 w 10470"/>
                <a:gd name="T1" fmla="*/ 0 h 441"/>
                <a:gd name="T2" fmla="*/ 0 w 10470"/>
                <a:gd name="T3" fmla="*/ 221 h 441"/>
                <a:gd name="T4" fmla="*/ 0 w 10470"/>
                <a:gd name="T5" fmla="*/ 441 h 441"/>
                <a:gd name="T6" fmla="*/ 10470 w 10470"/>
                <a:gd name="T7" fmla="*/ 441 h 441"/>
                <a:gd name="T8" fmla="*/ 10470 w 10470"/>
                <a:gd name="T9" fmla="*/ 0 h 441"/>
                <a:gd name="T10" fmla="*/ 0 w 10470"/>
                <a:gd name="T11" fmla="*/ 0 h 4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0470" h="441">
                  <a:moveTo>
                    <a:pt x="0" y="0"/>
                  </a:moveTo>
                  <a:lnTo>
                    <a:pt x="0" y="221"/>
                  </a:lnTo>
                  <a:lnTo>
                    <a:pt x="0" y="441"/>
                  </a:lnTo>
                  <a:lnTo>
                    <a:pt x="10470" y="441"/>
                  </a:lnTo>
                  <a:lnTo>
                    <a:pt x="1047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32" name="Freeform 12"/>
            <p:cNvSpPr>
              <a:spLocks/>
            </p:cNvSpPr>
            <p:nvPr/>
          </p:nvSpPr>
          <p:spPr bwMode="auto">
            <a:xfrm>
              <a:off x="2056" y="5564"/>
              <a:ext cx="1571" cy="273"/>
            </a:xfrm>
            <a:custGeom>
              <a:avLst/>
              <a:gdLst>
                <a:gd name="T0" fmla="*/ 0 w 12837"/>
                <a:gd name="T1" fmla="*/ 0 h 1708"/>
                <a:gd name="T2" fmla="*/ 0 w 12837"/>
                <a:gd name="T3" fmla="*/ 854 h 1708"/>
                <a:gd name="T4" fmla="*/ 0 w 12837"/>
                <a:gd name="T5" fmla="*/ 1708 h 1708"/>
                <a:gd name="T6" fmla="*/ 861 w 12837"/>
                <a:gd name="T7" fmla="*/ 1708 h 1708"/>
                <a:gd name="T8" fmla="*/ 861 w 12837"/>
                <a:gd name="T9" fmla="*/ 1378 h 1708"/>
                <a:gd name="T10" fmla="*/ 12837 w 12837"/>
                <a:gd name="T11" fmla="*/ 1378 h 1708"/>
                <a:gd name="T12" fmla="*/ 12837 w 12837"/>
                <a:gd name="T13" fmla="*/ 937 h 1708"/>
                <a:gd name="T14" fmla="*/ 4635 w 12837"/>
                <a:gd name="T15" fmla="*/ 937 h 1708"/>
                <a:gd name="T16" fmla="*/ 4635 w 12837"/>
                <a:gd name="T17" fmla="*/ 716 h 1708"/>
                <a:gd name="T18" fmla="*/ 4238 w 12837"/>
                <a:gd name="T19" fmla="*/ 716 h 1708"/>
                <a:gd name="T20" fmla="*/ 4238 w 12837"/>
                <a:gd name="T21" fmla="*/ 386 h 1708"/>
                <a:gd name="T22" fmla="*/ 971 w 12837"/>
                <a:gd name="T23" fmla="*/ 386 h 1708"/>
                <a:gd name="T24" fmla="*/ 971 w 12837"/>
                <a:gd name="T25" fmla="*/ 0 h 1708"/>
                <a:gd name="T26" fmla="*/ 0 w 12837"/>
                <a:gd name="T27" fmla="*/ 0 h 17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12837" h="1708">
                  <a:moveTo>
                    <a:pt x="0" y="0"/>
                  </a:moveTo>
                  <a:lnTo>
                    <a:pt x="0" y="854"/>
                  </a:lnTo>
                  <a:lnTo>
                    <a:pt x="0" y="1708"/>
                  </a:lnTo>
                  <a:lnTo>
                    <a:pt x="861" y="1708"/>
                  </a:lnTo>
                  <a:lnTo>
                    <a:pt x="861" y="1378"/>
                  </a:lnTo>
                  <a:lnTo>
                    <a:pt x="12837" y="1378"/>
                  </a:lnTo>
                  <a:lnTo>
                    <a:pt x="12837" y="937"/>
                  </a:lnTo>
                  <a:lnTo>
                    <a:pt x="4635" y="937"/>
                  </a:lnTo>
                  <a:lnTo>
                    <a:pt x="4635" y="716"/>
                  </a:lnTo>
                  <a:lnTo>
                    <a:pt x="4238" y="716"/>
                  </a:lnTo>
                  <a:lnTo>
                    <a:pt x="4238" y="386"/>
                  </a:lnTo>
                  <a:lnTo>
                    <a:pt x="971" y="386"/>
                  </a:lnTo>
                  <a:lnTo>
                    <a:pt x="971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33" name="Freeform 13"/>
            <p:cNvSpPr>
              <a:spLocks/>
            </p:cNvSpPr>
            <p:nvPr/>
          </p:nvSpPr>
          <p:spPr bwMode="auto">
            <a:xfrm>
              <a:off x="147" y="626"/>
              <a:ext cx="3480" cy="5405"/>
            </a:xfrm>
            <a:custGeom>
              <a:avLst/>
              <a:gdLst>
                <a:gd name="T0" fmla="*/ 0 w 28436"/>
                <a:gd name="T1" fmla="*/ 0 h 33796"/>
                <a:gd name="T2" fmla="*/ 0 w 28436"/>
                <a:gd name="T3" fmla="*/ 16898 h 33796"/>
                <a:gd name="T4" fmla="*/ 0 w 28436"/>
                <a:gd name="T5" fmla="*/ 33796 h 33796"/>
                <a:gd name="T6" fmla="*/ 2731 w 28436"/>
                <a:gd name="T7" fmla="*/ 33796 h 33796"/>
                <a:gd name="T8" fmla="*/ 2731 w 28436"/>
                <a:gd name="T9" fmla="*/ 33576 h 33796"/>
                <a:gd name="T10" fmla="*/ 28436 w 28436"/>
                <a:gd name="T11" fmla="*/ 33576 h 33796"/>
                <a:gd name="T12" fmla="*/ 28436 w 28436"/>
                <a:gd name="T13" fmla="*/ 33135 h 33796"/>
                <a:gd name="T14" fmla="*/ 17615 w 28436"/>
                <a:gd name="T15" fmla="*/ 33135 h 33796"/>
                <a:gd name="T16" fmla="*/ 17615 w 28436"/>
                <a:gd name="T17" fmla="*/ 32914 h 33796"/>
                <a:gd name="T18" fmla="*/ 16460 w 28436"/>
                <a:gd name="T19" fmla="*/ 32914 h 33796"/>
                <a:gd name="T20" fmla="*/ 16460 w 28436"/>
                <a:gd name="T21" fmla="*/ 32583 h 33796"/>
                <a:gd name="T22" fmla="*/ 15599 w 28436"/>
                <a:gd name="T23" fmla="*/ 32583 h 33796"/>
                <a:gd name="T24" fmla="*/ 15599 w 28436"/>
                <a:gd name="T25" fmla="*/ 31729 h 33796"/>
                <a:gd name="T26" fmla="*/ 14909 w 28436"/>
                <a:gd name="T27" fmla="*/ 31729 h 33796"/>
                <a:gd name="T28" fmla="*/ 14909 w 28436"/>
                <a:gd name="T29" fmla="*/ 30888 h 33796"/>
                <a:gd name="T30" fmla="*/ 11980 w 28436"/>
                <a:gd name="T31" fmla="*/ 30888 h 33796"/>
                <a:gd name="T32" fmla="*/ 11980 w 28436"/>
                <a:gd name="T33" fmla="*/ 28253 h 33796"/>
                <a:gd name="T34" fmla="*/ 9398 w 28436"/>
                <a:gd name="T35" fmla="*/ 28253 h 33796"/>
                <a:gd name="T36" fmla="*/ 9398 w 28436"/>
                <a:gd name="T37" fmla="*/ 24741 h 33796"/>
                <a:gd name="T38" fmla="*/ 8913 w 28436"/>
                <a:gd name="T39" fmla="*/ 24741 h 33796"/>
                <a:gd name="T40" fmla="*/ 8913 w 28436"/>
                <a:gd name="T41" fmla="*/ 21383 h 33796"/>
                <a:gd name="T42" fmla="*/ 8518 w 28436"/>
                <a:gd name="T43" fmla="*/ 21383 h 33796"/>
                <a:gd name="T44" fmla="*/ 8518 w 28436"/>
                <a:gd name="T45" fmla="*/ 14511 h 33796"/>
                <a:gd name="T46" fmla="*/ 2871 w 28436"/>
                <a:gd name="T47" fmla="*/ 14511 h 33796"/>
                <a:gd name="T48" fmla="*/ 2871 w 28436"/>
                <a:gd name="T49" fmla="*/ 9602 h 33796"/>
                <a:gd name="T50" fmla="*/ 2035 w 28436"/>
                <a:gd name="T51" fmla="*/ 9602 h 33796"/>
                <a:gd name="T52" fmla="*/ 2035 w 28436"/>
                <a:gd name="T53" fmla="*/ 5983 h 33796"/>
                <a:gd name="T54" fmla="*/ 1569 w 28436"/>
                <a:gd name="T55" fmla="*/ 5983 h 33796"/>
                <a:gd name="T56" fmla="*/ 1569 w 28436"/>
                <a:gd name="T57" fmla="*/ 3023 h 33796"/>
                <a:gd name="T58" fmla="*/ 693 w 28436"/>
                <a:gd name="T59" fmla="*/ 3023 h 33796"/>
                <a:gd name="T60" fmla="*/ 693 w 28436"/>
                <a:gd name="T61" fmla="*/ 0 h 33796"/>
                <a:gd name="T62" fmla="*/ 0 w 28436"/>
                <a:gd name="T63" fmla="*/ 0 h 337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</a:cxnLst>
              <a:rect l="0" t="0" r="r" b="b"/>
              <a:pathLst>
                <a:path w="28436" h="33796">
                  <a:moveTo>
                    <a:pt x="0" y="0"/>
                  </a:moveTo>
                  <a:lnTo>
                    <a:pt x="0" y="16898"/>
                  </a:lnTo>
                  <a:lnTo>
                    <a:pt x="0" y="33796"/>
                  </a:lnTo>
                  <a:lnTo>
                    <a:pt x="2731" y="33796"/>
                  </a:lnTo>
                  <a:lnTo>
                    <a:pt x="2731" y="33576"/>
                  </a:lnTo>
                  <a:lnTo>
                    <a:pt x="28436" y="33576"/>
                  </a:lnTo>
                  <a:lnTo>
                    <a:pt x="28436" y="33135"/>
                  </a:lnTo>
                  <a:lnTo>
                    <a:pt x="17615" y="33135"/>
                  </a:lnTo>
                  <a:lnTo>
                    <a:pt x="17615" y="32914"/>
                  </a:lnTo>
                  <a:lnTo>
                    <a:pt x="16460" y="32914"/>
                  </a:lnTo>
                  <a:lnTo>
                    <a:pt x="16460" y="32583"/>
                  </a:lnTo>
                  <a:lnTo>
                    <a:pt x="15599" y="32583"/>
                  </a:lnTo>
                  <a:lnTo>
                    <a:pt x="15599" y="31729"/>
                  </a:lnTo>
                  <a:lnTo>
                    <a:pt x="14909" y="31729"/>
                  </a:lnTo>
                  <a:lnTo>
                    <a:pt x="14909" y="30888"/>
                  </a:lnTo>
                  <a:lnTo>
                    <a:pt x="11980" y="30888"/>
                  </a:lnTo>
                  <a:lnTo>
                    <a:pt x="11980" y="28253"/>
                  </a:lnTo>
                  <a:lnTo>
                    <a:pt x="9398" y="28253"/>
                  </a:lnTo>
                  <a:lnTo>
                    <a:pt x="9398" y="24741"/>
                  </a:lnTo>
                  <a:lnTo>
                    <a:pt x="8913" y="24741"/>
                  </a:lnTo>
                  <a:lnTo>
                    <a:pt x="8913" y="21383"/>
                  </a:lnTo>
                  <a:lnTo>
                    <a:pt x="8518" y="21383"/>
                  </a:lnTo>
                  <a:lnTo>
                    <a:pt x="8518" y="14511"/>
                  </a:lnTo>
                  <a:lnTo>
                    <a:pt x="2871" y="14511"/>
                  </a:lnTo>
                  <a:lnTo>
                    <a:pt x="2871" y="9602"/>
                  </a:lnTo>
                  <a:lnTo>
                    <a:pt x="2035" y="9602"/>
                  </a:lnTo>
                  <a:lnTo>
                    <a:pt x="2035" y="5983"/>
                  </a:lnTo>
                  <a:lnTo>
                    <a:pt x="1569" y="5983"/>
                  </a:lnTo>
                  <a:lnTo>
                    <a:pt x="1569" y="3023"/>
                  </a:lnTo>
                  <a:lnTo>
                    <a:pt x="693" y="3023"/>
                  </a:lnTo>
                  <a:lnTo>
                    <a:pt x="693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34" name="Freeform 14"/>
            <p:cNvSpPr>
              <a:spLocks/>
            </p:cNvSpPr>
            <p:nvPr/>
          </p:nvSpPr>
          <p:spPr bwMode="auto">
            <a:xfrm>
              <a:off x="2637" y="1967"/>
              <a:ext cx="990" cy="221"/>
            </a:xfrm>
            <a:custGeom>
              <a:avLst/>
              <a:gdLst>
                <a:gd name="T0" fmla="*/ 0 w 8095"/>
                <a:gd name="T1" fmla="*/ 0 h 1378"/>
                <a:gd name="T2" fmla="*/ 0 w 8095"/>
                <a:gd name="T3" fmla="*/ 689 h 1378"/>
                <a:gd name="T4" fmla="*/ 0 w 8095"/>
                <a:gd name="T5" fmla="*/ 1378 h 1378"/>
                <a:gd name="T6" fmla="*/ 8095 w 8095"/>
                <a:gd name="T7" fmla="*/ 1378 h 1378"/>
                <a:gd name="T8" fmla="*/ 8095 w 8095"/>
                <a:gd name="T9" fmla="*/ 937 h 1378"/>
                <a:gd name="T10" fmla="*/ 2057 w 8095"/>
                <a:gd name="T11" fmla="*/ 937 h 1378"/>
                <a:gd name="T12" fmla="*/ 2057 w 8095"/>
                <a:gd name="T13" fmla="*/ 717 h 1378"/>
                <a:gd name="T14" fmla="*/ 1300 w 8095"/>
                <a:gd name="T15" fmla="*/ 717 h 1378"/>
                <a:gd name="T16" fmla="*/ 1300 w 8095"/>
                <a:gd name="T17" fmla="*/ 386 h 1378"/>
                <a:gd name="T18" fmla="*/ 461 w 8095"/>
                <a:gd name="T19" fmla="*/ 386 h 1378"/>
                <a:gd name="T20" fmla="*/ 461 w 8095"/>
                <a:gd name="T21" fmla="*/ 0 h 1378"/>
                <a:gd name="T22" fmla="*/ 0 w 8095"/>
                <a:gd name="T23" fmla="*/ 0 h 13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8095" h="1378">
                  <a:moveTo>
                    <a:pt x="0" y="0"/>
                  </a:moveTo>
                  <a:lnTo>
                    <a:pt x="0" y="689"/>
                  </a:lnTo>
                  <a:lnTo>
                    <a:pt x="0" y="1378"/>
                  </a:lnTo>
                  <a:lnTo>
                    <a:pt x="8095" y="1378"/>
                  </a:lnTo>
                  <a:lnTo>
                    <a:pt x="8095" y="937"/>
                  </a:lnTo>
                  <a:lnTo>
                    <a:pt x="2057" y="937"/>
                  </a:lnTo>
                  <a:lnTo>
                    <a:pt x="2057" y="717"/>
                  </a:lnTo>
                  <a:lnTo>
                    <a:pt x="1300" y="717"/>
                  </a:lnTo>
                  <a:lnTo>
                    <a:pt x="1300" y="386"/>
                  </a:lnTo>
                  <a:lnTo>
                    <a:pt x="461" y="386"/>
                  </a:lnTo>
                  <a:lnTo>
                    <a:pt x="461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35" name="Freeform 15"/>
            <p:cNvSpPr>
              <a:spLocks/>
            </p:cNvSpPr>
            <p:nvPr/>
          </p:nvSpPr>
          <p:spPr bwMode="auto">
            <a:xfrm>
              <a:off x="2456" y="4295"/>
              <a:ext cx="1171" cy="857"/>
            </a:xfrm>
            <a:custGeom>
              <a:avLst/>
              <a:gdLst>
                <a:gd name="T0" fmla="*/ 0 w 9574"/>
                <a:gd name="T1" fmla="*/ 0 h 5360"/>
                <a:gd name="T2" fmla="*/ 0 w 9574"/>
                <a:gd name="T3" fmla="*/ 2680 h 5360"/>
                <a:gd name="T4" fmla="*/ 0 w 9574"/>
                <a:gd name="T5" fmla="*/ 5360 h 5360"/>
                <a:gd name="T6" fmla="*/ 293 w 9574"/>
                <a:gd name="T7" fmla="*/ 5360 h 5360"/>
                <a:gd name="T8" fmla="*/ 293 w 9574"/>
                <a:gd name="T9" fmla="*/ 4464 h 5360"/>
                <a:gd name="T10" fmla="*/ 9574 w 9574"/>
                <a:gd name="T11" fmla="*/ 4464 h 5360"/>
                <a:gd name="T12" fmla="*/ 9574 w 9574"/>
                <a:gd name="T13" fmla="*/ 2259 h 5360"/>
                <a:gd name="T14" fmla="*/ 2538 w 9574"/>
                <a:gd name="T15" fmla="*/ 2259 h 5360"/>
                <a:gd name="T16" fmla="*/ 2538 w 9574"/>
                <a:gd name="T17" fmla="*/ 1047 h 5360"/>
                <a:gd name="T18" fmla="*/ 714 w 9574"/>
                <a:gd name="T19" fmla="*/ 1047 h 5360"/>
                <a:gd name="T20" fmla="*/ 714 w 9574"/>
                <a:gd name="T21" fmla="*/ 0 h 5360"/>
                <a:gd name="T22" fmla="*/ 0 w 9574"/>
                <a:gd name="T23" fmla="*/ 0 h 53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9574" h="5360">
                  <a:moveTo>
                    <a:pt x="0" y="0"/>
                  </a:moveTo>
                  <a:lnTo>
                    <a:pt x="0" y="2680"/>
                  </a:lnTo>
                  <a:lnTo>
                    <a:pt x="0" y="5360"/>
                  </a:lnTo>
                  <a:lnTo>
                    <a:pt x="293" y="5360"/>
                  </a:lnTo>
                  <a:lnTo>
                    <a:pt x="293" y="4464"/>
                  </a:lnTo>
                  <a:lnTo>
                    <a:pt x="9574" y="4464"/>
                  </a:lnTo>
                  <a:lnTo>
                    <a:pt x="9574" y="2259"/>
                  </a:lnTo>
                  <a:lnTo>
                    <a:pt x="2538" y="2259"/>
                  </a:lnTo>
                  <a:lnTo>
                    <a:pt x="2538" y="1047"/>
                  </a:lnTo>
                  <a:lnTo>
                    <a:pt x="714" y="1047"/>
                  </a:lnTo>
                  <a:lnTo>
                    <a:pt x="714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36" name="Freeform 16"/>
            <p:cNvSpPr>
              <a:spLocks/>
            </p:cNvSpPr>
            <p:nvPr/>
          </p:nvSpPr>
          <p:spPr bwMode="auto">
            <a:xfrm>
              <a:off x="2429" y="1835"/>
              <a:ext cx="1198" cy="412"/>
            </a:xfrm>
            <a:custGeom>
              <a:avLst/>
              <a:gdLst>
                <a:gd name="T0" fmla="*/ 0 w 9791"/>
                <a:gd name="T1" fmla="*/ 0 h 2577"/>
                <a:gd name="T2" fmla="*/ 0 w 9791"/>
                <a:gd name="T3" fmla="*/ 1289 h 2577"/>
                <a:gd name="T4" fmla="*/ 0 w 9791"/>
                <a:gd name="T5" fmla="*/ 2577 h 2577"/>
                <a:gd name="T6" fmla="*/ 936 w 9791"/>
                <a:gd name="T7" fmla="*/ 2577 h 2577"/>
                <a:gd name="T8" fmla="*/ 936 w 9791"/>
                <a:gd name="T9" fmla="*/ 1516 h 2577"/>
                <a:gd name="T10" fmla="*/ 1696 w 9791"/>
                <a:gd name="T11" fmla="*/ 1516 h 2577"/>
                <a:gd name="T12" fmla="*/ 1696 w 9791"/>
                <a:gd name="T13" fmla="*/ 827 h 2577"/>
                <a:gd name="T14" fmla="*/ 2157 w 9791"/>
                <a:gd name="T15" fmla="*/ 827 h 2577"/>
                <a:gd name="T16" fmla="*/ 2157 w 9791"/>
                <a:gd name="T17" fmla="*/ 441 h 2577"/>
                <a:gd name="T18" fmla="*/ 9791 w 9791"/>
                <a:gd name="T19" fmla="*/ 441 h 2577"/>
                <a:gd name="T20" fmla="*/ 9791 w 9791"/>
                <a:gd name="T21" fmla="*/ 0 h 2577"/>
                <a:gd name="T22" fmla="*/ 0 w 9791"/>
                <a:gd name="T23" fmla="*/ 0 h 25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9791" h="2577">
                  <a:moveTo>
                    <a:pt x="0" y="0"/>
                  </a:moveTo>
                  <a:lnTo>
                    <a:pt x="0" y="1289"/>
                  </a:lnTo>
                  <a:lnTo>
                    <a:pt x="0" y="2577"/>
                  </a:lnTo>
                  <a:lnTo>
                    <a:pt x="936" y="2577"/>
                  </a:lnTo>
                  <a:lnTo>
                    <a:pt x="936" y="1516"/>
                  </a:lnTo>
                  <a:lnTo>
                    <a:pt x="1696" y="1516"/>
                  </a:lnTo>
                  <a:lnTo>
                    <a:pt x="1696" y="827"/>
                  </a:lnTo>
                  <a:lnTo>
                    <a:pt x="2157" y="827"/>
                  </a:lnTo>
                  <a:lnTo>
                    <a:pt x="2157" y="441"/>
                  </a:lnTo>
                  <a:lnTo>
                    <a:pt x="9791" y="441"/>
                  </a:lnTo>
                  <a:lnTo>
                    <a:pt x="9791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37" name="Freeform 17"/>
            <p:cNvSpPr>
              <a:spLocks/>
            </p:cNvSpPr>
            <p:nvPr/>
          </p:nvSpPr>
          <p:spPr bwMode="auto">
            <a:xfrm>
              <a:off x="2766" y="4268"/>
              <a:ext cx="861" cy="388"/>
            </a:xfrm>
            <a:custGeom>
              <a:avLst/>
              <a:gdLst>
                <a:gd name="T0" fmla="*/ 0 w 7036"/>
                <a:gd name="T1" fmla="*/ 0 h 2425"/>
                <a:gd name="T2" fmla="*/ 0 w 7036"/>
                <a:gd name="T3" fmla="*/ 1213 h 2425"/>
                <a:gd name="T4" fmla="*/ 0 w 7036"/>
                <a:gd name="T5" fmla="*/ 2425 h 2425"/>
                <a:gd name="T6" fmla="*/ 7036 w 7036"/>
                <a:gd name="T7" fmla="*/ 2425 h 2425"/>
                <a:gd name="T8" fmla="*/ 7036 w 7036"/>
                <a:gd name="T9" fmla="*/ 0 h 2425"/>
                <a:gd name="T10" fmla="*/ 0 w 7036"/>
                <a:gd name="T11" fmla="*/ 0 h 24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7036" h="2425">
                  <a:moveTo>
                    <a:pt x="0" y="0"/>
                  </a:moveTo>
                  <a:lnTo>
                    <a:pt x="0" y="1213"/>
                  </a:lnTo>
                  <a:lnTo>
                    <a:pt x="0" y="2425"/>
                  </a:lnTo>
                  <a:lnTo>
                    <a:pt x="7036" y="2425"/>
                  </a:lnTo>
                  <a:lnTo>
                    <a:pt x="7036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38" name="Freeform 18"/>
            <p:cNvSpPr>
              <a:spLocks/>
            </p:cNvSpPr>
            <p:nvPr/>
          </p:nvSpPr>
          <p:spPr bwMode="auto">
            <a:xfrm>
              <a:off x="2624" y="5644"/>
              <a:ext cx="1003" cy="70"/>
            </a:xfrm>
            <a:custGeom>
              <a:avLst/>
              <a:gdLst>
                <a:gd name="T0" fmla="*/ 0 w 8202"/>
                <a:gd name="T1" fmla="*/ 0 h 441"/>
                <a:gd name="T2" fmla="*/ 0 w 8202"/>
                <a:gd name="T3" fmla="*/ 220 h 441"/>
                <a:gd name="T4" fmla="*/ 0 w 8202"/>
                <a:gd name="T5" fmla="*/ 441 h 441"/>
                <a:gd name="T6" fmla="*/ 8202 w 8202"/>
                <a:gd name="T7" fmla="*/ 441 h 441"/>
                <a:gd name="T8" fmla="*/ 8202 w 8202"/>
                <a:gd name="T9" fmla="*/ 0 h 441"/>
                <a:gd name="T10" fmla="*/ 0 w 8202"/>
                <a:gd name="T11" fmla="*/ 0 h 4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8202" h="441">
                  <a:moveTo>
                    <a:pt x="0" y="0"/>
                  </a:moveTo>
                  <a:lnTo>
                    <a:pt x="0" y="220"/>
                  </a:lnTo>
                  <a:lnTo>
                    <a:pt x="0" y="441"/>
                  </a:lnTo>
                  <a:lnTo>
                    <a:pt x="8202" y="441"/>
                  </a:lnTo>
                  <a:lnTo>
                    <a:pt x="8202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39" name="Freeform 19"/>
            <p:cNvSpPr>
              <a:spLocks/>
            </p:cNvSpPr>
            <p:nvPr/>
          </p:nvSpPr>
          <p:spPr bwMode="auto">
            <a:xfrm>
              <a:off x="595" y="1112"/>
              <a:ext cx="3032" cy="159"/>
            </a:xfrm>
            <a:custGeom>
              <a:avLst/>
              <a:gdLst>
                <a:gd name="T0" fmla="*/ 0 w 24782"/>
                <a:gd name="T1" fmla="*/ 0 h 992"/>
                <a:gd name="T2" fmla="*/ 0 w 24782"/>
                <a:gd name="T3" fmla="*/ 496 h 992"/>
                <a:gd name="T4" fmla="*/ 0 w 24782"/>
                <a:gd name="T5" fmla="*/ 992 h 992"/>
                <a:gd name="T6" fmla="*/ 24782 w 24782"/>
                <a:gd name="T7" fmla="*/ 992 h 992"/>
                <a:gd name="T8" fmla="*/ 24782 w 24782"/>
                <a:gd name="T9" fmla="*/ 551 h 992"/>
                <a:gd name="T10" fmla="*/ 901 w 24782"/>
                <a:gd name="T11" fmla="*/ 551 h 992"/>
                <a:gd name="T12" fmla="*/ 901 w 24782"/>
                <a:gd name="T13" fmla="*/ 330 h 992"/>
                <a:gd name="T14" fmla="*/ 349 w 24782"/>
                <a:gd name="T15" fmla="*/ 330 h 992"/>
                <a:gd name="T16" fmla="*/ 349 w 24782"/>
                <a:gd name="T17" fmla="*/ 0 h 992"/>
                <a:gd name="T18" fmla="*/ 0 w 24782"/>
                <a:gd name="T19" fmla="*/ 0 h 9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24782" h="992">
                  <a:moveTo>
                    <a:pt x="0" y="0"/>
                  </a:moveTo>
                  <a:lnTo>
                    <a:pt x="0" y="496"/>
                  </a:lnTo>
                  <a:lnTo>
                    <a:pt x="0" y="992"/>
                  </a:lnTo>
                  <a:lnTo>
                    <a:pt x="24782" y="992"/>
                  </a:lnTo>
                  <a:lnTo>
                    <a:pt x="24782" y="551"/>
                  </a:lnTo>
                  <a:lnTo>
                    <a:pt x="901" y="551"/>
                  </a:lnTo>
                  <a:lnTo>
                    <a:pt x="901" y="330"/>
                  </a:lnTo>
                  <a:lnTo>
                    <a:pt x="349" y="330"/>
                  </a:lnTo>
                  <a:lnTo>
                    <a:pt x="349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40" name="Freeform 20"/>
            <p:cNvSpPr>
              <a:spLocks/>
            </p:cNvSpPr>
            <p:nvPr/>
          </p:nvSpPr>
          <p:spPr bwMode="auto">
            <a:xfrm>
              <a:off x="2346" y="3598"/>
              <a:ext cx="1281" cy="106"/>
            </a:xfrm>
            <a:custGeom>
              <a:avLst/>
              <a:gdLst>
                <a:gd name="T0" fmla="*/ 0 w 10470"/>
                <a:gd name="T1" fmla="*/ 0 h 662"/>
                <a:gd name="T2" fmla="*/ 0 w 10470"/>
                <a:gd name="T3" fmla="*/ 331 h 662"/>
                <a:gd name="T4" fmla="*/ 0 w 10470"/>
                <a:gd name="T5" fmla="*/ 662 h 662"/>
                <a:gd name="T6" fmla="*/ 0 w 10470"/>
                <a:gd name="T7" fmla="*/ 662 h 662"/>
                <a:gd name="T8" fmla="*/ 0 w 10470"/>
                <a:gd name="T9" fmla="*/ 441 h 662"/>
                <a:gd name="T10" fmla="*/ 10470 w 10470"/>
                <a:gd name="T11" fmla="*/ 441 h 662"/>
                <a:gd name="T12" fmla="*/ 10470 w 10470"/>
                <a:gd name="T13" fmla="*/ 0 h 662"/>
                <a:gd name="T14" fmla="*/ 0 w 10470"/>
                <a:gd name="T15" fmla="*/ 0 h 6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0470" h="662">
                  <a:moveTo>
                    <a:pt x="0" y="0"/>
                  </a:moveTo>
                  <a:lnTo>
                    <a:pt x="0" y="331"/>
                  </a:lnTo>
                  <a:lnTo>
                    <a:pt x="0" y="662"/>
                  </a:lnTo>
                  <a:lnTo>
                    <a:pt x="0" y="662"/>
                  </a:lnTo>
                  <a:lnTo>
                    <a:pt x="0" y="441"/>
                  </a:lnTo>
                  <a:lnTo>
                    <a:pt x="10470" y="441"/>
                  </a:lnTo>
                  <a:lnTo>
                    <a:pt x="1047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41" name="Freeform 21"/>
            <p:cNvSpPr>
              <a:spLocks/>
            </p:cNvSpPr>
            <p:nvPr/>
          </p:nvSpPr>
          <p:spPr bwMode="auto">
            <a:xfrm>
              <a:off x="2492" y="5009"/>
              <a:ext cx="1135" cy="286"/>
            </a:xfrm>
            <a:custGeom>
              <a:avLst/>
              <a:gdLst>
                <a:gd name="T0" fmla="*/ 0 w 9281"/>
                <a:gd name="T1" fmla="*/ 0 h 1792"/>
                <a:gd name="T2" fmla="*/ 0 w 9281"/>
                <a:gd name="T3" fmla="*/ 896 h 1792"/>
                <a:gd name="T4" fmla="*/ 0 w 9281"/>
                <a:gd name="T5" fmla="*/ 1792 h 1792"/>
                <a:gd name="T6" fmla="*/ 425 w 9281"/>
                <a:gd name="T7" fmla="*/ 1792 h 1792"/>
                <a:gd name="T8" fmla="*/ 425 w 9281"/>
                <a:gd name="T9" fmla="*/ 1378 h 1792"/>
                <a:gd name="T10" fmla="*/ 802 w 9281"/>
                <a:gd name="T11" fmla="*/ 1378 h 1792"/>
                <a:gd name="T12" fmla="*/ 802 w 9281"/>
                <a:gd name="T13" fmla="*/ 992 h 1792"/>
                <a:gd name="T14" fmla="*/ 1981 w 9281"/>
                <a:gd name="T15" fmla="*/ 992 h 1792"/>
                <a:gd name="T16" fmla="*/ 1981 w 9281"/>
                <a:gd name="T17" fmla="*/ 662 h 1792"/>
                <a:gd name="T18" fmla="*/ 6478 w 9281"/>
                <a:gd name="T19" fmla="*/ 662 h 1792"/>
                <a:gd name="T20" fmla="*/ 6478 w 9281"/>
                <a:gd name="T21" fmla="*/ 441 h 1792"/>
                <a:gd name="T22" fmla="*/ 9281 w 9281"/>
                <a:gd name="T23" fmla="*/ 441 h 1792"/>
                <a:gd name="T24" fmla="*/ 9281 w 9281"/>
                <a:gd name="T25" fmla="*/ 0 h 1792"/>
                <a:gd name="T26" fmla="*/ 0 w 9281"/>
                <a:gd name="T27" fmla="*/ 0 h 17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9281" h="1792">
                  <a:moveTo>
                    <a:pt x="0" y="0"/>
                  </a:moveTo>
                  <a:lnTo>
                    <a:pt x="0" y="896"/>
                  </a:lnTo>
                  <a:lnTo>
                    <a:pt x="0" y="1792"/>
                  </a:lnTo>
                  <a:lnTo>
                    <a:pt x="425" y="1792"/>
                  </a:lnTo>
                  <a:lnTo>
                    <a:pt x="425" y="1378"/>
                  </a:lnTo>
                  <a:lnTo>
                    <a:pt x="802" y="1378"/>
                  </a:lnTo>
                  <a:lnTo>
                    <a:pt x="802" y="992"/>
                  </a:lnTo>
                  <a:lnTo>
                    <a:pt x="1981" y="992"/>
                  </a:lnTo>
                  <a:lnTo>
                    <a:pt x="1981" y="662"/>
                  </a:lnTo>
                  <a:lnTo>
                    <a:pt x="6478" y="662"/>
                  </a:lnTo>
                  <a:lnTo>
                    <a:pt x="6478" y="441"/>
                  </a:lnTo>
                  <a:lnTo>
                    <a:pt x="9281" y="441"/>
                  </a:lnTo>
                  <a:lnTo>
                    <a:pt x="9281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42" name="Freeform 22"/>
            <p:cNvSpPr>
              <a:spLocks/>
            </p:cNvSpPr>
            <p:nvPr/>
          </p:nvSpPr>
          <p:spPr bwMode="auto">
            <a:xfrm>
              <a:off x="1799" y="3422"/>
              <a:ext cx="1828" cy="167"/>
            </a:xfrm>
            <a:custGeom>
              <a:avLst/>
              <a:gdLst>
                <a:gd name="T0" fmla="*/ 0 w 14942"/>
                <a:gd name="T1" fmla="*/ 0 h 1047"/>
                <a:gd name="T2" fmla="*/ 0 w 14942"/>
                <a:gd name="T3" fmla="*/ 523 h 1047"/>
                <a:gd name="T4" fmla="*/ 0 w 14942"/>
                <a:gd name="T5" fmla="*/ 1047 h 1047"/>
                <a:gd name="T6" fmla="*/ 0 w 14942"/>
                <a:gd name="T7" fmla="*/ 1047 h 1047"/>
                <a:gd name="T8" fmla="*/ 0 w 14942"/>
                <a:gd name="T9" fmla="*/ 661 h 1047"/>
                <a:gd name="T10" fmla="*/ 14942 w 14942"/>
                <a:gd name="T11" fmla="*/ 661 h 1047"/>
                <a:gd name="T12" fmla="*/ 14942 w 14942"/>
                <a:gd name="T13" fmla="*/ 220 h 1047"/>
                <a:gd name="T14" fmla="*/ 872 w 14942"/>
                <a:gd name="T15" fmla="*/ 220 h 1047"/>
                <a:gd name="T16" fmla="*/ 872 w 14942"/>
                <a:gd name="T17" fmla="*/ 0 h 1047"/>
                <a:gd name="T18" fmla="*/ 0 w 14942"/>
                <a:gd name="T19" fmla="*/ 0 h 10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14942" h="1047">
                  <a:moveTo>
                    <a:pt x="0" y="0"/>
                  </a:moveTo>
                  <a:lnTo>
                    <a:pt x="0" y="523"/>
                  </a:lnTo>
                  <a:lnTo>
                    <a:pt x="0" y="1047"/>
                  </a:lnTo>
                  <a:lnTo>
                    <a:pt x="0" y="1047"/>
                  </a:lnTo>
                  <a:lnTo>
                    <a:pt x="0" y="661"/>
                  </a:lnTo>
                  <a:lnTo>
                    <a:pt x="14942" y="661"/>
                  </a:lnTo>
                  <a:lnTo>
                    <a:pt x="14942" y="220"/>
                  </a:lnTo>
                  <a:lnTo>
                    <a:pt x="872" y="220"/>
                  </a:lnTo>
                  <a:lnTo>
                    <a:pt x="872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43" name="Freeform 23"/>
            <p:cNvSpPr>
              <a:spLocks/>
            </p:cNvSpPr>
            <p:nvPr/>
          </p:nvSpPr>
          <p:spPr bwMode="auto">
            <a:xfrm>
              <a:off x="2544" y="5229"/>
              <a:ext cx="1083" cy="132"/>
            </a:xfrm>
            <a:custGeom>
              <a:avLst/>
              <a:gdLst>
                <a:gd name="T0" fmla="*/ 0 w 8856"/>
                <a:gd name="T1" fmla="*/ 0 h 827"/>
                <a:gd name="T2" fmla="*/ 0 w 8856"/>
                <a:gd name="T3" fmla="*/ 414 h 827"/>
                <a:gd name="T4" fmla="*/ 0 w 8856"/>
                <a:gd name="T5" fmla="*/ 827 h 827"/>
                <a:gd name="T6" fmla="*/ 8856 w 8856"/>
                <a:gd name="T7" fmla="*/ 827 h 827"/>
                <a:gd name="T8" fmla="*/ 8856 w 8856"/>
                <a:gd name="T9" fmla="*/ 386 h 827"/>
                <a:gd name="T10" fmla="*/ 377 w 8856"/>
                <a:gd name="T11" fmla="*/ 386 h 827"/>
                <a:gd name="T12" fmla="*/ 377 w 8856"/>
                <a:gd name="T13" fmla="*/ 0 h 827"/>
                <a:gd name="T14" fmla="*/ 0 w 8856"/>
                <a:gd name="T15" fmla="*/ 0 h 8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8856" h="827">
                  <a:moveTo>
                    <a:pt x="0" y="0"/>
                  </a:moveTo>
                  <a:lnTo>
                    <a:pt x="0" y="414"/>
                  </a:lnTo>
                  <a:lnTo>
                    <a:pt x="0" y="827"/>
                  </a:lnTo>
                  <a:lnTo>
                    <a:pt x="8856" y="827"/>
                  </a:lnTo>
                  <a:lnTo>
                    <a:pt x="8856" y="386"/>
                  </a:lnTo>
                  <a:lnTo>
                    <a:pt x="377" y="386"/>
                  </a:lnTo>
                  <a:lnTo>
                    <a:pt x="377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44" name="Freeform 24"/>
            <p:cNvSpPr>
              <a:spLocks/>
            </p:cNvSpPr>
            <p:nvPr/>
          </p:nvSpPr>
          <p:spPr bwMode="auto">
            <a:xfrm>
              <a:off x="2885" y="1624"/>
              <a:ext cx="742" cy="70"/>
            </a:xfrm>
            <a:custGeom>
              <a:avLst/>
              <a:gdLst>
                <a:gd name="T0" fmla="*/ 0 w 6069"/>
                <a:gd name="T1" fmla="*/ 0 h 440"/>
                <a:gd name="T2" fmla="*/ 0 w 6069"/>
                <a:gd name="T3" fmla="*/ 220 h 440"/>
                <a:gd name="T4" fmla="*/ 0 w 6069"/>
                <a:gd name="T5" fmla="*/ 440 h 440"/>
                <a:gd name="T6" fmla="*/ 6069 w 6069"/>
                <a:gd name="T7" fmla="*/ 440 h 440"/>
                <a:gd name="T8" fmla="*/ 6069 w 6069"/>
                <a:gd name="T9" fmla="*/ 0 h 440"/>
                <a:gd name="T10" fmla="*/ 0 w 6069"/>
                <a:gd name="T11" fmla="*/ 0 h 4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6069" h="440">
                  <a:moveTo>
                    <a:pt x="0" y="0"/>
                  </a:moveTo>
                  <a:lnTo>
                    <a:pt x="0" y="220"/>
                  </a:lnTo>
                  <a:lnTo>
                    <a:pt x="0" y="440"/>
                  </a:lnTo>
                  <a:lnTo>
                    <a:pt x="6069" y="440"/>
                  </a:lnTo>
                  <a:lnTo>
                    <a:pt x="6069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45" name="Freeform 25"/>
            <p:cNvSpPr>
              <a:spLocks/>
            </p:cNvSpPr>
            <p:nvPr/>
          </p:nvSpPr>
          <p:spPr bwMode="auto">
            <a:xfrm>
              <a:off x="482" y="5996"/>
              <a:ext cx="3145" cy="71"/>
            </a:xfrm>
            <a:custGeom>
              <a:avLst/>
              <a:gdLst>
                <a:gd name="T0" fmla="*/ 0 w 25705"/>
                <a:gd name="T1" fmla="*/ 0 h 441"/>
                <a:gd name="T2" fmla="*/ 0 w 25705"/>
                <a:gd name="T3" fmla="*/ 220 h 441"/>
                <a:gd name="T4" fmla="*/ 0 w 25705"/>
                <a:gd name="T5" fmla="*/ 441 h 441"/>
                <a:gd name="T6" fmla="*/ 25705 w 25705"/>
                <a:gd name="T7" fmla="*/ 441 h 441"/>
                <a:gd name="T8" fmla="*/ 25705 w 25705"/>
                <a:gd name="T9" fmla="*/ 0 h 441"/>
                <a:gd name="T10" fmla="*/ 0 w 25705"/>
                <a:gd name="T11" fmla="*/ 0 h 4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5705" h="441">
                  <a:moveTo>
                    <a:pt x="0" y="0"/>
                  </a:moveTo>
                  <a:lnTo>
                    <a:pt x="0" y="220"/>
                  </a:lnTo>
                  <a:lnTo>
                    <a:pt x="0" y="441"/>
                  </a:lnTo>
                  <a:lnTo>
                    <a:pt x="25705" y="441"/>
                  </a:lnTo>
                  <a:lnTo>
                    <a:pt x="25705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46" name="Freeform 26"/>
            <p:cNvSpPr>
              <a:spLocks/>
            </p:cNvSpPr>
            <p:nvPr/>
          </p:nvSpPr>
          <p:spPr bwMode="auto">
            <a:xfrm>
              <a:off x="2162" y="5785"/>
              <a:ext cx="1465" cy="105"/>
            </a:xfrm>
            <a:custGeom>
              <a:avLst/>
              <a:gdLst>
                <a:gd name="T0" fmla="*/ 0 w 11976"/>
                <a:gd name="T1" fmla="*/ 0 h 661"/>
                <a:gd name="T2" fmla="*/ 0 w 11976"/>
                <a:gd name="T3" fmla="*/ 330 h 661"/>
                <a:gd name="T4" fmla="*/ 0 w 11976"/>
                <a:gd name="T5" fmla="*/ 661 h 661"/>
                <a:gd name="T6" fmla="*/ 1155 w 11976"/>
                <a:gd name="T7" fmla="*/ 661 h 661"/>
                <a:gd name="T8" fmla="*/ 1155 w 11976"/>
                <a:gd name="T9" fmla="*/ 441 h 661"/>
                <a:gd name="T10" fmla="*/ 11976 w 11976"/>
                <a:gd name="T11" fmla="*/ 441 h 661"/>
                <a:gd name="T12" fmla="*/ 11976 w 11976"/>
                <a:gd name="T13" fmla="*/ 0 h 661"/>
                <a:gd name="T14" fmla="*/ 0 w 11976"/>
                <a:gd name="T15" fmla="*/ 0 h 6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1976" h="661">
                  <a:moveTo>
                    <a:pt x="0" y="0"/>
                  </a:moveTo>
                  <a:lnTo>
                    <a:pt x="0" y="330"/>
                  </a:lnTo>
                  <a:lnTo>
                    <a:pt x="0" y="661"/>
                  </a:lnTo>
                  <a:lnTo>
                    <a:pt x="1155" y="661"/>
                  </a:lnTo>
                  <a:lnTo>
                    <a:pt x="1155" y="441"/>
                  </a:lnTo>
                  <a:lnTo>
                    <a:pt x="11976" y="441"/>
                  </a:lnTo>
                  <a:lnTo>
                    <a:pt x="11976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47" name="Freeform 27"/>
            <p:cNvSpPr>
              <a:spLocks/>
            </p:cNvSpPr>
            <p:nvPr/>
          </p:nvSpPr>
          <p:spPr bwMode="auto">
            <a:xfrm>
              <a:off x="499" y="1377"/>
              <a:ext cx="3128" cy="1570"/>
            </a:xfrm>
            <a:custGeom>
              <a:avLst/>
              <a:gdLst>
                <a:gd name="T0" fmla="*/ 0 w 25565"/>
                <a:gd name="T1" fmla="*/ 0 h 9818"/>
                <a:gd name="T2" fmla="*/ 0 w 25565"/>
                <a:gd name="T3" fmla="*/ 4909 h 9818"/>
                <a:gd name="T4" fmla="*/ 0 w 25565"/>
                <a:gd name="T5" fmla="*/ 9818 h 9818"/>
                <a:gd name="T6" fmla="*/ 5647 w 25565"/>
                <a:gd name="T7" fmla="*/ 9818 h 9818"/>
                <a:gd name="T8" fmla="*/ 5647 w 25565"/>
                <a:gd name="T9" fmla="*/ 2946 h 9818"/>
                <a:gd name="T10" fmla="*/ 14147 w 25565"/>
                <a:gd name="T11" fmla="*/ 2946 h 9818"/>
                <a:gd name="T12" fmla="*/ 14147 w 25565"/>
                <a:gd name="T13" fmla="*/ 1736 h 9818"/>
                <a:gd name="T14" fmla="*/ 14676 w 25565"/>
                <a:gd name="T15" fmla="*/ 1736 h 9818"/>
                <a:gd name="T16" fmla="*/ 14676 w 25565"/>
                <a:gd name="T17" fmla="*/ 1047 h 9818"/>
                <a:gd name="T18" fmla="*/ 16284 w 25565"/>
                <a:gd name="T19" fmla="*/ 1047 h 9818"/>
                <a:gd name="T20" fmla="*/ 16284 w 25565"/>
                <a:gd name="T21" fmla="*/ 662 h 9818"/>
                <a:gd name="T22" fmla="*/ 25565 w 25565"/>
                <a:gd name="T23" fmla="*/ 662 h 9818"/>
                <a:gd name="T24" fmla="*/ 25565 w 25565"/>
                <a:gd name="T25" fmla="*/ 221 h 9818"/>
                <a:gd name="T26" fmla="*/ 2475 w 25565"/>
                <a:gd name="T27" fmla="*/ 221 h 9818"/>
                <a:gd name="T28" fmla="*/ 2475 w 25565"/>
                <a:gd name="T29" fmla="*/ 0 h 9818"/>
                <a:gd name="T30" fmla="*/ 0 w 25565"/>
                <a:gd name="T31" fmla="*/ 0 h 98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25565" h="9818">
                  <a:moveTo>
                    <a:pt x="0" y="0"/>
                  </a:moveTo>
                  <a:lnTo>
                    <a:pt x="0" y="4909"/>
                  </a:lnTo>
                  <a:lnTo>
                    <a:pt x="0" y="9818"/>
                  </a:lnTo>
                  <a:lnTo>
                    <a:pt x="5647" y="9818"/>
                  </a:lnTo>
                  <a:lnTo>
                    <a:pt x="5647" y="2946"/>
                  </a:lnTo>
                  <a:lnTo>
                    <a:pt x="14147" y="2946"/>
                  </a:lnTo>
                  <a:lnTo>
                    <a:pt x="14147" y="1736"/>
                  </a:lnTo>
                  <a:lnTo>
                    <a:pt x="14676" y="1736"/>
                  </a:lnTo>
                  <a:lnTo>
                    <a:pt x="14676" y="1047"/>
                  </a:lnTo>
                  <a:lnTo>
                    <a:pt x="16284" y="1047"/>
                  </a:lnTo>
                  <a:lnTo>
                    <a:pt x="16284" y="662"/>
                  </a:lnTo>
                  <a:lnTo>
                    <a:pt x="25565" y="662"/>
                  </a:lnTo>
                  <a:lnTo>
                    <a:pt x="25565" y="221"/>
                  </a:lnTo>
                  <a:lnTo>
                    <a:pt x="2475" y="221"/>
                  </a:lnTo>
                  <a:lnTo>
                    <a:pt x="2475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48" name="Freeform 28"/>
            <p:cNvSpPr>
              <a:spLocks/>
            </p:cNvSpPr>
            <p:nvPr/>
          </p:nvSpPr>
          <p:spPr bwMode="auto">
            <a:xfrm>
              <a:off x="1689" y="3810"/>
              <a:ext cx="1938" cy="70"/>
            </a:xfrm>
            <a:custGeom>
              <a:avLst/>
              <a:gdLst>
                <a:gd name="T0" fmla="*/ 0 w 15839"/>
                <a:gd name="T1" fmla="*/ 0 h 441"/>
                <a:gd name="T2" fmla="*/ 0 w 15839"/>
                <a:gd name="T3" fmla="*/ 221 h 441"/>
                <a:gd name="T4" fmla="*/ 0 w 15839"/>
                <a:gd name="T5" fmla="*/ 441 h 441"/>
                <a:gd name="T6" fmla="*/ 15839 w 15839"/>
                <a:gd name="T7" fmla="*/ 441 h 441"/>
                <a:gd name="T8" fmla="*/ 15839 w 15839"/>
                <a:gd name="T9" fmla="*/ 0 h 441"/>
                <a:gd name="T10" fmla="*/ 0 w 15839"/>
                <a:gd name="T11" fmla="*/ 0 h 4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5839" h="441">
                  <a:moveTo>
                    <a:pt x="0" y="0"/>
                  </a:moveTo>
                  <a:lnTo>
                    <a:pt x="0" y="221"/>
                  </a:lnTo>
                  <a:lnTo>
                    <a:pt x="0" y="441"/>
                  </a:lnTo>
                  <a:lnTo>
                    <a:pt x="15839" y="441"/>
                  </a:lnTo>
                  <a:lnTo>
                    <a:pt x="15839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49" name="Freeform 29"/>
            <p:cNvSpPr>
              <a:spLocks/>
            </p:cNvSpPr>
            <p:nvPr/>
          </p:nvSpPr>
          <p:spPr bwMode="auto">
            <a:xfrm>
              <a:off x="2230" y="1654"/>
              <a:ext cx="1397" cy="387"/>
            </a:xfrm>
            <a:custGeom>
              <a:avLst/>
              <a:gdLst>
                <a:gd name="T0" fmla="*/ 0 w 11418"/>
                <a:gd name="T1" fmla="*/ 0 h 2419"/>
                <a:gd name="T2" fmla="*/ 0 w 11418"/>
                <a:gd name="T3" fmla="*/ 1210 h 2419"/>
                <a:gd name="T4" fmla="*/ 0 w 11418"/>
                <a:gd name="T5" fmla="*/ 2419 h 2419"/>
                <a:gd name="T6" fmla="*/ 1627 w 11418"/>
                <a:gd name="T7" fmla="*/ 2419 h 2419"/>
                <a:gd name="T8" fmla="*/ 1627 w 11418"/>
                <a:gd name="T9" fmla="*/ 1130 h 2419"/>
                <a:gd name="T10" fmla="*/ 11418 w 11418"/>
                <a:gd name="T11" fmla="*/ 1130 h 2419"/>
                <a:gd name="T12" fmla="*/ 11418 w 11418"/>
                <a:gd name="T13" fmla="*/ 689 h 2419"/>
                <a:gd name="T14" fmla="*/ 529 w 11418"/>
                <a:gd name="T15" fmla="*/ 689 h 2419"/>
                <a:gd name="T16" fmla="*/ 529 w 11418"/>
                <a:gd name="T17" fmla="*/ 0 h 2419"/>
                <a:gd name="T18" fmla="*/ 0 w 11418"/>
                <a:gd name="T19" fmla="*/ 0 h 24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11418" h="2419">
                  <a:moveTo>
                    <a:pt x="0" y="0"/>
                  </a:moveTo>
                  <a:lnTo>
                    <a:pt x="0" y="1210"/>
                  </a:lnTo>
                  <a:lnTo>
                    <a:pt x="0" y="2419"/>
                  </a:lnTo>
                  <a:lnTo>
                    <a:pt x="1627" y="2419"/>
                  </a:lnTo>
                  <a:lnTo>
                    <a:pt x="1627" y="1130"/>
                  </a:lnTo>
                  <a:lnTo>
                    <a:pt x="11418" y="1130"/>
                  </a:lnTo>
                  <a:lnTo>
                    <a:pt x="11418" y="689"/>
                  </a:lnTo>
                  <a:lnTo>
                    <a:pt x="529" y="689"/>
                  </a:lnTo>
                  <a:lnTo>
                    <a:pt x="529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50" name="Freeform 30"/>
            <p:cNvSpPr>
              <a:spLocks/>
            </p:cNvSpPr>
            <p:nvPr/>
          </p:nvSpPr>
          <p:spPr bwMode="auto">
            <a:xfrm>
              <a:off x="2543" y="4127"/>
              <a:ext cx="1084" cy="335"/>
            </a:xfrm>
            <a:custGeom>
              <a:avLst/>
              <a:gdLst>
                <a:gd name="T0" fmla="*/ 0 w 8860"/>
                <a:gd name="T1" fmla="*/ 0 h 2095"/>
                <a:gd name="T2" fmla="*/ 0 w 8860"/>
                <a:gd name="T3" fmla="*/ 1048 h 2095"/>
                <a:gd name="T4" fmla="*/ 0 w 8860"/>
                <a:gd name="T5" fmla="*/ 2095 h 2095"/>
                <a:gd name="T6" fmla="*/ 1824 w 8860"/>
                <a:gd name="T7" fmla="*/ 2095 h 2095"/>
                <a:gd name="T8" fmla="*/ 1824 w 8860"/>
                <a:gd name="T9" fmla="*/ 882 h 2095"/>
                <a:gd name="T10" fmla="*/ 8860 w 8860"/>
                <a:gd name="T11" fmla="*/ 882 h 2095"/>
                <a:gd name="T12" fmla="*/ 8860 w 8860"/>
                <a:gd name="T13" fmla="*/ 221 h 2095"/>
                <a:gd name="T14" fmla="*/ 1229 w 8860"/>
                <a:gd name="T15" fmla="*/ 221 h 2095"/>
                <a:gd name="T16" fmla="*/ 1229 w 8860"/>
                <a:gd name="T17" fmla="*/ 0 h 2095"/>
                <a:gd name="T18" fmla="*/ 0 w 8860"/>
                <a:gd name="T19" fmla="*/ 0 h 20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8860" h="2095">
                  <a:moveTo>
                    <a:pt x="0" y="0"/>
                  </a:moveTo>
                  <a:lnTo>
                    <a:pt x="0" y="1048"/>
                  </a:lnTo>
                  <a:lnTo>
                    <a:pt x="0" y="2095"/>
                  </a:lnTo>
                  <a:lnTo>
                    <a:pt x="1824" y="2095"/>
                  </a:lnTo>
                  <a:lnTo>
                    <a:pt x="1824" y="882"/>
                  </a:lnTo>
                  <a:lnTo>
                    <a:pt x="8860" y="882"/>
                  </a:lnTo>
                  <a:lnTo>
                    <a:pt x="8860" y="221"/>
                  </a:lnTo>
                  <a:lnTo>
                    <a:pt x="1229" y="221"/>
                  </a:lnTo>
                  <a:lnTo>
                    <a:pt x="1229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51" name="Freeform 31"/>
            <p:cNvSpPr>
              <a:spLocks/>
            </p:cNvSpPr>
            <p:nvPr/>
          </p:nvSpPr>
          <p:spPr bwMode="auto">
            <a:xfrm>
              <a:off x="1298" y="4021"/>
              <a:ext cx="2329" cy="1124"/>
            </a:xfrm>
            <a:custGeom>
              <a:avLst/>
              <a:gdLst>
                <a:gd name="T0" fmla="*/ 0 w 19038"/>
                <a:gd name="T1" fmla="*/ 0 h 7024"/>
                <a:gd name="T2" fmla="*/ 0 w 19038"/>
                <a:gd name="T3" fmla="*/ 3512 h 7024"/>
                <a:gd name="T4" fmla="*/ 0 w 19038"/>
                <a:gd name="T5" fmla="*/ 7024 h 7024"/>
                <a:gd name="T6" fmla="*/ 2582 w 19038"/>
                <a:gd name="T7" fmla="*/ 7024 h 7024"/>
                <a:gd name="T8" fmla="*/ 2582 w 19038"/>
                <a:gd name="T9" fmla="*/ 4389 h 7024"/>
                <a:gd name="T10" fmla="*/ 9464 w 19038"/>
                <a:gd name="T11" fmla="*/ 4389 h 7024"/>
                <a:gd name="T12" fmla="*/ 9464 w 19038"/>
                <a:gd name="T13" fmla="*/ 1709 h 7024"/>
                <a:gd name="T14" fmla="*/ 10178 w 19038"/>
                <a:gd name="T15" fmla="*/ 1709 h 7024"/>
                <a:gd name="T16" fmla="*/ 10178 w 19038"/>
                <a:gd name="T17" fmla="*/ 661 h 7024"/>
                <a:gd name="T18" fmla="*/ 11407 w 19038"/>
                <a:gd name="T19" fmla="*/ 661 h 7024"/>
                <a:gd name="T20" fmla="*/ 11407 w 19038"/>
                <a:gd name="T21" fmla="*/ 441 h 7024"/>
                <a:gd name="T22" fmla="*/ 19038 w 19038"/>
                <a:gd name="T23" fmla="*/ 441 h 7024"/>
                <a:gd name="T24" fmla="*/ 19038 w 19038"/>
                <a:gd name="T25" fmla="*/ 0 h 7024"/>
                <a:gd name="T26" fmla="*/ 0 w 19038"/>
                <a:gd name="T27" fmla="*/ 0 h 70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19038" h="7024">
                  <a:moveTo>
                    <a:pt x="0" y="0"/>
                  </a:moveTo>
                  <a:lnTo>
                    <a:pt x="0" y="3512"/>
                  </a:lnTo>
                  <a:lnTo>
                    <a:pt x="0" y="7024"/>
                  </a:lnTo>
                  <a:lnTo>
                    <a:pt x="2582" y="7024"/>
                  </a:lnTo>
                  <a:lnTo>
                    <a:pt x="2582" y="4389"/>
                  </a:lnTo>
                  <a:lnTo>
                    <a:pt x="9464" y="4389"/>
                  </a:lnTo>
                  <a:lnTo>
                    <a:pt x="9464" y="1709"/>
                  </a:lnTo>
                  <a:lnTo>
                    <a:pt x="10178" y="1709"/>
                  </a:lnTo>
                  <a:lnTo>
                    <a:pt x="10178" y="661"/>
                  </a:lnTo>
                  <a:lnTo>
                    <a:pt x="11407" y="661"/>
                  </a:lnTo>
                  <a:lnTo>
                    <a:pt x="11407" y="441"/>
                  </a:lnTo>
                  <a:lnTo>
                    <a:pt x="19038" y="441"/>
                  </a:lnTo>
                  <a:lnTo>
                    <a:pt x="19038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52" name="Freeform 32"/>
            <p:cNvSpPr>
              <a:spLocks/>
            </p:cNvSpPr>
            <p:nvPr/>
          </p:nvSpPr>
          <p:spPr bwMode="auto">
            <a:xfrm>
              <a:off x="637" y="1059"/>
              <a:ext cx="2990" cy="106"/>
            </a:xfrm>
            <a:custGeom>
              <a:avLst/>
              <a:gdLst>
                <a:gd name="T0" fmla="*/ 0 w 24433"/>
                <a:gd name="T1" fmla="*/ 0 h 661"/>
                <a:gd name="T2" fmla="*/ 0 w 24433"/>
                <a:gd name="T3" fmla="*/ 331 h 661"/>
                <a:gd name="T4" fmla="*/ 0 w 24433"/>
                <a:gd name="T5" fmla="*/ 661 h 661"/>
                <a:gd name="T6" fmla="*/ 552 w 24433"/>
                <a:gd name="T7" fmla="*/ 661 h 661"/>
                <a:gd name="T8" fmla="*/ 552 w 24433"/>
                <a:gd name="T9" fmla="*/ 441 h 661"/>
                <a:gd name="T10" fmla="*/ 24433 w 24433"/>
                <a:gd name="T11" fmla="*/ 441 h 661"/>
                <a:gd name="T12" fmla="*/ 24433 w 24433"/>
                <a:gd name="T13" fmla="*/ 0 h 661"/>
                <a:gd name="T14" fmla="*/ 0 w 24433"/>
                <a:gd name="T15" fmla="*/ 0 h 6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4433" h="661">
                  <a:moveTo>
                    <a:pt x="0" y="0"/>
                  </a:moveTo>
                  <a:lnTo>
                    <a:pt x="0" y="331"/>
                  </a:lnTo>
                  <a:lnTo>
                    <a:pt x="0" y="661"/>
                  </a:lnTo>
                  <a:lnTo>
                    <a:pt x="552" y="661"/>
                  </a:lnTo>
                  <a:lnTo>
                    <a:pt x="552" y="441"/>
                  </a:lnTo>
                  <a:lnTo>
                    <a:pt x="24433" y="441"/>
                  </a:lnTo>
                  <a:lnTo>
                    <a:pt x="24433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53" name="Freeform 33"/>
            <p:cNvSpPr>
              <a:spLocks/>
            </p:cNvSpPr>
            <p:nvPr/>
          </p:nvSpPr>
          <p:spPr bwMode="auto">
            <a:xfrm>
              <a:off x="2895" y="2329"/>
              <a:ext cx="732" cy="494"/>
            </a:xfrm>
            <a:custGeom>
              <a:avLst/>
              <a:gdLst>
                <a:gd name="T0" fmla="*/ 0 w 5982"/>
                <a:gd name="T1" fmla="*/ 0 h 3087"/>
                <a:gd name="T2" fmla="*/ 0 w 5982"/>
                <a:gd name="T3" fmla="*/ 1543 h 3087"/>
                <a:gd name="T4" fmla="*/ 0 w 5982"/>
                <a:gd name="T5" fmla="*/ 3087 h 3087"/>
                <a:gd name="T6" fmla="*/ 5982 w 5982"/>
                <a:gd name="T7" fmla="*/ 3087 h 3087"/>
                <a:gd name="T8" fmla="*/ 5982 w 5982"/>
                <a:gd name="T9" fmla="*/ 0 h 3087"/>
                <a:gd name="T10" fmla="*/ 0 w 5982"/>
                <a:gd name="T11" fmla="*/ 0 h 30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5982" h="3087">
                  <a:moveTo>
                    <a:pt x="0" y="0"/>
                  </a:moveTo>
                  <a:lnTo>
                    <a:pt x="0" y="1543"/>
                  </a:lnTo>
                  <a:lnTo>
                    <a:pt x="0" y="3087"/>
                  </a:lnTo>
                  <a:lnTo>
                    <a:pt x="5982" y="3087"/>
                  </a:lnTo>
                  <a:lnTo>
                    <a:pt x="5982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54" name="Freeform 34"/>
            <p:cNvSpPr>
              <a:spLocks/>
            </p:cNvSpPr>
            <p:nvPr/>
          </p:nvSpPr>
          <p:spPr bwMode="auto">
            <a:xfrm>
              <a:off x="1972" y="5432"/>
              <a:ext cx="1655" cy="269"/>
            </a:xfrm>
            <a:custGeom>
              <a:avLst/>
              <a:gdLst>
                <a:gd name="T0" fmla="*/ 0 w 13527"/>
                <a:gd name="T1" fmla="*/ 0 h 1681"/>
                <a:gd name="T2" fmla="*/ 0 w 13527"/>
                <a:gd name="T3" fmla="*/ 840 h 1681"/>
                <a:gd name="T4" fmla="*/ 0 w 13527"/>
                <a:gd name="T5" fmla="*/ 1681 h 1681"/>
                <a:gd name="T6" fmla="*/ 690 w 13527"/>
                <a:gd name="T7" fmla="*/ 1681 h 1681"/>
                <a:gd name="T8" fmla="*/ 690 w 13527"/>
                <a:gd name="T9" fmla="*/ 827 h 1681"/>
                <a:gd name="T10" fmla="*/ 1661 w 13527"/>
                <a:gd name="T11" fmla="*/ 827 h 1681"/>
                <a:gd name="T12" fmla="*/ 1661 w 13527"/>
                <a:gd name="T13" fmla="*/ 441 h 1681"/>
                <a:gd name="T14" fmla="*/ 13527 w 13527"/>
                <a:gd name="T15" fmla="*/ 441 h 1681"/>
                <a:gd name="T16" fmla="*/ 13527 w 13527"/>
                <a:gd name="T17" fmla="*/ 0 h 1681"/>
                <a:gd name="T18" fmla="*/ 0 w 13527"/>
                <a:gd name="T19" fmla="*/ 0 h 168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13527" h="1681">
                  <a:moveTo>
                    <a:pt x="0" y="0"/>
                  </a:moveTo>
                  <a:lnTo>
                    <a:pt x="0" y="840"/>
                  </a:lnTo>
                  <a:lnTo>
                    <a:pt x="0" y="1681"/>
                  </a:lnTo>
                  <a:lnTo>
                    <a:pt x="690" y="1681"/>
                  </a:lnTo>
                  <a:lnTo>
                    <a:pt x="690" y="827"/>
                  </a:lnTo>
                  <a:lnTo>
                    <a:pt x="1661" y="827"/>
                  </a:lnTo>
                  <a:lnTo>
                    <a:pt x="1661" y="441"/>
                  </a:lnTo>
                  <a:lnTo>
                    <a:pt x="13527" y="441"/>
                  </a:lnTo>
                  <a:lnTo>
                    <a:pt x="13527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55" name="Freeform 35"/>
            <p:cNvSpPr>
              <a:spLocks/>
            </p:cNvSpPr>
            <p:nvPr/>
          </p:nvSpPr>
          <p:spPr bwMode="auto">
            <a:xfrm>
              <a:off x="802" y="1342"/>
              <a:ext cx="2825" cy="70"/>
            </a:xfrm>
            <a:custGeom>
              <a:avLst/>
              <a:gdLst>
                <a:gd name="T0" fmla="*/ 0 w 23090"/>
                <a:gd name="T1" fmla="*/ 0 h 441"/>
                <a:gd name="T2" fmla="*/ 0 w 23090"/>
                <a:gd name="T3" fmla="*/ 220 h 441"/>
                <a:gd name="T4" fmla="*/ 0 w 23090"/>
                <a:gd name="T5" fmla="*/ 441 h 441"/>
                <a:gd name="T6" fmla="*/ 23090 w 23090"/>
                <a:gd name="T7" fmla="*/ 441 h 441"/>
                <a:gd name="T8" fmla="*/ 23090 w 23090"/>
                <a:gd name="T9" fmla="*/ 0 h 441"/>
                <a:gd name="T10" fmla="*/ 0 w 23090"/>
                <a:gd name="T11" fmla="*/ 0 h 4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3090" h="441">
                  <a:moveTo>
                    <a:pt x="0" y="0"/>
                  </a:moveTo>
                  <a:lnTo>
                    <a:pt x="0" y="220"/>
                  </a:lnTo>
                  <a:lnTo>
                    <a:pt x="0" y="441"/>
                  </a:lnTo>
                  <a:lnTo>
                    <a:pt x="23090" y="441"/>
                  </a:lnTo>
                  <a:lnTo>
                    <a:pt x="2309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56" name="Freeform 36"/>
            <p:cNvSpPr>
              <a:spLocks/>
            </p:cNvSpPr>
            <p:nvPr/>
          </p:nvSpPr>
          <p:spPr bwMode="auto">
            <a:xfrm>
              <a:off x="1238" y="3509"/>
              <a:ext cx="2389" cy="1074"/>
            </a:xfrm>
            <a:custGeom>
              <a:avLst/>
              <a:gdLst>
                <a:gd name="T0" fmla="*/ 0 w 19523"/>
                <a:gd name="T1" fmla="*/ 0 h 6716"/>
                <a:gd name="T2" fmla="*/ 0 w 19523"/>
                <a:gd name="T3" fmla="*/ 3358 h 6716"/>
                <a:gd name="T4" fmla="*/ 0 w 19523"/>
                <a:gd name="T5" fmla="*/ 6716 h 6716"/>
                <a:gd name="T6" fmla="*/ 485 w 19523"/>
                <a:gd name="T7" fmla="*/ 6716 h 6716"/>
                <a:gd name="T8" fmla="*/ 485 w 19523"/>
                <a:gd name="T9" fmla="*/ 3204 h 6716"/>
                <a:gd name="T10" fmla="*/ 19523 w 19523"/>
                <a:gd name="T11" fmla="*/ 3204 h 6716"/>
                <a:gd name="T12" fmla="*/ 19523 w 19523"/>
                <a:gd name="T13" fmla="*/ 2763 h 6716"/>
                <a:gd name="T14" fmla="*/ 3286 w 19523"/>
                <a:gd name="T15" fmla="*/ 2763 h 6716"/>
                <a:gd name="T16" fmla="*/ 3286 w 19523"/>
                <a:gd name="T17" fmla="*/ 2432 h 6716"/>
                <a:gd name="T18" fmla="*/ 2582 w 19523"/>
                <a:gd name="T19" fmla="*/ 2432 h 6716"/>
                <a:gd name="T20" fmla="*/ 2582 w 19523"/>
                <a:gd name="T21" fmla="*/ 1206 h 6716"/>
                <a:gd name="T22" fmla="*/ 1626 w 19523"/>
                <a:gd name="T23" fmla="*/ 1206 h 6716"/>
                <a:gd name="T24" fmla="*/ 1626 w 19523"/>
                <a:gd name="T25" fmla="*/ 0 h 6716"/>
                <a:gd name="T26" fmla="*/ 0 w 19523"/>
                <a:gd name="T27" fmla="*/ 0 h 67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19523" h="6716">
                  <a:moveTo>
                    <a:pt x="0" y="0"/>
                  </a:moveTo>
                  <a:lnTo>
                    <a:pt x="0" y="3358"/>
                  </a:lnTo>
                  <a:lnTo>
                    <a:pt x="0" y="6716"/>
                  </a:lnTo>
                  <a:lnTo>
                    <a:pt x="485" y="6716"/>
                  </a:lnTo>
                  <a:lnTo>
                    <a:pt x="485" y="3204"/>
                  </a:lnTo>
                  <a:lnTo>
                    <a:pt x="19523" y="3204"/>
                  </a:lnTo>
                  <a:lnTo>
                    <a:pt x="19523" y="2763"/>
                  </a:lnTo>
                  <a:lnTo>
                    <a:pt x="3286" y="2763"/>
                  </a:lnTo>
                  <a:lnTo>
                    <a:pt x="3286" y="2432"/>
                  </a:lnTo>
                  <a:lnTo>
                    <a:pt x="2582" y="2432"/>
                  </a:lnTo>
                  <a:lnTo>
                    <a:pt x="2582" y="1206"/>
                  </a:lnTo>
                  <a:lnTo>
                    <a:pt x="1626" y="1206"/>
                  </a:lnTo>
                  <a:lnTo>
                    <a:pt x="1626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57" name="Freeform 37"/>
            <p:cNvSpPr>
              <a:spLocks/>
            </p:cNvSpPr>
            <p:nvPr/>
          </p:nvSpPr>
          <p:spPr bwMode="auto">
            <a:xfrm>
              <a:off x="2295" y="1544"/>
              <a:ext cx="1332" cy="221"/>
            </a:xfrm>
            <a:custGeom>
              <a:avLst/>
              <a:gdLst>
                <a:gd name="T0" fmla="*/ 0 w 10889"/>
                <a:gd name="T1" fmla="*/ 0 h 1378"/>
                <a:gd name="T2" fmla="*/ 0 w 10889"/>
                <a:gd name="T3" fmla="*/ 689 h 1378"/>
                <a:gd name="T4" fmla="*/ 0 w 10889"/>
                <a:gd name="T5" fmla="*/ 1378 h 1378"/>
                <a:gd name="T6" fmla="*/ 10889 w 10889"/>
                <a:gd name="T7" fmla="*/ 1378 h 1378"/>
                <a:gd name="T8" fmla="*/ 10889 w 10889"/>
                <a:gd name="T9" fmla="*/ 937 h 1378"/>
                <a:gd name="T10" fmla="*/ 4820 w 10889"/>
                <a:gd name="T11" fmla="*/ 937 h 1378"/>
                <a:gd name="T12" fmla="*/ 4820 w 10889"/>
                <a:gd name="T13" fmla="*/ 717 h 1378"/>
                <a:gd name="T14" fmla="*/ 2605 w 10889"/>
                <a:gd name="T15" fmla="*/ 717 h 1378"/>
                <a:gd name="T16" fmla="*/ 2605 w 10889"/>
                <a:gd name="T17" fmla="*/ 386 h 1378"/>
                <a:gd name="T18" fmla="*/ 1608 w 10889"/>
                <a:gd name="T19" fmla="*/ 386 h 1378"/>
                <a:gd name="T20" fmla="*/ 1608 w 10889"/>
                <a:gd name="T21" fmla="*/ 0 h 1378"/>
                <a:gd name="T22" fmla="*/ 0 w 10889"/>
                <a:gd name="T23" fmla="*/ 0 h 13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10889" h="1378">
                  <a:moveTo>
                    <a:pt x="0" y="0"/>
                  </a:moveTo>
                  <a:lnTo>
                    <a:pt x="0" y="689"/>
                  </a:lnTo>
                  <a:lnTo>
                    <a:pt x="0" y="1378"/>
                  </a:lnTo>
                  <a:lnTo>
                    <a:pt x="10889" y="1378"/>
                  </a:lnTo>
                  <a:lnTo>
                    <a:pt x="10889" y="937"/>
                  </a:lnTo>
                  <a:lnTo>
                    <a:pt x="4820" y="937"/>
                  </a:lnTo>
                  <a:lnTo>
                    <a:pt x="4820" y="717"/>
                  </a:lnTo>
                  <a:lnTo>
                    <a:pt x="2605" y="717"/>
                  </a:lnTo>
                  <a:lnTo>
                    <a:pt x="2605" y="386"/>
                  </a:lnTo>
                  <a:lnTo>
                    <a:pt x="1608" y="386"/>
                  </a:lnTo>
                  <a:lnTo>
                    <a:pt x="1608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58" name="Freeform 38"/>
            <p:cNvSpPr>
              <a:spLocks/>
            </p:cNvSpPr>
            <p:nvPr/>
          </p:nvSpPr>
          <p:spPr bwMode="auto">
            <a:xfrm>
              <a:off x="2888" y="2047"/>
              <a:ext cx="739" cy="70"/>
            </a:xfrm>
            <a:custGeom>
              <a:avLst/>
              <a:gdLst>
                <a:gd name="T0" fmla="*/ 0 w 6038"/>
                <a:gd name="T1" fmla="*/ 0 h 441"/>
                <a:gd name="T2" fmla="*/ 0 w 6038"/>
                <a:gd name="T3" fmla="*/ 221 h 441"/>
                <a:gd name="T4" fmla="*/ 0 w 6038"/>
                <a:gd name="T5" fmla="*/ 441 h 441"/>
                <a:gd name="T6" fmla="*/ 6038 w 6038"/>
                <a:gd name="T7" fmla="*/ 441 h 441"/>
                <a:gd name="T8" fmla="*/ 6038 w 6038"/>
                <a:gd name="T9" fmla="*/ 0 h 441"/>
                <a:gd name="T10" fmla="*/ 0 w 6038"/>
                <a:gd name="T11" fmla="*/ 0 h 4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6038" h="441">
                  <a:moveTo>
                    <a:pt x="0" y="0"/>
                  </a:moveTo>
                  <a:lnTo>
                    <a:pt x="0" y="221"/>
                  </a:lnTo>
                  <a:lnTo>
                    <a:pt x="0" y="441"/>
                  </a:lnTo>
                  <a:lnTo>
                    <a:pt x="6038" y="441"/>
                  </a:lnTo>
                  <a:lnTo>
                    <a:pt x="6038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59" name="Freeform 39"/>
            <p:cNvSpPr>
              <a:spLocks/>
            </p:cNvSpPr>
            <p:nvPr/>
          </p:nvSpPr>
          <p:spPr bwMode="auto">
            <a:xfrm>
              <a:off x="2796" y="1976"/>
              <a:ext cx="831" cy="106"/>
            </a:xfrm>
            <a:custGeom>
              <a:avLst/>
              <a:gdLst>
                <a:gd name="T0" fmla="*/ 0 w 6795"/>
                <a:gd name="T1" fmla="*/ 0 h 662"/>
                <a:gd name="T2" fmla="*/ 0 w 6795"/>
                <a:gd name="T3" fmla="*/ 331 h 662"/>
                <a:gd name="T4" fmla="*/ 0 w 6795"/>
                <a:gd name="T5" fmla="*/ 662 h 662"/>
                <a:gd name="T6" fmla="*/ 757 w 6795"/>
                <a:gd name="T7" fmla="*/ 662 h 662"/>
                <a:gd name="T8" fmla="*/ 757 w 6795"/>
                <a:gd name="T9" fmla="*/ 441 h 662"/>
                <a:gd name="T10" fmla="*/ 6795 w 6795"/>
                <a:gd name="T11" fmla="*/ 441 h 662"/>
                <a:gd name="T12" fmla="*/ 6795 w 6795"/>
                <a:gd name="T13" fmla="*/ 0 h 662"/>
                <a:gd name="T14" fmla="*/ 0 w 6795"/>
                <a:gd name="T15" fmla="*/ 0 h 6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6795" h="662">
                  <a:moveTo>
                    <a:pt x="0" y="0"/>
                  </a:moveTo>
                  <a:lnTo>
                    <a:pt x="0" y="331"/>
                  </a:lnTo>
                  <a:lnTo>
                    <a:pt x="0" y="662"/>
                  </a:lnTo>
                  <a:lnTo>
                    <a:pt x="757" y="662"/>
                  </a:lnTo>
                  <a:lnTo>
                    <a:pt x="757" y="441"/>
                  </a:lnTo>
                  <a:lnTo>
                    <a:pt x="6795" y="441"/>
                  </a:lnTo>
                  <a:lnTo>
                    <a:pt x="6795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60" name="Freeform 40"/>
            <p:cNvSpPr>
              <a:spLocks/>
            </p:cNvSpPr>
            <p:nvPr/>
          </p:nvSpPr>
          <p:spPr bwMode="auto">
            <a:xfrm>
              <a:off x="1906" y="3387"/>
              <a:ext cx="1721" cy="70"/>
            </a:xfrm>
            <a:custGeom>
              <a:avLst/>
              <a:gdLst>
                <a:gd name="T0" fmla="*/ 0 w 14070"/>
                <a:gd name="T1" fmla="*/ 0 h 441"/>
                <a:gd name="T2" fmla="*/ 0 w 14070"/>
                <a:gd name="T3" fmla="*/ 221 h 441"/>
                <a:gd name="T4" fmla="*/ 0 w 14070"/>
                <a:gd name="T5" fmla="*/ 441 h 441"/>
                <a:gd name="T6" fmla="*/ 14070 w 14070"/>
                <a:gd name="T7" fmla="*/ 441 h 441"/>
                <a:gd name="T8" fmla="*/ 14070 w 14070"/>
                <a:gd name="T9" fmla="*/ 0 h 441"/>
                <a:gd name="T10" fmla="*/ 0 w 14070"/>
                <a:gd name="T11" fmla="*/ 0 h 4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4070" h="441">
                  <a:moveTo>
                    <a:pt x="0" y="0"/>
                  </a:moveTo>
                  <a:lnTo>
                    <a:pt x="0" y="221"/>
                  </a:lnTo>
                  <a:lnTo>
                    <a:pt x="0" y="441"/>
                  </a:lnTo>
                  <a:lnTo>
                    <a:pt x="14070" y="441"/>
                  </a:lnTo>
                  <a:lnTo>
                    <a:pt x="1407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61" name="Freeform 41"/>
            <p:cNvSpPr>
              <a:spLocks/>
            </p:cNvSpPr>
            <p:nvPr/>
          </p:nvSpPr>
          <p:spPr bwMode="auto">
            <a:xfrm>
              <a:off x="2175" y="5503"/>
              <a:ext cx="1452" cy="123"/>
            </a:xfrm>
            <a:custGeom>
              <a:avLst/>
              <a:gdLst>
                <a:gd name="T0" fmla="*/ 0 w 11866"/>
                <a:gd name="T1" fmla="*/ 0 h 772"/>
                <a:gd name="T2" fmla="*/ 0 w 11866"/>
                <a:gd name="T3" fmla="*/ 386 h 772"/>
                <a:gd name="T4" fmla="*/ 0 w 11866"/>
                <a:gd name="T5" fmla="*/ 772 h 772"/>
                <a:gd name="T6" fmla="*/ 3267 w 11866"/>
                <a:gd name="T7" fmla="*/ 772 h 772"/>
                <a:gd name="T8" fmla="*/ 3267 w 11866"/>
                <a:gd name="T9" fmla="*/ 441 h 772"/>
                <a:gd name="T10" fmla="*/ 11866 w 11866"/>
                <a:gd name="T11" fmla="*/ 441 h 772"/>
                <a:gd name="T12" fmla="*/ 11866 w 11866"/>
                <a:gd name="T13" fmla="*/ 0 h 772"/>
                <a:gd name="T14" fmla="*/ 0 w 11866"/>
                <a:gd name="T15" fmla="*/ 0 h 7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1866" h="772">
                  <a:moveTo>
                    <a:pt x="0" y="0"/>
                  </a:moveTo>
                  <a:lnTo>
                    <a:pt x="0" y="386"/>
                  </a:lnTo>
                  <a:lnTo>
                    <a:pt x="0" y="772"/>
                  </a:lnTo>
                  <a:lnTo>
                    <a:pt x="3267" y="772"/>
                  </a:lnTo>
                  <a:lnTo>
                    <a:pt x="3267" y="441"/>
                  </a:lnTo>
                  <a:lnTo>
                    <a:pt x="11866" y="441"/>
                  </a:lnTo>
                  <a:lnTo>
                    <a:pt x="11866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62" name="Freeform 42"/>
            <p:cNvSpPr>
              <a:spLocks/>
            </p:cNvSpPr>
            <p:nvPr/>
          </p:nvSpPr>
          <p:spPr bwMode="auto">
            <a:xfrm>
              <a:off x="1614" y="4723"/>
              <a:ext cx="2013" cy="843"/>
            </a:xfrm>
            <a:custGeom>
              <a:avLst/>
              <a:gdLst>
                <a:gd name="T0" fmla="*/ 0 w 16456"/>
                <a:gd name="T1" fmla="*/ 0 h 5270"/>
                <a:gd name="T2" fmla="*/ 0 w 16456"/>
                <a:gd name="T3" fmla="*/ 2635 h 5270"/>
                <a:gd name="T4" fmla="*/ 0 w 16456"/>
                <a:gd name="T5" fmla="*/ 5270 h 5270"/>
                <a:gd name="T6" fmla="*/ 2929 w 16456"/>
                <a:gd name="T7" fmla="*/ 5270 h 5270"/>
                <a:gd name="T8" fmla="*/ 2929 w 16456"/>
                <a:gd name="T9" fmla="*/ 4430 h 5270"/>
                <a:gd name="T10" fmla="*/ 16456 w 16456"/>
                <a:gd name="T11" fmla="*/ 4430 h 5270"/>
                <a:gd name="T12" fmla="*/ 16456 w 16456"/>
                <a:gd name="T13" fmla="*/ 3989 h 5270"/>
                <a:gd name="T14" fmla="*/ 7600 w 16456"/>
                <a:gd name="T15" fmla="*/ 3989 h 5270"/>
                <a:gd name="T16" fmla="*/ 7600 w 16456"/>
                <a:gd name="T17" fmla="*/ 3576 h 5270"/>
                <a:gd name="T18" fmla="*/ 7175 w 16456"/>
                <a:gd name="T19" fmla="*/ 3576 h 5270"/>
                <a:gd name="T20" fmla="*/ 7175 w 16456"/>
                <a:gd name="T21" fmla="*/ 2680 h 5270"/>
                <a:gd name="T22" fmla="*/ 6882 w 16456"/>
                <a:gd name="T23" fmla="*/ 2680 h 5270"/>
                <a:gd name="T24" fmla="*/ 6882 w 16456"/>
                <a:gd name="T25" fmla="*/ 0 h 5270"/>
                <a:gd name="T26" fmla="*/ 0 w 16456"/>
                <a:gd name="T27" fmla="*/ 0 h 52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16456" h="5270">
                  <a:moveTo>
                    <a:pt x="0" y="0"/>
                  </a:moveTo>
                  <a:lnTo>
                    <a:pt x="0" y="2635"/>
                  </a:lnTo>
                  <a:lnTo>
                    <a:pt x="0" y="5270"/>
                  </a:lnTo>
                  <a:lnTo>
                    <a:pt x="2929" y="5270"/>
                  </a:lnTo>
                  <a:lnTo>
                    <a:pt x="2929" y="4430"/>
                  </a:lnTo>
                  <a:lnTo>
                    <a:pt x="16456" y="4430"/>
                  </a:lnTo>
                  <a:lnTo>
                    <a:pt x="16456" y="3989"/>
                  </a:lnTo>
                  <a:lnTo>
                    <a:pt x="7600" y="3989"/>
                  </a:lnTo>
                  <a:lnTo>
                    <a:pt x="7600" y="3576"/>
                  </a:lnTo>
                  <a:lnTo>
                    <a:pt x="7175" y="3576"/>
                  </a:lnTo>
                  <a:lnTo>
                    <a:pt x="7175" y="2680"/>
                  </a:lnTo>
                  <a:lnTo>
                    <a:pt x="6882" y="2680"/>
                  </a:lnTo>
                  <a:lnTo>
                    <a:pt x="6882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63" name="Freeform 43"/>
            <p:cNvSpPr>
              <a:spLocks/>
            </p:cNvSpPr>
            <p:nvPr/>
          </p:nvSpPr>
          <p:spPr bwMode="auto">
            <a:xfrm>
              <a:off x="1799" y="3528"/>
              <a:ext cx="1828" cy="123"/>
            </a:xfrm>
            <a:custGeom>
              <a:avLst/>
              <a:gdLst>
                <a:gd name="T0" fmla="*/ 0 w 14942"/>
                <a:gd name="T1" fmla="*/ 0 h 772"/>
                <a:gd name="T2" fmla="*/ 0 w 14942"/>
                <a:gd name="T3" fmla="*/ 386 h 772"/>
                <a:gd name="T4" fmla="*/ 0 w 14942"/>
                <a:gd name="T5" fmla="*/ 772 h 772"/>
                <a:gd name="T6" fmla="*/ 4472 w 14942"/>
                <a:gd name="T7" fmla="*/ 772 h 772"/>
                <a:gd name="T8" fmla="*/ 4472 w 14942"/>
                <a:gd name="T9" fmla="*/ 441 h 772"/>
                <a:gd name="T10" fmla="*/ 14942 w 14942"/>
                <a:gd name="T11" fmla="*/ 441 h 772"/>
                <a:gd name="T12" fmla="*/ 14942 w 14942"/>
                <a:gd name="T13" fmla="*/ 0 h 772"/>
                <a:gd name="T14" fmla="*/ 0 w 14942"/>
                <a:gd name="T15" fmla="*/ 0 h 7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4942" h="772">
                  <a:moveTo>
                    <a:pt x="0" y="0"/>
                  </a:moveTo>
                  <a:lnTo>
                    <a:pt x="0" y="386"/>
                  </a:lnTo>
                  <a:lnTo>
                    <a:pt x="0" y="772"/>
                  </a:lnTo>
                  <a:lnTo>
                    <a:pt x="4472" y="772"/>
                  </a:lnTo>
                  <a:lnTo>
                    <a:pt x="4472" y="441"/>
                  </a:lnTo>
                  <a:lnTo>
                    <a:pt x="14942" y="441"/>
                  </a:lnTo>
                  <a:lnTo>
                    <a:pt x="14942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64" name="Freeform 44"/>
            <p:cNvSpPr>
              <a:spLocks/>
            </p:cNvSpPr>
            <p:nvPr/>
          </p:nvSpPr>
          <p:spPr bwMode="auto">
            <a:xfrm>
              <a:off x="2303" y="5855"/>
              <a:ext cx="1324" cy="71"/>
            </a:xfrm>
            <a:custGeom>
              <a:avLst/>
              <a:gdLst>
                <a:gd name="T0" fmla="*/ 0 w 10821"/>
                <a:gd name="T1" fmla="*/ 0 h 441"/>
                <a:gd name="T2" fmla="*/ 0 w 10821"/>
                <a:gd name="T3" fmla="*/ 220 h 441"/>
                <a:gd name="T4" fmla="*/ 0 w 10821"/>
                <a:gd name="T5" fmla="*/ 441 h 441"/>
                <a:gd name="T6" fmla="*/ 10821 w 10821"/>
                <a:gd name="T7" fmla="*/ 441 h 441"/>
                <a:gd name="T8" fmla="*/ 10821 w 10821"/>
                <a:gd name="T9" fmla="*/ 0 h 441"/>
                <a:gd name="T10" fmla="*/ 0 w 10821"/>
                <a:gd name="T11" fmla="*/ 0 h 4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0821" h="441">
                  <a:moveTo>
                    <a:pt x="0" y="0"/>
                  </a:moveTo>
                  <a:lnTo>
                    <a:pt x="0" y="220"/>
                  </a:lnTo>
                  <a:lnTo>
                    <a:pt x="0" y="441"/>
                  </a:lnTo>
                  <a:lnTo>
                    <a:pt x="10821" y="441"/>
                  </a:lnTo>
                  <a:lnTo>
                    <a:pt x="10821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65" name="Freeform 45"/>
            <p:cNvSpPr>
              <a:spLocks/>
            </p:cNvSpPr>
            <p:nvPr/>
          </p:nvSpPr>
          <p:spPr bwMode="auto">
            <a:xfrm>
              <a:off x="512" y="989"/>
              <a:ext cx="3115" cy="203"/>
            </a:xfrm>
            <a:custGeom>
              <a:avLst/>
              <a:gdLst>
                <a:gd name="T0" fmla="*/ 0 w 25458"/>
                <a:gd name="T1" fmla="*/ 0 h 1268"/>
                <a:gd name="T2" fmla="*/ 0 w 25458"/>
                <a:gd name="T3" fmla="*/ 634 h 1268"/>
                <a:gd name="T4" fmla="*/ 0 w 25458"/>
                <a:gd name="T5" fmla="*/ 1268 h 1268"/>
                <a:gd name="T6" fmla="*/ 676 w 25458"/>
                <a:gd name="T7" fmla="*/ 1268 h 1268"/>
                <a:gd name="T8" fmla="*/ 676 w 25458"/>
                <a:gd name="T9" fmla="*/ 772 h 1268"/>
                <a:gd name="T10" fmla="*/ 1025 w 25458"/>
                <a:gd name="T11" fmla="*/ 772 h 1268"/>
                <a:gd name="T12" fmla="*/ 1025 w 25458"/>
                <a:gd name="T13" fmla="*/ 441 h 1268"/>
                <a:gd name="T14" fmla="*/ 25458 w 25458"/>
                <a:gd name="T15" fmla="*/ 441 h 1268"/>
                <a:gd name="T16" fmla="*/ 25458 w 25458"/>
                <a:gd name="T17" fmla="*/ 0 h 1268"/>
                <a:gd name="T18" fmla="*/ 0 w 25458"/>
                <a:gd name="T19" fmla="*/ 0 h 12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25458" h="1268">
                  <a:moveTo>
                    <a:pt x="0" y="0"/>
                  </a:moveTo>
                  <a:lnTo>
                    <a:pt x="0" y="634"/>
                  </a:lnTo>
                  <a:lnTo>
                    <a:pt x="0" y="1268"/>
                  </a:lnTo>
                  <a:lnTo>
                    <a:pt x="676" y="1268"/>
                  </a:lnTo>
                  <a:lnTo>
                    <a:pt x="676" y="772"/>
                  </a:lnTo>
                  <a:lnTo>
                    <a:pt x="1025" y="772"/>
                  </a:lnTo>
                  <a:lnTo>
                    <a:pt x="1025" y="441"/>
                  </a:lnTo>
                  <a:lnTo>
                    <a:pt x="25458" y="441"/>
                  </a:lnTo>
                  <a:lnTo>
                    <a:pt x="25458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66" name="Freeform 46"/>
            <p:cNvSpPr>
              <a:spLocks/>
            </p:cNvSpPr>
            <p:nvPr/>
          </p:nvSpPr>
          <p:spPr bwMode="auto">
            <a:xfrm>
              <a:off x="397" y="1004"/>
              <a:ext cx="3230" cy="1158"/>
            </a:xfrm>
            <a:custGeom>
              <a:avLst/>
              <a:gdLst>
                <a:gd name="T0" fmla="*/ 0 w 26401"/>
                <a:gd name="T1" fmla="*/ 0 h 7238"/>
                <a:gd name="T2" fmla="*/ 0 w 26401"/>
                <a:gd name="T3" fmla="*/ 3619 h 7238"/>
                <a:gd name="T4" fmla="*/ 0 w 26401"/>
                <a:gd name="T5" fmla="*/ 7238 h 7238"/>
                <a:gd name="T6" fmla="*/ 836 w 26401"/>
                <a:gd name="T7" fmla="*/ 7238 h 7238"/>
                <a:gd name="T8" fmla="*/ 836 w 26401"/>
                <a:gd name="T9" fmla="*/ 2329 h 7238"/>
                <a:gd name="T10" fmla="*/ 3311 w 26401"/>
                <a:gd name="T11" fmla="*/ 2329 h 7238"/>
                <a:gd name="T12" fmla="*/ 3311 w 26401"/>
                <a:gd name="T13" fmla="*/ 2109 h 7238"/>
                <a:gd name="T14" fmla="*/ 26401 w 26401"/>
                <a:gd name="T15" fmla="*/ 2109 h 7238"/>
                <a:gd name="T16" fmla="*/ 26401 w 26401"/>
                <a:gd name="T17" fmla="*/ 1668 h 7238"/>
                <a:gd name="T18" fmla="*/ 1619 w 26401"/>
                <a:gd name="T19" fmla="*/ 1668 h 7238"/>
                <a:gd name="T20" fmla="*/ 1619 w 26401"/>
                <a:gd name="T21" fmla="*/ 1172 h 7238"/>
                <a:gd name="T22" fmla="*/ 943 w 26401"/>
                <a:gd name="T23" fmla="*/ 1172 h 7238"/>
                <a:gd name="T24" fmla="*/ 943 w 26401"/>
                <a:gd name="T25" fmla="*/ 538 h 7238"/>
                <a:gd name="T26" fmla="*/ 357 w 26401"/>
                <a:gd name="T27" fmla="*/ 538 h 7238"/>
                <a:gd name="T28" fmla="*/ 357 w 26401"/>
                <a:gd name="T29" fmla="*/ 0 h 7238"/>
                <a:gd name="T30" fmla="*/ 0 w 26401"/>
                <a:gd name="T31" fmla="*/ 0 h 72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26401" h="7238">
                  <a:moveTo>
                    <a:pt x="0" y="0"/>
                  </a:moveTo>
                  <a:lnTo>
                    <a:pt x="0" y="3619"/>
                  </a:lnTo>
                  <a:lnTo>
                    <a:pt x="0" y="7238"/>
                  </a:lnTo>
                  <a:lnTo>
                    <a:pt x="836" y="7238"/>
                  </a:lnTo>
                  <a:lnTo>
                    <a:pt x="836" y="2329"/>
                  </a:lnTo>
                  <a:lnTo>
                    <a:pt x="3311" y="2329"/>
                  </a:lnTo>
                  <a:lnTo>
                    <a:pt x="3311" y="2109"/>
                  </a:lnTo>
                  <a:lnTo>
                    <a:pt x="26401" y="2109"/>
                  </a:lnTo>
                  <a:lnTo>
                    <a:pt x="26401" y="1668"/>
                  </a:lnTo>
                  <a:lnTo>
                    <a:pt x="1619" y="1668"/>
                  </a:lnTo>
                  <a:lnTo>
                    <a:pt x="1619" y="1172"/>
                  </a:lnTo>
                  <a:lnTo>
                    <a:pt x="943" y="1172"/>
                  </a:lnTo>
                  <a:lnTo>
                    <a:pt x="943" y="538"/>
                  </a:lnTo>
                  <a:lnTo>
                    <a:pt x="357" y="538"/>
                  </a:lnTo>
                  <a:lnTo>
                    <a:pt x="357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67" name="Freeform 47"/>
            <p:cNvSpPr>
              <a:spLocks/>
            </p:cNvSpPr>
            <p:nvPr/>
          </p:nvSpPr>
          <p:spPr bwMode="auto">
            <a:xfrm>
              <a:off x="705" y="1130"/>
              <a:ext cx="2922" cy="70"/>
            </a:xfrm>
            <a:custGeom>
              <a:avLst/>
              <a:gdLst>
                <a:gd name="T0" fmla="*/ 0 w 23881"/>
                <a:gd name="T1" fmla="*/ 0 h 441"/>
                <a:gd name="T2" fmla="*/ 0 w 23881"/>
                <a:gd name="T3" fmla="*/ 220 h 441"/>
                <a:gd name="T4" fmla="*/ 0 w 23881"/>
                <a:gd name="T5" fmla="*/ 441 h 441"/>
                <a:gd name="T6" fmla="*/ 23881 w 23881"/>
                <a:gd name="T7" fmla="*/ 441 h 441"/>
                <a:gd name="T8" fmla="*/ 23881 w 23881"/>
                <a:gd name="T9" fmla="*/ 0 h 441"/>
                <a:gd name="T10" fmla="*/ 0 w 23881"/>
                <a:gd name="T11" fmla="*/ 0 h 4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3881" h="441">
                  <a:moveTo>
                    <a:pt x="0" y="0"/>
                  </a:moveTo>
                  <a:lnTo>
                    <a:pt x="0" y="220"/>
                  </a:lnTo>
                  <a:lnTo>
                    <a:pt x="0" y="441"/>
                  </a:lnTo>
                  <a:lnTo>
                    <a:pt x="23881" y="441"/>
                  </a:lnTo>
                  <a:lnTo>
                    <a:pt x="23881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68" name="Freeform 48"/>
            <p:cNvSpPr>
              <a:spLocks/>
            </p:cNvSpPr>
            <p:nvPr/>
          </p:nvSpPr>
          <p:spPr bwMode="auto">
            <a:xfrm>
              <a:off x="2734" y="5115"/>
              <a:ext cx="893" cy="105"/>
            </a:xfrm>
            <a:custGeom>
              <a:avLst/>
              <a:gdLst>
                <a:gd name="T0" fmla="*/ 0 w 7300"/>
                <a:gd name="T1" fmla="*/ 0 h 661"/>
                <a:gd name="T2" fmla="*/ 0 w 7300"/>
                <a:gd name="T3" fmla="*/ 330 h 661"/>
                <a:gd name="T4" fmla="*/ 0 w 7300"/>
                <a:gd name="T5" fmla="*/ 661 h 661"/>
                <a:gd name="T6" fmla="*/ 7300 w 7300"/>
                <a:gd name="T7" fmla="*/ 661 h 661"/>
                <a:gd name="T8" fmla="*/ 7300 w 7300"/>
                <a:gd name="T9" fmla="*/ 220 h 661"/>
                <a:gd name="T10" fmla="*/ 4497 w 7300"/>
                <a:gd name="T11" fmla="*/ 220 h 661"/>
                <a:gd name="T12" fmla="*/ 4497 w 7300"/>
                <a:gd name="T13" fmla="*/ 0 h 661"/>
                <a:gd name="T14" fmla="*/ 0 w 7300"/>
                <a:gd name="T15" fmla="*/ 0 h 6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7300" h="661">
                  <a:moveTo>
                    <a:pt x="0" y="0"/>
                  </a:moveTo>
                  <a:lnTo>
                    <a:pt x="0" y="330"/>
                  </a:lnTo>
                  <a:lnTo>
                    <a:pt x="0" y="661"/>
                  </a:lnTo>
                  <a:lnTo>
                    <a:pt x="7300" y="661"/>
                  </a:lnTo>
                  <a:lnTo>
                    <a:pt x="7300" y="220"/>
                  </a:lnTo>
                  <a:lnTo>
                    <a:pt x="4497" y="220"/>
                  </a:lnTo>
                  <a:lnTo>
                    <a:pt x="4497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69" name="Freeform 49"/>
            <p:cNvSpPr>
              <a:spLocks/>
            </p:cNvSpPr>
            <p:nvPr/>
          </p:nvSpPr>
          <p:spPr bwMode="auto">
            <a:xfrm>
              <a:off x="232" y="143"/>
              <a:ext cx="3395" cy="967"/>
            </a:xfrm>
            <a:custGeom>
              <a:avLst/>
              <a:gdLst>
                <a:gd name="T0" fmla="*/ 0 w 27743"/>
                <a:gd name="T1" fmla="*/ 0 h 6046"/>
                <a:gd name="T2" fmla="*/ 0 w 27743"/>
                <a:gd name="T3" fmla="*/ 3023 h 6046"/>
                <a:gd name="T4" fmla="*/ 0 w 27743"/>
                <a:gd name="T5" fmla="*/ 6046 h 6046"/>
                <a:gd name="T6" fmla="*/ 876 w 27743"/>
                <a:gd name="T7" fmla="*/ 6046 h 6046"/>
                <a:gd name="T8" fmla="*/ 876 w 27743"/>
                <a:gd name="T9" fmla="*/ 3086 h 6046"/>
                <a:gd name="T10" fmla="*/ 2133 w 27743"/>
                <a:gd name="T11" fmla="*/ 3086 h 6046"/>
                <a:gd name="T12" fmla="*/ 2133 w 27743"/>
                <a:gd name="T13" fmla="*/ 1984 h 6046"/>
                <a:gd name="T14" fmla="*/ 27743 w 27743"/>
                <a:gd name="T15" fmla="*/ 1984 h 6046"/>
                <a:gd name="T16" fmla="*/ 27743 w 27743"/>
                <a:gd name="T17" fmla="*/ 0 h 6046"/>
                <a:gd name="T18" fmla="*/ 0 w 27743"/>
                <a:gd name="T19" fmla="*/ 0 h 60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27743" h="6046">
                  <a:moveTo>
                    <a:pt x="0" y="0"/>
                  </a:moveTo>
                  <a:lnTo>
                    <a:pt x="0" y="3023"/>
                  </a:lnTo>
                  <a:lnTo>
                    <a:pt x="0" y="6046"/>
                  </a:lnTo>
                  <a:lnTo>
                    <a:pt x="876" y="6046"/>
                  </a:lnTo>
                  <a:lnTo>
                    <a:pt x="876" y="3086"/>
                  </a:lnTo>
                  <a:lnTo>
                    <a:pt x="2133" y="3086"/>
                  </a:lnTo>
                  <a:lnTo>
                    <a:pt x="2133" y="1984"/>
                  </a:lnTo>
                  <a:lnTo>
                    <a:pt x="27743" y="1984"/>
                  </a:lnTo>
                  <a:lnTo>
                    <a:pt x="27743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70" name="Freeform 50"/>
            <p:cNvSpPr>
              <a:spLocks/>
            </p:cNvSpPr>
            <p:nvPr/>
          </p:nvSpPr>
          <p:spPr bwMode="auto">
            <a:xfrm>
              <a:off x="2693" y="1906"/>
              <a:ext cx="934" cy="123"/>
            </a:xfrm>
            <a:custGeom>
              <a:avLst/>
              <a:gdLst>
                <a:gd name="T0" fmla="*/ 0 w 7634"/>
                <a:gd name="T1" fmla="*/ 0 h 772"/>
                <a:gd name="T2" fmla="*/ 0 w 7634"/>
                <a:gd name="T3" fmla="*/ 386 h 772"/>
                <a:gd name="T4" fmla="*/ 0 w 7634"/>
                <a:gd name="T5" fmla="*/ 772 h 772"/>
                <a:gd name="T6" fmla="*/ 839 w 7634"/>
                <a:gd name="T7" fmla="*/ 772 h 772"/>
                <a:gd name="T8" fmla="*/ 839 w 7634"/>
                <a:gd name="T9" fmla="*/ 441 h 772"/>
                <a:gd name="T10" fmla="*/ 7634 w 7634"/>
                <a:gd name="T11" fmla="*/ 441 h 772"/>
                <a:gd name="T12" fmla="*/ 7634 w 7634"/>
                <a:gd name="T13" fmla="*/ 0 h 772"/>
                <a:gd name="T14" fmla="*/ 0 w 7634"/>
                <a:gd name="T15" fmla="*/ 0 h 7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7634" h="772">
                  <a:moveTo>
                    <a:pt x="0" y="0"/>
                  </a:moveTo>
                  <a:lnTo>
                    <a:pt x="0" y="386"/>
                  </a:lnTo>
                  <a:lnTo>
                    <a:pt x="0" y="772"/>
                  </a:lnTo>
                  <a:lnTo>
                    <a:pt x="839" y="772"/>
                  </a:lnTo>
                  <a:lnTo>
                    <a:pt x="839" y="441"/>
                  </a:lnTo>
                  <a:lnTo>
                    <a:pt x="7634" y="441"/>
                  </a:lnTo>
                  <a:lnTo>
                    <a:pt x="7634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71" name="Freeform 51"/>
            <p:cNvSpPr>
              <a:spLocks/>
            </p:cNvSpPr>
            <p:nvPr/>
          </p:nvSpPr>
          <p:spPr bwMode="auto">
            <a:xfrm>
              <a:off x="1437" y="3316"/>
              <a:ext cx="2190" cy="386"/>
            </a:xfrm>
            <a:custGeom>
              <a:avLst/>
              <a:gdLst>
                <a:gd name="T0" fmla="*/ 0 w 17897"/>
                <a:gd name="T1" fmla="*/ 0 h 2412"/>
                <a:gd name="T2" fmla="*/ 0 w 17897"/>
                <a:gd name="T3" fmla="*/ 1206 h 2412"/>
                <a:gd name="T4" fmla="*/ 0 w 17897"/>
                <a:gd name="T5" fmla="*/ 2412 h 2412"/>
                <a:gd name="T6" fmla="*/ 956 w 17897"/>
                <a:gd name="T7" fmla="*/ 2412 h 2412"/>
                <a:gd name="T8" fmla="*/ 956 w 17897"/>
                <a:gd name="T9" fmla="*/ 1185 h 2412"/>
                <a:gd name="T10" fmla="*/ 2955 w 17897"/>
                <a:gd name="T11" fmla="*/ 1185 h 2412"/>
                <a:gd name="T12" fmla="*/ 2955 w 17897"/>
                <a:gd name="T13" fmla="*/ 662 h 2412"/>
                <a:gd name="T14" fmla="*/ 3827 w 17897"/>
                <a:gd name="T15" fmla="*/ 662 h 2412"/>
                <a:gd name="T16" fmla="*/ 3827 w 17897"/>
                <a:gd name="T17" fmla="*/ 441 h 2412"/>
                <a:gd name="T18" fmla="*/ 17897 w 17897"/>
                <a:gd name="T19" fmla="*/ 441 h 2412"/>
                <a:gd name="T20" fmla="*/ 17897 w 17897"/>
                <a:gd name="T21" fmla="*/ 0 h 2412"/>
                <a:gd name="T22" fmla="*/ 0 w 17897"/>
                <a:gd name="T23" fmla="*/ 0 h 24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17897" h="2412">
                  <a:moveTo>
                    <a:pt x="0" y="0"/>
                  </a:moveTo>
                  <a:lnTo>
                    <a:pt x="0" y="1206"/>
                  </a:lnTo>
                  <a:lnTo>
                    <a:pt x="0" y="2412"/>
                  </a:lnTo>
                  <a:lnTo>
                    <a:pt x="956" y="2412"/>
                  </a:lnTo>
                  <a:lnTo>
                    <a:pt x="956" y="1185"/>
                  </a:lnTo>
                  <a:lnTo>
                    <a:pt x="2955" y="1185"/>
                  </a:lnTo>
                  <a:lnTo>
                    <a:pt x="2955" y="662"/>
                  </a:lnTo>
                  <a:lnTo>
                    <a:pt x="3827" y="662"/>
                  </a:lnTo>
                  <a:lnTo>
                    <a:pt x="3827" y="441"/>
                  </a:lnTo>
                  <a:lnTo>
                    <a:pt x="17897" y="441"/>
                  </a:lnTo>
                  <a:lnTo>
                    <a:pt x="17897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72" name="Freeform 52"/>
            <p:cNvSpPr>
              <a:spLocks/>
            </p:cNvSpPr>
            <p:nvPr/>
          </p:nvSpPr>
          <p:spPr bwMode="auto">
            <a:xfrm>
              <a:off x="2544" y="2078"/>
              <a:ext cx="1083" cy="339"/>
            </a:xfrm>
            <a:custGeom>
              <a:avLst/>
              <a:gdLst>
                <a:gd name="T0" fmla="*/ 0 w 8855"/>
                <a:gd name="T1" fmla="*/ 0 h 2122"/>
                <a:gd name="T2" fmla="*/ 0 w 8855"/>
                <a:gd name="T3" fmla="*/ 1061 h 2122"/>
                <a:gd name="T4" fmla="*/ 0 w 8855"/>
                <a:gd name="T5" fmla="*/ 2122 h 2122"/>
                <a:gd name="T6" fmla="*/ 2002 w 8855"/>
                <a:gd name="T7" fmla="*/ 2122 h 2122"/>
                <a:gd name="T8" fmla="*/ 2002 w 8855"/>
                <a:gd name="T9" fmla="*/ 1130 h 2122"/>
                <a:gd name="T10" fmla="*/ 8855 w 8855"/>
                <a:gd name="T11" fmla="*/ 1130 h 2122"/>
                <a:gd name="T12" fmla="*/ 8855 w 8855"/>
                <a:gd name="T13" fmla="*/ 689 h 2122"/>
                <a:gd name="T14" fmla="*/ 760 w 8855"/>
                <a:gd name="T15" fmla="*/ 689 h 2122"/>
                <a:gd name="T16" fmla="*/ 760 w 8855"/>
                <a:gd name="T17" fmla="*/ 0 h 2122"/>
                <a:gd name="T18" fmla="*/ 0 w 8855"/>
                <a:gd name="T19" fmla="*/ 0 h 21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8855" h="2122">
                  <a:moveTo>
                    <a:pt x="0" y="0"/>
                  </a:moveTo>
                  <a:lnTo>
                    <a:pt x="0" y="1061"/>
                  </a:lnTo>
                  <a:lnTo>
                    <a:pt x="0" y="2122"/>
                  </a:lnTo>
                  <a:lnTo>
                    <a:pt x="2002" y="2122"/>
                  </a:lnTo>
                  <a:lnTo>
                    <a:pt x="2002" y="1130"/>
                  </a:lnTo>
                  <a:lnTo>
                    <a:pt x="8855" y="1130"/>
                  </a:lnTo>
                  <a:lnTo>
                    <a:pt x="8855" y="689"/>
                  </a:lnTo>
                  <a:lnTo>
                    <a:pt x="760" y="689"/>
                  </a:lnTo>
                  <a:lnTo>
                    <a:pt x="76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73" name="Freeform 53"/>
            <p:cNvSpPr>
              <a:spLocks/>
            </p:cNvSpPr>
            <p:nvPr/>
          </p:nvSpPr>
          <p:spPr bwMode="auto">
            <a:xfrm>
              <a:off x="1554" y="3506"/>
              <a:ext cx="2073" cy="392"/>
            </a:xfrm>
            <a:custGeom>
              <a:avLst/>
              <a:gdLst>
                <a:gd name="T0" fmla="*/ 0 w 16941"/>
                <a:gd name="T1" fmla="*/ 0 h 2453"/>
                <a:gd name="T2" fmla="*/ 0 w 16941"/>
                <a:gd name="T3" fmla="*/ 1227 h 2453"/>
                <a:gd name="T4" fmla="*/ 0 w 16941"/>
                <a:gd name="T5" fmla="*/ 2453 h 2453"/>
                <a:gd name="T6" fmla="*/ 704 w 16941"/>
                <a:gd name="T7" fmla="*/ 2453 h 2453"/>
                <a:gd name="T8" fmla="*/ 704 w 16941"/>
                <a:gd name="T9" fmla="*/ 2123 h 2453"/>
                <a:gd name="T10" fmla="*/ 1102 w 16941"/>
                <a:gd name="T11" fmla="*/ 2123 h 2453"/>
                <a:gd name="T12" fmla="*/ 1102 w 16941"/>
                <a:gd name="T13" fmla="*/ 1902 h 2453"/>
                <a:gd name="T14" fmla="*/ 16941 w 16941"/>
                <a:gd name="T15" fmla="*/ 1902 h 2453"/>
                <a:gd name="T16" fmla="*/ 16941 w 16941"/>
                <a:gd name="T17" fmla="*/ 1461 h 2453"/>
                <a:gd name="T18" fmla="*/ 6471 w 16941"/>
                <a:gd name="T19" fmla="*/ 1461 h 2453"/>
                <a:gd name="T20" fmla="*/ 6471 w 16941"/>
                <a:gd name="T21" fmla="*/ 1241 h 2453"/>
                <a:gd name="T22" fmla="*/ 6471 w 16941"/>
                <a:gd name="T23" fmla="*/ 1241 h 2453"/>
                <a:gd name="T24" fmla="*/ 6471 w 16941"/>
                <a:gd name="T25" fmla="*/ 910 h 2453"/>
                <a:gd name="T26" fmla="*/ 1999 w 16941"/>
                <a:gd name="T27" fmla="*/ 910 h 2453"/>
                <a:gd name="T28" fmla="*/ 1999 w 16941"/>
                <a:gd name="T29" fmla="*/ 524 h 2453"/>
                <a:gd name="T30" fmla="*/ 1999 w 16941"/>
                <a:gd name="T31" fmla="*/ 524 h 2453"/>
                <a:gd name="T32" fmla="*/ 1999 w 16941"/>
                <a:gd name="T33" fmla="*/ 0 h 2453"/>
                <a:gd name="T34" fmla="*/ 0 w 16941"/>
                <a:gd name="T35" fmla="*/ 0 h 24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6941" h="2453">
                  <a:moveTo>
                    <a:pt x="0" y="0"/>
                  </a:moveTo>
                  <a:lnTo>
                    <a:pt x="0" y="1227"/>
                  </a:lnTo>
                  <a:lnTo>
                    <a:pt x="0" y="2453"/>
                  </a:lnTo>
                  <a:lnTo>
                    <a:pt x="704" y="2453"/>
                  </a:lnTo>
                  <a:lnTo>
                    <a:pt x="704" y="2123"/>
                  </a:lnTo>
                  <a:lnTo>
                    <a:pt x="1102" y="2123"/>
                  </a:lnTo>
                  <a:lnTo>
                    <a:pt x="1102" y="1902"/>
                  </a:lnTo>
                  <a:lnTo>
                    <a:pt x="16941" y="1902"/>
                  </a:lnTo>
                  <a:lnTo>
                    <a:pt x="16941" y="1461"/>
                  </a:lnTo>
                  <a:lnTo>
                    <a:pt x="6471" y="1461"/>
                  </a:lnTo>
                  <a:lnTo>
                    <a:pt x="6471" y="1241"/>
                  </a:lnTo>
                  <a:lnTo>
                    <a:pt x="6471" y="1241"/>
                  </a:lnTo>
                  <a:lnTo>
                    <a:pt x="6471" y="910"/>
                  </a:lnTo>
                  <a:lnTo>
                    <a:pt x="1999" y="910"/>
                  </a:lnTo>
                  <a:lnTo>
                    <a:pt x="1999" y="524"/>
                  </a:lnTo>
                  <a:lnTo>
                    <a:pt x="1999" y="524"/>
                  </a:lnTo>
                  <a:lnTo>
                    <a:pt x="1999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74" name="Freeform 54"/>
            <p:cNvSpPr>
              <a:spLocks/>
            </p:cNvSpPr>
            <p:nvPr/>
          </p:nvSpPr>
          <p:spPr bwMode="auto">
            <a:xfrm>
              <a:off x="2614" y="1553"/>
              <a:ext cx="1013" cy="106"/>
            </a:xfrm>
            <a:custGeom>
              <a:avLst/>
              <a:gdLst>
                <a:gd name="T0" fmla="*/ 0 w 8284"/>
                <a:gd name="T1" fmla="*/ 0 h 661"/>
                <a:gd name="T2" fmla="*/ 0 w 8284"/>
                <a:gd name="T3" fmla="*/ 330 h 661"/>
                <a:gd name="T4" fmla="*/ 0 w 8284"/>
                <a:gd name="T5" fmla="*/ 661 h 661"/>
                <a:gd name="T6" fmla="*/ 2215 w 8284"/>
                <a:gd name="T7" fmla="*/ 661 h 661"/>
                <a:gd name="T8" fmla="*/ 2215 w 8284"/>
                <a:gd name="T9" fmla="*/ 441 h 661"/>
                <a:gd name="T10" fmla="*/ 8284 w 8284"/>
                <a:gd name="T11" fmla="*/ 441 h 661"/>
                <a:gd name="T12" fmla="*/ 8284 w 8284"/>
                <a:gd name="T13" fmla="*/ 0 h 661"/>
                <a:gd name="T14" fmla="*/ 0 w 8284"/>
                <a:gd name="T15" fmla="*/ 0 h 6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8284" h="661">
                  <a:moveTo>
                    <a:pt x="0" y="0"/>
                  </a:moveTo>
                  <a:lnTo>
                    <a:pt x="0" y="330"/>
                  </a:lnTo>
                  <a:lnTo>
                    <a:pt x="0" y="661"/>
                  </a:lnTo>
                  <a:lnTo>
                    <a:pt x="2215" y="661"/>
                  </a:lnTo>
                  <a:lnTo>
                    <a:pt x="2215" y="441"/>
                  </a:lnTo>
                  <a:lnTo>
                    <a:pt x="8284" y="441"/>
                  </a:lnTo>
                  <a:lnTo>
                    <a:pt x="8284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75" name="Freeform 55"/>
            <p:cNvSpPr>
              <a:spLocks/>
            </p:cNvSpPr>
            <p:nvPr/>
          </p:nvSpPr>
          <p:spPr bwMode="auto">
            <a:xfrm>
              <a:off x="2789" y="2258"/>
              <a:ext cx="838" cy="318"/>
            </a:xfrm>
            <a:custGeom>
              <a:avLst/>
              <a:gdLst>
                <a:gd name="T0" fmla="*/ 0 w 6853"/>
                <a:gd name="T1" fmla="*/ 0 h 1984"/>
                <a:gd name="T2" fmla="*/ 0 w 6853"/>
                <a:gd name="T3" fmla="*/ 992 h 1984"/>
                <a:gd name="T4" fmla="*/ 0 w 6853"/>
                <a:gd name="T5" fmla="*/ 1984 h 1984"/>
                <a:gd name="T6" fmla="*/ 871 w 6853"/>
                <a:gd name="T7" fmla="*/ 1984 h 1984"/>
                <a:gd name="T8" fmla="*/ 871 w 6853"/>
                <a:gd name="T9" fmla="*/ 441 h 1984"/>
                <a:gd name="T10" fmla="*/ 6853 w 6853"/>
                <a:gd name="T11" fmla="*/ 441 h 1984"/>
                <a:gd name="T12" fmla="*/ 6853 w 6853"/>
                <a:gd name="T13" fmla="*/ 0 h 1984"/>
                <a:gd name="T14" fmla="*/ 0 w 6853"/>
                <a:gd name="T15" fmla="*/ 0 h 19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6853" h="1984">
                  <a:moveTo>
                    <a:pt x="0" y="0"/>
                  </a:moveTo>
                  <a:lnTo>
                    <a:pt x="0" y="992"/>
                  </a:lnTo>
                  <a:lnTo>
                    <a:pt x="0" y="1984"/>
                  </a:lnTo>
                  <a:lnTo>
                    <a:pt x="871" y="1984"/>
                  </a:lnTo>
                  <a:lnTo>
                    <a:pt x="871" y="441"/>
                  </a:lnTo>
                  <a:lnTo>
                    <a:pt x="6853" y="441"/>
                  </a:lnTo>
                  <a:lnTo>
                    <a:pt x="6853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76" name="Freeform 56"/>
            <p:cNvSpPr>
              <a:spLocks/>
            </p:cNvSpPr>
            <p:nvPr/>
          </p:nvSpPr>
          <p:spPr bwMode="auto">
            <a:xfrm>
              <a:off x="2693" y="4092"/>
              <a:ext cx="934" cy="71"/>
            </a:xfrm>
            <a:custGeom>
              <a:avLst/>
              <a:gdLst>
                <a:gd name="T0" fmla="*/ 0 w 7631"/>
                <a:gd name="T1" fmla="*/ 0 h 441"/>
                <a:gd name="T2" fmla="*/ 0 w 7631"/>
                <a:gd name="T3" fmla="*/ 220 h 441"/>
                <a:gd name="T4" fmla="*/ 0 w 7631"/>
                <a:gd name="T5" fmla="*/ 441 h 441"/>
                <a:gd name="T6" fmla="*/ 7631 w 7631"/>
                <a:gd name="T7" fmla="*/ 441 h 441"/>
                <a:gd name="T8" fmla="*/ 7631 w 7631"/>
                <a:gd name="T9" fmla="*/ 0 h 441"/>
                <a:gd name="T10" fmla="*/ 0 w 7631"/>
                <a:gd name="T11" fmla="*/ 0 h 4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7631" h="441">
                  <a:moveTo>
                    <a:pt x="0" y="0"/>
                  </a:moveTo>
                  <a:lnTo>
                    <a:pt x="0" y="220"/>
                  </a:lnTo>
                  <a:lnTo>
                    <a:pt x="0" y="441"/>
                  </a:lnTo>
                  <a:lnTo>
                    <a:pt x="7631" y="441"/>
                  </a:lnTo>
                  <a:lnTo>
                    <a:pt x="7631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77" name="Freeform 57"/>
            <p:cNvSpPr>
              <a:spLocks/>
            </p:cNvSpPr>
            <p:nvPr/>
          </p:nvSpPr>
          <p:spPr bwMode="auto">
            <a:xfrm>
              <a:off x="440" y="918"/>
              <a:ext cx="3187" cy="172"/>
            </a:xfrm>
            <a:custGeom>
              <a:avLst/>
              <a:gdLst>
                <a:gd name="T0" fmla="*/ 0 w 26044"/>
                <a:gd name="T1" fmla="*/ 0 h 1075"/>
                <a:gd name="T2" fmla="*/ 0 w 26044"/>
                <a:gd name="T3" fmla="*/ 537 h 1075"/>
                <a:gd name="T4" fmla="*/ 0 w 26044"/>
                <a:gd name="T5" fmla="*/ 1075 h 1075"/>
                <a:gd name="T6" fmla="*/ 586 w 26044"/>
                <a:gd name="T7" fmla="*/ 1075 h 1075"/>
                <a:gd name="T8" fmla="*/ 586 w 26044"/>
                <a:gd name="T9" fmla="*/ 441 h 1075"/>
                <a:gd name="T10" fmla="*/ 26044 w 26044"/>
                <a:gd name="T11" fmla="*/ 441 h 1075"/>
                <a:gd name="T12" fmla="*/ 26044 w 26044"/>
                <a:gd name="T13" fmla="*/ 0 h 1075"/>
                <a:gd name="T14" fmla="*/ 0 w 26044"/>
                <a:gd name="T15" fmla="*/ 0 h 10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6044" h="1075">
                  <a:moveTo>
                    <a:pt x="0" y="0"/>
                  </a:moveTo>
                  <a:lnTo>
                    <a:pt x="0" y="537"/>
                  </a:lnTo>
                  <a:lnTo>
                    <a:pt x="0" y="1075"/>
                  </a:lnTo>
                  <a:lnTo>
                    <a:pt x="586" y="1075"/>
                  </a:lnTo>
                  <a:lnTo>
                    <a:pt x="586" y="441"/>
                  </a:lnTo>
                  <a:lnTo>
                    <a:pt x="26044" y="441"/>
                  </a:lnTo>
                  <a:lnTo>
                    <a:pt x="26044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78" name="Freeform 58"/>
            <p:cNvSpPr>
              <a:spLocks/>
            </p:cNvSpPr>
            <p:nvPr/>
          </p:nvSpPr>
          <p:spPr bwMode="auto">
            <a:xfrm>
              <a:off x="493" y="460"/>
              <a:ext cx="3134" cy="353"/>
            </a:xfrm>
            <a:custGeom>
              <a:avLst/>
              <a:gdLst>
                <a:gd name="T0" fmla="*/ 0 w 25610"/>
                <a:gd name="T1" fmla="*/ 0 h 2205"/>
                <a:gd name="T2" fmla="*/ 0 w 25610"/>
                <a:gd name="T3" fmla="*/ 1102 h 2205"/>
                <a:gd name="T4" fmla="*/ 0 w 25610"/>
                <a:gd name="T5" fmla="*/ 2205 h 2205"/>
                <a:gd name="T6" fmla="*/ 25610 w 25610"/>
                <a:gd name="T7" fmla="*/ 2205 h 2205"/>
                <a:gd name="T8" fmla="*/ 25610 w 25610"/>
                <a:gd name="T9" fmla="*/ 0 h 2205"/>
                <a:gd name="T10" fmla="*/ 0 w 25610"/>
                <a:gd name="T11" fmla="*/ 0 h 22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5610" h="2205">
                  <a:moveTo>
                    <a:pt x="0" y="0"/>
                  </a:moveTo>
                  <a:lnTo>
                    <a:pt x="0" y="1102"/>
                  </a:lnTo>
                  <a:lnTo>
                    <a:pt x="0" y="2205"/>
                  </a:lnTo>
                  <a:lnTo>
                    <a:pt x="25610" y="2205"/>
                  </a:lnTo>
                  <a:lnTo>
                    <a:pt x="2561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79" name="Freeform 59"/>
            <p:cNvSpPr>
              <a:spLocks/>
            </p:cNvSpPr>
            <p:nvPr/>
          </p:nvSpPr>
          <p:spPr bwMode="auto">
            <a:xfrm>
              <a:off x="339" y="636"/>
              <a:ext cx="3288" cy="947"/>
            </a:xfrm>
            <a:custGeom>
              <a:avLst/>
              <a:gdLst>
                <a:gd name="T0" fmla="*/ 0 w 26867"/>
                <a:gd name="T1" fmla="*/ 0 h 5920"/>
                <a:gd name="T2" fmla="*/ 0 w 26867"/>
                <a:gd name="T3" fmla="*/ 2960 h 5920"/>
                <a:gd name="T4" fmla="*/ 0 w 26867"/>
                <a:gd name="T5" fmla="*/ 5920 h 5920"/>
                <a:gd name="T6" fmla="*/ 466 w 26867"/>
                <a:gd name="T7" fmla="*/ 5920 h 5920"/>
                <a:gd name="T8" fmla="*/ 466 w 26867"/>
                <a:gd name="T9" fmla="*/ 2301 h 5920"/>
                <a:gd name="T10" fmla="*/ 823 w 26867"/>
                <a:gd name="T11" fmla="*/ 2301 h 5920"/>
                <a:gd name="T12" fmla="*/ 823 w 26867"/>
                <a:gd name="T13" fmla="*/ 1764 h 5920"/>
                <a:gd name="T14" fmla="*/ 26867 w 26867"/>
                <a:gd name="T15" fmla="*/ 1764 h 5920"/>
                <a:gd name="T16" fmla="*/ 26867 w 26867"/>
                <a:gd name="T17" fmla="*/ 1103 h 5920"/>
                <a:gd name="T18" fmla="*/ 1257 w 26867"/>
                <a:gd name="T19" fmla="*/ 1103 h 5920"/>
                <a:gd name="T20" fmla="*/ 1257 w 26867"/>
                <a:gd name="T21" fmla="*/ 0 h 5920"/>
                <a:gd name="T22" fmla="*/ 0 w 26867"/>
                <a:gd name="T23" fmla="*/ 0 h 59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26867" h="5920">
                  <a:moveTo>
                    <a:pt x="0" y="0"/>
                  </a:moveTo>
                  <a:lnTo>
                    <a:pt x="0" y="2960"/>
                  </a:lnTo>
                  <a:lnTo>
                    <a:pt x="0" y="5920"/>
                  </a:lnTo>
                  <a:lnTo>
                    <a:pt x="466" y="5920"/>
                  </a:lnTo>
                  <a:lnTo>
                    <a:pt x="466" y="2301"/>
                  </a:lnTo>
                  <a:lnTo>
                    <a:pt x="823" y="2301"/>
                  </a:lnTo>
                  <a:lnTo>
                    <a:pt x="823" y="1764"/>
                  </a:lnTo>
                  <a:lnTo>
                    <a:pt x="26867" y="1764"/>
                  </a:lnTo>
                  <a:lnTo>
                    <a:pt x="26867" y="1103"/>
                  </a:lnTo>
                  <a:lnTo>
                    <a:pt x="1257" y="1103"/>
                  </a:lnTo>
                  <a:lnTo>
                    <a:pt x="1257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80" name="Freeform 60"/>
            <p:cNvSpPr>
              <a:spLocks/>
            </p:cNvSpPr>
            <p:nvPr/>
          </p:nvSpPr>
          <p:spPr bwMode="auto">
            <a:xfrm>
              <a:off x="2492" y="1483"/>
              <a:ext cx="1135" cy="123"/>
            </a:xfrm>
            <a:custGeom>
              <a:avLst/>
              <a:gdLst>
                <a:gd name="T0" fmla="*/ 0 w 9281"/>
                <a:gd name="T1" fmla="*/ 0 h 771"/>
                <a:gd name="T2" fmla="*/ 0 w 9281"/>
                <a:gd name="T3" fmla="*/ 385 h 771"/>
                <a:gd name="T4" fmla="*/ 0 w 9281"/>
                <a:gd name="T5" fmla="*/ 771 h 771"/>
                <a:gd name="T6" fmla="*/ 997 w 9281"/>
                <a:gd name="T7" fmla="*/ 771 h 771"/>
                <a:gd name="T8" fmla="*/ 997 w 9281"/>
                <a:gd name="T9" fmla="*/ 441 h 771"/>
                <a:gd name="T10" fmla="*/ 9281 w 9281"/>
                <a:gd name="T11" fmla="*/ 441 h 771"/>
                <a:gd name="T12" fmla="*/ 9281 w 9281"/>
                <a:gd name="T13" fmla="*/ 0 h 771"/>
                <a:gd name="T14" fmla="*/ 0 w 9281"/>
                <a:gd name="T15" fmla="*/ 0 h 7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9281" h="771">
                  <a:moveTo>
                    <a:pt x="0" y="0"/>
                  </a:moveTo>
                  <a:lnTo>
                    <a:pt x="0" y="385"/>
                  </a:lnTo>
                  <a:lnTo>
                    <a:pt x="0" y="771"/>
                  </a:lnTo>
                  <a:lnTo>
                    <a:pt x="997" y="771"/>
                  </a:lnTo>
                  <a:lnTo>
                    <a:pt x="997" y="441"/>
                  </a:lnTo>
                  <a:lnTo>
                    <a:pt x="9281" y="441"/>
                  </a:lnTo>
                  <a:lnTo>
                    <a:pt x="9281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81" name="Freeform 61"/>
            <p:cNvSpPr>
              <a:spLocks/>
            </p:cNvSpPr>
            <p:nvPr/>
          </p:nvSpPr>
          <p:spPr bwMode="auto">
            <a:xfrm>
              <a:off x="1190" y="1848"/>
              <a:ext cx="2437" cy="2198"/>
            </a:xfrm>
            <a:custGeom>
              <a:avLst/>
              <a:gdLst>
                <a:gd name="T0" fmla="*/ 0 w 19918"/>
                <a:gd name="T1" fmla="*/ 0 h 13744"/>
                <a:gd name="T2" fmla="*/ 0 w 19918"/>
                <a:gd name="T3" fmla="*/ 6872 h 13744"/>
                <a:gd name="T4" fmla="*/ 0 w 19918"/>
                <a:gd name="T5" fmla="*/ 13744 h 13744"/>
                <a:gd name="T6" fmla="*/ 395 w 19918"/>
                <a:gd name="T7" fmla="*/ 13744 h 13744"/>
                <a:gd name="T8" fmla="*/ 395 w 19918"/>
                <a:gd name="T9" fmla="*/ 10386 h 13744"/>
                <a:gd name="T10" fmla="*/ 2021 w 19918"/>
                <a:gd name="T11" fmla="*/ 10386 h 13744"/>
                <a:gd name="T12" fmla="*/ 2021 w 19918"/>
                <a:gd name="T13" fmla="*/ 9180 h 13744"/>
                <a:gd name="T14" fmla="*/ 19918 w 19918"/>
                <a:gd name="T15" fmla="*/ 9180 h 13744"/>
                <a:gd name="T16" fmla="*/ 19918 w 19918"/>
                <a:gd name="T17" fmla="*/ 6094 h 13744"/>
                <a:gd name="T18" fmla="*/ 13936 w 19918"/>
                <a:gd name="T19" fmla="*/ 6094 h 13744"/>
                <a:gd name="T20" fmla="*/ 13936 w 19918"/>
                <a:gd name="T21" fmla="*/ 4550 h 13744"/>
                <a:gd name="T22" fmla="*/ 13065 w 19918"/>
                <a:gd name="T23" fmla="*/ 4550 h 13744"/>
                <a:gd name="T24" fmla="*/ 13065 w 19918"/>
                <a:gd name="T25" fmla="*/ 3558 h 13744"/>
                <a:gd name="T26" fmla="*/ 11063 w 19918"/>
                <a:gd name="T27" fmla="*/ 3558 h 13744"/>
                <a:gd name="T28" fmla="*/ 11063 w 19918"/>
                <a:gd name="T29" fmla="*/ 2497 h 13744"/>
                <a:gd name="T30" fmla="*/ 10127 w 19918"/>
                <a:gd name="T31" fmla="*/ 2497 h 13744"/>
                <a:gd name="T32" fmla="*/ 10127 w 19918"/>
                <a:gd name="T33" fmla="*/ 1209 h 13744"/>
                <a:gd name="T34" fmla="*/ 8500 w 19918"/>
                <a:gd name="T35" fmla="*/ 1209 h 13744"/>
                <a:gd name="T36" fmla="*/ 8500 w 19918"/>
                <a:gd name="T37" fmla="*/ 0 h 13744"/>
                <a:gd name="T38" fmla="*/ 0 w 19918"/>
                <a:gd name="T39" fmla="*/ 0 h 137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19918" h="13744">
                  <a:moveTo>
                    <a:pt x="0" y="0"/>
                  </a:moveTo>
                  <a:lnTo>
                    <a:pt x="0" y="6872"/>
                  </a:lnTo>
                  <a:lnTo>
                    <a:pt x="0" y="13744"/>
                  </a:lnTo>
                  <a:lnTo>
                    <a:pt x="395" y="13744"/>
                  </a:lnTo>
                  <a:lnTo>
                    <a:pt x="395" y="10386"/>
                  </a:lnTo>
                  <a:lnTo>
                    <a:pt x="2021" y="10386"/>
                  </a:lnTo>
                  <a:lnTo>
                    <a:pt x="2021" y="9180"/>
                  </a:lnTo>
                  <a:lnTo>
                    <a:pt x="19918" y="9180"/>
                  </a:lnTo>
                  <a:lnTo>
                    <a:pt x="19918" y="6094"/>
                  </a:lnTo>
                  <a:lnTo>
                    <a:pt x="13936" y="6094"/>
                  </a:lnTo>
                  <a:lnTo>
                    <a:pt x="13936" y="4550"/>
                  </a:lnTo>
                  <a:lnTo>
                    <a:pt x="13065" y="4550"/>
                  </a:lnTo>
                  <a:lnTo>
                    <a:pt x="13065" y="3558"/>
                  </a:lnTo>
                  <a:lnTo>
                    <a:pt x="11063" y="3558"/>
                  </a:lnTo>
                  <a:lnTo>
                    <a:pt x="11063" y="2497"/>
                  </a:lnTo>
                  <a:lnTo>
                    <a:pt x="10127" y="2497"/>
                  </a:lnTo>
                  <a:lnTo>
                    <a:pt x="10127" y="1209"/>
                  </a:lnTo>
                  <a:lnTo>
                    <a:pt x="8500" y="1209"/>
                  </a:lnTo>
                  <a:lnTo>
                    <a:pt x="8500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sq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82" name="Freeform 62"/>
            <p:cNvSpPr>
              <a:spLocks/>
            </p:cNvSpPr>
            <p:nvPr/>
          </p:nvSpPr>
          <p:spPr bwMode="auto">
            <a:xfrm>
              <a:off x="674" y="213"/>
              <a:ext cx="53" cy="494"/>
            </a:xfrm>
            <a:custGeom>
              <a:avLst/>
              <a:gdLst>
                <a:gd name="T0" fmla="*/ 0 w 433"/>
                <a:gd name="T1" fmla="*/ 1544 h 3087"/>
                <a:gd name="T2" fmla="*/ 433 w 433"/>
                <a:gd name="T3" fmla="*/ 0 h 3087"/>
                <a:gd name="T4" fmla="*/ 433 w 433"/>
                <a:gd name="T5" fmla="*/ 3087 h 3087"/>
                <a:gd name="T6" fmla="*/ 0 w 433"/>
                <a:gd name="T7" fmla="*/ 1544 h 30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33" h="3087">
                  <a:moveTo>
                    <a:pt x="0" y="1544"/>
                  </a:moveTo>
                  <a:lnTo>
                    <a:pt x="433" y="0"/>
                  </a:lnTo>
                  <a:lnTo>
                    <a:pt x="433" y="3087"/>
                  </a:lnTo>
                  <a:lnTo>
                    <a:pt x="0" y="1544"/>
                  </a:ln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83" name="Freeform 63"/>
            <p:cNvSpPr>
              <a:spLocks/>
            </p:cNvSpPr>
            <p:nvPr/>
          </p:nvSpPr>
          <p:spPr bwMode="auto">
            <a:xfrm>
              <a:off x="2906" y="4374"/>
              <a:ext cx="53" cy="564"/>
            </a:xfrm>
            <a:custGeom>
              <a:avLst/>
              <a:gdLst>
                <a:gd name="T0" fmla="*/ 0 w 439"/>
                <a:gd name="T1" fmla="*/ 1763 h 3527"/>
                <a:gd name="T2" fmla="*/ 439 w 439"/>
                <a:gd name="T3" fmla="*/ 0 h 3527"/>
                <a:gd name="T4" fmla="*/ 439 w 439"/>
                <a:gd name="T5" fmla="*/ 3527 h 3527"/>
                <a:gd name="T6" fmla="*/ 0 w 439"/>
                <a:gd name="T7" fmla="*/ 1763 h 35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39" h="3527">
                  <a:moveTo>
                    <a:pt x="0" y="1763"/>
                  </a:moveTo>
                  <a:lnTo>
                    <a:pt x="439" y="0"/>
                  </a:lnTo>
                  <a:lnTo>
                    <a:pt x="439" y="3527"/>
                  </a:lnTo>
                  <a:lnTo>
                    <a:pt x="0" y="1763"/>
                  </a:ln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84" name="Freeform 64"/>
            <p:cNvSpPr>
              <a:spLocks/>
            </p:cNvSpPr>
            <p:nvPr/>
          </p:nvSpPr>
          <p:spPr bwMode="auto">
            <a:xfrm>
              <a:off x="776" y="777"/>
              <a:ext cx="9" cy="71"/>
            </a:xfrm>
            <a:custGeom>
              <a:avLst/>
              <a:gdLst>
                <a:gd name="T0" fmla="*/ 0 w 68"/>
                <a:gd name="T1" fmla="*/ 221 h 441"/>
                <a:gd name="T2" fmla="*/ 68 w 68"/>
                <a:gd name="T3" fmla="*/ 0 h 441"/>
                <a:gd name="T4" fmla="*/ 68 w 68"/>
                <a:gd name="T5" fmla="*/ 441 h 441"/>
                <a:gd name="T6" fmla="*/ 0 w 68"/>
                <a:gd name="T7" fmla="*/ 221 h 4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68" h="441">
                  <a:moveTo>
                    <a:pt x="0" y="221"/>
                  </a:moveTo>
                  <a:lnTo>
                    <a:pt x="68" y="0"/>
                  </a:lnTo>
                  <a:lnTo>
                    <a:pt x="68" y="441"/>
                  </a:lnTo>
                  <a:lnTo>
                    <a:pt x="0" y="221"/>
                  </a:ln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85" name="Freeform 65"/>
            <p:cNvSpPr>
              <a:spLocks/>
            </p:cNvSpPr>
            <p:nvPr/>
          </p:nvSpPr>
          <p:spPr bwMode="auto">
            <a:xfrm>
              <a:off x="3065" y="2399"/>
              <a:ext cx="49" cy="847"/>
            </a:xfrm>
            <a:custGeom>
              <a:avLst/>
              <a:gdLst>
                <a:gd name="T0" fmla="*/ 0 w 398"/>
                <a:gd name="T1" fmla="*/ 2646 h 5291"/>
                <a:gd name="T2" fmla="*/ 398 w 398"/>
                <a:gd name="T3" fmla="*/ 0 h 5291"/>
                <a:gd name="T4" fmla="*/ 398 w 398"/>
                <a:gd name="T5" fmla="*/ 5291 h 5291"/>
                <a:gd name="T6" fmla="*/ 0 w 398"/>
                <a:gd name="T7" fmla="*/ 2646 h 52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98" h="5291">
                  <a:moveTo>
                    <a:pt x="0" y="2646"/>
                  </a:moveTo>
                  <a:lnTo>
                    <a:pt x="398" y="0"/>
                  </a:lnTo>
                  <a:lnTo>
                    <a:pt x="398" y="5291"/>
                  </a:lnTo>
                  <a:lnTo>
                    <a:pt x="0" y="2646"/>
                  </a:ln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86" name="Freeform 66"/>
            <p:cNvSpPr>
              <a:spLocks/>
            </p:cNvSpPr>
            <p:nvPr/>
          </p:nvSpPr>
          <p:spPr bwMode="auto">
            <a:xfrm>
              <a:off x="2927" y="4233"/>
              <a:ext cx="291" cy="71"/>
            </a:xfrm>
            <a:custGeom>
              <a:avLst/>
              <a:gdLst>
                <a:gd name="T0" fmla="*/ 0 w 2378"/>
                <a:gd name="T1" fmla="*/ 220 h 441"/>
                <a:gd name="T2" fmla="*/ 2378 w 2378"/>
                <a:gd name="T3" fmla="*/ 0 h 441"/>
                <a:gd name="T4" fmla="*/ 2378 w 2378"/>
                <a:gd name="T5" fmla="*/ 441 h 441"/>
                <a:gd name="T6" fmla="*/ 0 w 2378"/>
                <a:gd name="T7" fmla="*/ 220 h 4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378" h="441">
                  <a:moveTo>
                    <a:pt x="0" y="220"/>
                  </a:moveTo>
                  <a:lnTo>
                    <a:pt x="2378" y="0"/>
                  </a:lnTo>
                  <a:lnTo>
                    <a:pt x="2378" y="441"/>
                  </a:lnTo>
                  <a:lnTo>
                    <a:pt x="0" y="220"/>
                  </a:lnTo>
                  <a:close/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87" name="Freeform 67"/>
            <p:cNvSpPr>
              <a:spLocks/>
            </p:cNvSpPr>
            <p:nvPr/>
          </p:nvSpPr>
          <p:spPr bwMode="auto">
            <a:xfrm>
              <a:off x="2693" y="4092"/>
              <a:ext cx="178" cy="35"/>
            </a:xfrm>
            <a:custGeom>
              <a:avLst/>
              <a:gdLst>
                <a:gd name="T0" fmla="*/ 1454 w 1454"/>
                <a:gd name="T1" fmla="*/ 0 h 220"/>
                <a:gd name="T2" fmla="*/ 0 w 1454"/>
                <a:gd name="T3" fmla="*/ 0 h 220"/>
                <a:gd name="T4" fmla="*/ 0 w 1454"/>
                <a:gd name="T5" fmla="*/ 220 h 2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54" h="220">
                  <a:moveTo>
                    <a:pt x="1454" y="0"/>
                  </a:moveTo>
                  <a:lnTo>
                    <a:pt x="0" y="0"/>
                  </a:lnTo>
                  <a:lnTo>
                    <a:pt x="0" y="22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88" name="Freeform 68"/>
            <p:cNvSpPr>
              <a:spLocks/>
            </p:cNvSpPr>
            <p:nvPr/>
          </p:nvSpPr>
          <p:spPr bwMode="auto">
            <a:xfrm>
              <a:off x="2492" y="1483"/>
              <a:ext cx="326" cy="61"/>
            </a:xfrm>
            <a:custGeom>
              <a:avLst/>
              <a:gdLst>
                <a:gd name="T0" fmla="*/ 2667 w 2667"/>
                <a:gd name="T1" fmla="*/ 0 h 385"/>
                <a:gd name="T2" fmla="*/ 0 w 2667"/>
                <a:gd name="T3" fmla="*/ 0 h 385"/>
                <a:gd name="T4" fmla="*/ 0 w 2667"/>
                <a:gd name="T5" fmla="*/ 385 h 3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67" h="385">
                  <a:moveTo>
                    <a:pt x="2667" y="0"/>
                  </a:moveTo>
                  <a:lnTo>
                    <a:pt x="0" y="0"/>
                  </a:lnTo>
                  <a:lnTo>
                    <a:pt x="0" y="385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89" name="Freeform 69"/>
            <p:cNvSpPr>
              <a:spLocks/>
            </p:cNvSpPr>
            <p:nvPr/>
          </p:nvSpPr>
          <p:spPr bwMode="auto">
            <a:xfrm>
              <a:off x="2624" y="5644"/>
              <a:ext cx="214" cy="35"/>
            </a:xfrm>
            <a:custGeom>
              <a:avLst/>
              <a:gdLst>
                <a:gd name="T0" fmla="*/ 1751 w 1751"/>
                <a:gd name="T1" fmla="*/ 0 h 220"/>
                <a:gd name="T2" fmla="*/ 0 w 1751"/>
                <a:gd name="T3" fmla="*/ 0 h 220"/>
                <a:gd name="T4" fmla="*/ 0 w 1751"/>
                <a:gd name="T5" fmla="*/ 220 h 2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51" h="220">
                  <a:moveTo>
                    <a:pt x="1751" y="0"/>
                  </a:moveTo>
                  <a:lnTo>
                    <a:pt x="0" y="0"/>
                  </a:lnTo>
                  <a:lnTo>
                    <a:pt x="0" y="22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90" name="Freeform 70"/>
            <p:cNvSpPr>
              <a:spLocks/>
            </p:cNvSpPr>
            <p:nvPr/>
          </p:nvSpPr>
          <p:spPr bwMode="auto">
            <a:xfrm>
              <a:off x="802" y="1342"/>
              <a:ext cx="221" cy="35"/>
            </a:xfrm>
            <a:custGeom>
              <a:avLst/>
              <a:gdLst>
                <a:gd name="T0" fmla="*/ 1807 w 1807"/>
                <a:gd name="T1" fmla="*/ 0 h 220"/>
                <a:gd name="T2" fmla="*/ 0 w 1807"/>
                <a:gd name="T3" fmla="*/ 0 h 220"/>
                <a:gd name="T4" fmla="*/ 0 w 1807"/>
                <a:gd name="T5" fmla="*/ 220 h 2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07" h="220">
                  <a:moveTo>
                    <a:pt x="1807" y="0"/>
                  </a:moveTo>
                  <a:lnTo>
                    <a:pt x="0" y="0"/>
                  </a:lnTo>
                  <a:lnTo>
                    <a:pt x="0" y="22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91" name="Freeform 71"/>
            <p:cNvSpPr>
              <a:spLocks/>
            </p:cNvSpPr>
            <p:nvPr/>
          </p:nvSpPr>
          <p:spPr bwMode="auto">
            <a:xfrm>
              <a:off x="1906" y="3387"/>
              <a:ext cx="345" cy="35"/>
            </a:xfrm>
            <a:custGeom>
              <a:avLst/>
              <a:gdLst>
                <a:gd name="T0" fmla="*/ 2821 w 2821"/>
                <a:gd name="T1" fmla="*/ 0 h 221"/>
                <a:gd name="T2" fmla="*/ 0 w 2821"/>
                <a:gd name="T3" fmla="*/ 0 h 221"/>
                <a:gd name="T4" fmla="*/ 0 w 2821"/>
                <a:gd name="T5" fmla="*/ 221 h 2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21" h="221">
                  <a:moveTo>
                    <a:pt x="2821" y="0"/>
                  </a:moveTo>
                  <a:lnTo>
                    <a:pt x="0" y="0"/>
                  </a:lnTo>
                  <a:lnTo>
                    <a:pt x="0" y="221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92" name="Freeform 72"/>
            <p:cNvSpPr>
              <a:spLocks/>
            </p:cNvSpPr>
            <p:nvPr/>
          </p:nvSpPr>
          <p:spPr bwMode="auto">
            <a:xfrm>
              <a:off x="2346" y="3651"/>
              <a:ext cx="0" cy="53"/>
            </a:xfrm>
            <a:custGeom>
              <a:avLst/>
              <a:gdLst>
                <a:gd name="T0" fmla="*/ 331 h 331"/>
                <a:gd name="T1" fmla="*/ 331 h 331"/>
                <a:gd name="T2" fmla="*/ 0 h 33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31">
                  <a:moveTo>
                    <a:pt x="0" y="331"/>
                  </a:moveTo>
                  <a:lnTo>
                    <a:pt x="0" y="331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93" name="Freeform 73"/>
            <p:cNvSpPr>
              <a:spLocks/>
            </p:cNvSpPr>
            <p:nvPr/>
          </p:nvSpPr>
          <p:spPr bwMode="auto">
            <a:xfrm>
              <a:off x="1972" y="5566"/>
              <a:ext cx="84" cy="135"/>
            </a:xfrm>
            <a:custGeom>
              <a:avLst/>
              <a:gdLst>
                <a:gd name="T0" fmla="*/ 690 w 690"/>
                <a:gd name="T1" fmla="*/ 841 h 841"/>
                <a:gd name="T2" fmla="*/ 0 w 690"/>
                <a:gd name="T3" fmla="*/ 841 h 841"/>
                <a:gd name="T4" fmla="*/ 0 w 690"/>
                <a:gd name="T5" fmla="*/ 0 h 8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90" h="841">
                  <a:moveTo>
                    <a:pt x="690" y="841"/>
                  </a:moveTo>
                  <a:lnTo>
                    <a:pt x="0" y="841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94" name="Freeform 74"/>
            <p:cNvSpPr>
              <a:spLocks/>
            </p:cNvSpPr>
            <p:nvPr/>
          </p:nvSpPr>
          <p:spPr bwMode="auto">
            <a:xfrm>
              <a:off x="2230" y="1848"/>
              <a:ext cx="199" cy="193"/>
            </a:xfrm>
            <a:custGeom>
              <a:avLst/>
              <a:gdLst>
                <a:gd name="T0" fmla="*/ 1627 w 1627"/>
                <a:gd name="T1" fmla="*/ 1209 h 1209"/>
                <a:gd name="T2" fmla="*/ 0 w 1627"/>
                <a:gd name="T3" fmla="*/ 1209 h 1209"/>
                <a:gd name="T4" fmla="*/ 0 w 1627"/>
                <a:gd name="T5" fmla="*/ 0 h 12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27" h="1209">
                  <a:moveTo>
                    <a:pt x="1627" y="1209"/>
                  </a:moveTo>
                  <a:lnTo>
                    <a:pt x="0" y="1209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95" name="Freeform 75"/>
            <p:cNvSpPr>
              <a:spLocks/>
            </p:cNvSpPr>
            <p:nvPr/>
          </p:nvSpPr>
          <p:spPr bwMode="auto">
            <a:xfrm>
              <a:off x="2575" y="5626"/>
              <a:ext cx="49" cy="53"/>
            </a:xfrm>
            <a:custGeom>
              <a:avLst/>
              <a:gdLst>
                <a:gd name="T0" fmla="*/ 397 w 397"/>
                <a:gd name="T1" fmla="*/ 330 h 330"/>
                <a:gd name="T2" fmla="*/ 0 w 397"/>
                <a:gd name="T3" fmla="*/ 330 h 330"/>
                <a:gd name="T4" fmla="*/ 0 w 397"/>
                <a:gd name="T5" fmla="*/ 0 h 3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7" h="330">
                  <a:moveTo>
                    <a:pt x="397" y="330"/>
                  </a:moveTo>
                  <a:lnTo>
                    <a:pt x="0" y="330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96" name="Freeform 76"/>
            <p:cNvSpPr>
              <a:spLocks/>
            </p:cNvSpPr>
            <p:nvPr/>
          </p:nvSpPr>
          <p:spPr bwMode="auto">
            <a:xfrm>
              <a:off x="493" y="636"/>
              <a:ext cx="283" cy="177"/>
            </a:xfrm>
            <a:custGeom>
              <a:avLst/>
              <a:gdLst>
                <a:gd name="T0" fmla="*/ 2313 w 2313"/>
                <a:gd name="T1" fmla="*/ 1103 h 1103"/>
                <a:gd name="T2" fmla="*/ 0 w 2313"/>
                <a:gd name="T3" fmla="*/ 1103 h 1103"/>
                <a:gd name="T4" fmla="*/ 0 w 2313"/>
                <a:gd name="T5" fmla="*/ 0 h 11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13" h="1103">
                  <a:moveTo>
                    <a:pt x="2313" y="1103"/>
                  </a:moveTo>
                  <a:lnTo>
                    <a:pt x="0" y="1103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97" name="Freeform 77"/>
            <p:cNvSpPr>
              <a:spLocks/>
            </p:cNvSpPr>
            <p:nvPr/>
          </p:nvSpPr>
          <p:spPr bwMode="auto">
            <a:xfrm>
              <a:off x="512" y="1090"/>
              <a:ext cx="83" cy="102"/>
            </a:xfrm>
            <a:custGeom>
              <a:avLst/>
              <a:gdLst>
                <a:gd name="T0" fmla="*/ 676 w 676"/>
                <a:gd name="T1" fmla="*/ 634 h 634"/>
                <a:gd name="T2" fmla="*/ 0 w 676"/>
                <a:gd name="T3" fmla="*/ 634 h 634"/>
                <a:gd name="T4" fmla="*/ 0 w 676"/>
                <a:gd name="T5" fmla="*/ 0 h 6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76" h="634">
                  <a:moveTo>
                    <a:pt x="676" y="634"/>
                  </a:moveTo>
                  <a:lnTo>
                    <a:pt x="0" y="634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98" name="Freeform 78"/>
            <p:cNvSpPr>
              <a:spLocks/>
            </p:cNvSpPr>
            <p:nvPr/>
          </p:nvSpPr>
          <p:spPr bwMode="auto">
            <a:xfrm>
              <a:off x="802" y="1377"/>
              <a:ext cx="295" cy="35"/>
            </a:xfrm>
            <a:custGeom>
              <a:avLst/>
              <a:gdLst>
                <a:gd name="T0" fmla="*/ 2410 w 2410"/>
                <a:gd name="T1" fmla="*/ 221 h 221"/>
                <a:gd name="T2" fmla="*/ 0 w 2410"/>
                <a:gd name="T3" fmla="*/ 221 h 221"/>
                <a:gd name="T4" fmla="*/ 0 w 2410"/>
                <a:gd name="T5" fmla="*/ 0 h 2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10" h="221">
                  <a:moveTo>
                    <a:pt x="2410" y="221"/>
                  </a:moveTo>
                  <a:lnTo>
                    <a:pt x="0" y="221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99" name="Freeform 79"/>
            <p:cNvSpPr>
              <a:spLocks/>
            </p:cNvSpPr>
            <p:nvPr/>
          </p:nvSpPr>
          <p:spPr bwMode="auto">
            <a:xfrm>
              <a:off x="2346" y="3704"/>
              <a:ext cx="0" cy="35"/>
            </a:xfrm>
            <a:custGeom>
              <a:avLst/>
              <a:gdLst>
                <a:gd name="T0" fmla="*/ 220 h 220"/>
                <a:gd name="T1" fmla="*/ 220 h 220"/>
                <a:gd name="T2" fmla="*/ 0 h 22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20">
                  <a:moveTo>
                    <a:pt x="0" y="220"/>
                  </a:moveTo>
                  <a:lnTo>
                    <a:pt x="0" y="220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00" name="Freeform 80"/>
            <p:cNvSpPr>
              <a:spLocks/>
            </p:cNvSpPr>
            <p:nvPr/>
          </p:nvSpPr>
          <p:spPr bwMode="auto">
            <a:xfrm>
              <a:off x="2056" y="5701"/>
              <a:ext cx="106" cy="136"/>
            </a:xfrm>
            <a:custGeom>
              <a:avLst/>
              <a:gdLst>
                <a:gd name="T0" fmla="*/ 861 w 861"/>
                <a:gd name="T1" fmla="*/ 854 h 854"/>
                <a:gd name="T2" fmla="*/ 0 w 861"/>
                <a:gd name="T3" fmla="*/ 854 h 854"/>
                <a:gd name="T4" fmla="*/ 0 w 861"/>
                <a:gd name="T5" fmla="*/ 0 h 8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61" h="854">
                  <a:moveTo>
                    <a:pt x="861" y="854"/>
                  </a:moveTo>
                  <a:lnTo>
                    <a:pt x="0" y="854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01" name="Freeform 81"/>
            <p:cNvSpPr>
              <a:spLocks/>
            </p:cNvSpPr>
            <p:nvPr/>
          </p:nvSpPr>
          <p:spPr bwMode="auto">
            <a:xfrm>
              <a:off x="1640" y="3845"/>
              <a:ext cx="49" cy="53"/>
            </a:xfrm>
            <a:custGeom>
              <a:avLst/>
              <a:gdLst>
                <a:gd name="T0" fmla="*/ 398 w 398"/>
                <a:gd name="T1" fmla="*/ 0 h 330"/>
                <a:gd name="T2" fmla="*/ 0 w 398"/>
                <a:gd name="T3" fmla="*/ 0 h 330"/>
                <a:gd name="T4" fmla="*/ 0 w 398"/>
                <a:gd name="T5" fmla="*/ 330 h 3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8" h="330">
                  <a:moveTo>
                    <a:pt x="398" y="0"/>
                  </a:moveTo>
                  <a:lnTo>
                    <a:pt x="0" y="0"/>
                  </a:lnTo>
                  <a:lnTo>
                    <a:pt x="0" y="33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02" name="Freeform 82"/>
            <p:cNvSpPr>
              <a:spLocks/>
            </p:cNvSpPr>
            <p:nvPr/>
          </p:nvSpPr>
          <p:spPr bwMode="auto">
            <a:xfrm>
              <a:off x="2614" y="1553"/>
              <a:ext cx="276" cy="53"/>
            </a:xfrm>
            <a:custGeom>
              <a:avLst/>
              <a:gdLst>
                <a:gd name="T0" fmla="*/ 2255 w 2255"/>
                <a:gd name="T1" fmla="*/ 0 h 330"/>
                <a:gd name="T2" fmla="*/ 0 w 2255"/>
                <a:gd name="T3" fmla="*/ 0 h 330"/>
                <a:gd name="T4" fmla="*/ 0 w 2255"/>
                <a:gd name="T5" fmla="*/ 330 h 3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55" h="330">
                  <a:moveTo>
                    <a:pt x="2255" y="0"/>
                  </a:moveTo>
                  <a:lnTo>
                    <a:pt x="0" y="0"/>
                  </a:lnTo>
                  <a:lnTo>
                    <a:pt x="0" y="33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03" name="Freeform 83"/>
            <p:cNvSpPr>
              <a:spLocks/>
            </p:cNvSpPr>
            <p:nvPr/>
          </p:nvSpPr>
          <p:spPr bwMode="auto">
            <a:xfrm>
              <a:off x="2895" y="2329"/>
              <a:ext cx="275" cy="247"/>
            </a:xfrm>
            <a:custGeom>
              <a:avLst/>
              <a:gdLst>
                <a:gd name="T0" fmla="*/ 2245 w 2245"/>
                <a:gd name="T1" fmla="*/ 0 h 1543"/>
                <a:gd name="T2" fmla="*/ 0 w 2245"/>
                <a:gd name="T3" fmla="*/ 0 h 1543"/>
                <a:gd name="T4" fmla="*/ 0 w 2245"/>
                <a:gd name="T5" fmla="*/ 1543 h 15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45" h="1543">
                  <a:moveTo>
                    <a:pt x="2245" y="0"/>
                  </a:moveTo>
                  <a:lnTo>
                    <a:pt x="0" y="0"/>
                  </a:lnTo>
                  <a:lnTo>
                    <a:pt x="0" y="1543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04" name="Freeform 84"/>
            <p:cNvSpPr>
              <a:spLocks/>
            </p:cNvSpPr>
            <p:nvPr/>
          </p:nvSpPr>
          <p:spPr bwMode="auto">
            <a:xfrm>
              <a:off x="2456" y="4295"/>
              <a:ext cx="87" cy="428"/>
            </a:xfrm>
            <a:custGeom>
              <a:avLst/>
              <a:gdLst>
                <a:gd name="T0" fmla="*/ 714 w 714"/>
                <a:gd name="T1" fmla="*/ 0 h 2680"/>
                <a:gd name="T2" fmla="*/ 0 w 714"/>
                <a:gd name="T3" fmla="*/ 0 h 2680"/>
                <a:gd name="T4" fmla="*/ 0 w 714"/>
                <a:gd name="T5" fmla="*/ 2680 h 26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14" h="2680">
                  <a:moveTo>
                    <a:pt x="714" y="0"/>
                  </a:moveTo>
                  <a:lnTo>
                    <a:pt x="0" y="0"/>
                  </a:lnTo>
                  <a:lnTo>
                    <a:pt x="0" y="268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05" name="Freeform 85"/>
            <p:cNvSpPr>
              <a:spLocks/>
            </p:cNvSpPr>
            <p:nvPr/>
          </p:nvSpPr>
          <p:spPr bwMode="auto">
            <a:xfrm>
              <a:off x="2789" y="2417"/>
              <a:ext cx="106" cy="159"/>
            </a:xfrm>
            <a:custGeom>
              <a:avLst/>
              <a:gdLst>
                <a:gd name="T0" fmla="*/ 871 w 871"/>
                <a:gd name="T1" fmla="*/ 992 h 992"/>
                <a:gd name="T2" fmla="*/ 0 w 871"/>
                <a:gd name="T3" fmla="*/ 992 h 992"/>
                <a:gd name="T4" fmla="*/ 0 w 871"/>
                <a:gd name="T5" fmla="*/ 0 h 9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71" h="992">
                  <a:moveTo>
                    <a:pt x="871" y="992"/>
                  </a:moveTo>
                  <a:lnTo>
                    <a:pt x="0" y="992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06" name="Freeform 86"/>
            <p:cNvSpPr>
              <a:spLocks/>
            </p:cNvSpPr>
            <p:nvPr/>
          </p:nvSpPr>
          <p:spPr bwMode="auto">
            <a:xfrm>
              <a:off x="1614" y="5145"/>
              <a:ext cx="358" cy="421"/>
            </a:xfrm>
            <a:custGeom>
              <a:avLst/>
              <a:gdLst>
                <a:gd name="T0" fmla="*/ 2929 w 2929"/>
                <a:gd name="T1" fmla="*/ 2635 h 2635"/>
                <a:gd name="T2" fmla="*/ 0 w 2929"/>
                <a:gd name="T3" fmla="*/ 2635 h 2635"/>
                <a:gd name="T4" fmla="*/ 0 w 2929"/>
                <a:gd name="T5" fmla="*/ 0 h 26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29" h="2635">
                  <a:moveTo>
                    <a:pt x="2929" y="2635"/>
                  </a:moveTo>
                  <a:lnTo>
                    <a:pt x="0" y="2635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07" name="Freeform 87"/>
            <p:cNvSpPr>
              <a:spLocks/>
            </p:cNvSpPr>
            <p:nvPr/>
          </p:nvSpPr>
          <p:spPr bwMode="auto">
            <a:xfrm>
              <a:off x="499" y="1377"/>
              <a:ext cx="303" cy="785"/>
            </a:xfrm>
            <a:custGeom>
              <a:avLst/>
              <a:gdLst>
                <a:gd name="T0" fmla="*/ 2475 w 2475"/>
                <a:gd name="T1" fmla="*/ 0 h 4909"/>
                <a:gd name="T2" fmla="*/ 0 w 2475"/>
                <a:gd name="T3" fmla="*/ 0 h 4909"/>
                <a:gd name="T4" fmla="*/ 0 w 2475"/>
                <a:gd name="T5" fmla="*/ 4909 h 49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75" h="4909">
                  <a:moveTo>
                    <a:pt x="2475" y="0"/>
                  </a:moveTo>
                  <a:lnTo>
                    <a:pt x="0" y="0"/>
                  </a:lnTo>
                  <a:lnTo>
                    <a:pt x="0" y="4909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08" name="Freeform 88"/>
            <p:cNvSpPr>
              <a:spLocks/>
            </p:cNvSpPr>
            <p:nvPr/>
          </p:nvSpPr>
          <p:spPr bwMode="auto">
            <a:xfrm>
              <a:off x="1190" y="2947"/>
              <a:ext cx="48" cy="1099"/>
            </a:xfrm>
            <a:custGeom>
              <a:avLst/>
              <a:gdLst>
                <a:gd name="T0" fmla="*/ 395 w 395"/>
                <a:gd name="T1" fmla="*/ 6872 h 6872"/>
                <a:gd name="T2" fmla="*/ 0 w 395"/>
                <a:gd name="T3" fmla="*/ 6872 h 6872"/>
                <a:gd name="T4" fmla="*/ 0 w 395"/>
                <a:gd name="T5" fmla="*/ 0 h 68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5" h="6872">
                  <a:moveTo>
                    <a:pt x="395" y="6872"/>
                  </a:moveTo>
                  <a:lnTo>
                    <a:pt x="0" y="6872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09" name="Freeform 89"/>
            <p:cNvSpPr>
              <a:spLocks/>
            </p:cNvSpPr>
            <p:nvPr/>
          </p:nvSpPr>
          <p:spPr bwMode="auto">
            <a:xfrm>
              <a:off x="2544" y="5295"/>
              <a:ext cx="377" cy="66"/>
            </a:xfrm>
            <a:custGeom>
              <a:avLst/>
              <a:gdLst>
                <a:gd name="T0" fmla="*/ 3085 w 3085"/>
                <a:gd name="T1" fmla="*/ 413 h 413"/>
                <a:gd name="T2" fmla="*/ 0 w 3085"/>
                <a:gd name="T3" fmla="*/ 413 h 413"/>
                <a:gd name="T4" fmla="*/ 0 w 3085"/>
                <a:gd name="T5" fmla="*/ 0 h 4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85" h="413">
                  <a:moveTo>
                    <a:pt x="3085" y="413"/>
                  </a:moveTo>
                  <a:lnTo>
                    <a:pt x="0" y="413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10" name="Freeform 90"/>
            <p:cNvSpPr>
              <a:spLocks/>
            </p:cNvSpPr>
            <p:nvPr/>
          </p:nvSpPr>
          <p:spPr bwMode="auto">
            <a:xfrm>
              <a:off x="2230" y="1654"/>
              <a:ext cx="65" cy="194"/>
            </a:xfrm>
            <a:custGeom>
              <a:avLst/>
              <a:gdLst>
                <a:gd name="T0" fmla="*/ 529 w 529"/>
                <a:gd name="T1" fmla="*/ 0 h 1210"/>
                <a:gd name="T2" fmla="*/ 0 w 529"/>
                <a:gd name="T3" fmla="*/ 0 h 1210"/>
                <a:gd name="T4" fmla="*/ 0 w 529"/>
                <a:gd name="T5" fmla="*/ 1210 h 12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29" h="1210">
                  <a:moveTo>
                    <a:pt x="529" y="0"/>
                  </a:moveTo>
                  <a:lnTo>
                    <a:pt x="0" y="0"/>
                  </a:lnTo>
                  <a:lnTo>
                    <a:pt x="0" y="121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11" name="Freeform 91"/>
            <p:cNvSpPr>
              <a:spLocks/>
            </p:cNvSpPr>
            <p:nvPr/>
          </p:nvSpPr>
          <p:spPr bwMode="auto">
            <a:xfrm>
              <a:off x="2796" y="2029"/>
              <a:ext cx="92" cy="53"/>
            </a:xfrm>
            <a:custGeom>
              <a:avLst/>
              <a:gdLst>
                <a:gd name="T0" fmla="*/ 757 w 757"/>
                <a:gd name="T1" fmla="*/ 331 h 331"/>
                <a:gd name="T2" fmla="*/ 0 w 757"/>
                <a:gd name="T3" fmla="*/ 331 h 331"/>
                <a:gd name="T4" fmla="*/ 0 w 757"/>
                <a:gd name="T5" fmla="*/ 0 h 3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57" h="331">
                  <a:moveTo>
                    <a:pt x="757" y="331"/>
                  </a:moveTo>
                  <a:lnTo>
                    <a:pt x="0" y="331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12" name="Freeform 92"/>
            <p:cNvSpPr>
              <a:spLocks/>
            </p:cNvSpPr>
            <p:nvPr/>
          </p:nvSpPr>
          <p:spPr bwMode="auto">
            <a:xfrm>
              <a:off x="1799" y="3528"/>
              <a:ext cx="336" cy="61"/>
            </a:xfrm>
            <a:custGeom>
              <a:avLst/>
              <a:gdLst>
                <a:gd name="T0" fmla="*/ 2749 w 2749"/>
                <a:gd name="T1" fmla="*/ 0 h 386"/>
                <a:gd name="T2" fmla="*/ 0 w 2749"/>
                <a:gd name="T3" fmla="*/ 0 h 386"/>
                <a:gd name="T4" fmla="*/ 0 w 2749"/>
                <a:gd name="T5" fmla="*/ 386 h 3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49" h="386">
                  <a:moveTo>
                    <a:pt x="2749" y="0"/>
                  </a:moveTo>
                  <a:lnTo>
                    <a:pt x="0" y="0"/>
                  </a:lnTo>
                  <a:lnTo>
                    <a:pt x="0" y="386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13" name="Freeform 93"/>
            <p:cNvSpPr>
              <a:spLocks/>
            </p:cNvSpPr>
            <p:nvPr/>
          </p:nvSpPr>
          <p:spPr bwMode="auto">
            <a:xfrm>
              <a:off x="2888" y="2047"/>
              <a:ext cx="206" cy="35"/>
            </a:xfrm>
            <a:custGeom>
              <a:avLst/>
              <a:gdLst>
                <a:gd name="T0" fmla="*/ 1677 w 1677"/>
                <a:gd name="T1" fmla="*/ 0 h 221"/>
                <a:gd name="T2" fmla="*/ 0 w 1677"/>
                <a:gd name="T3" fmla="*/ 0 h 221"/>
                <a:gd name="T4" fmla="*/ 0 w 1677"/>
                <a:gd name="T5" fmla="*/ 221 h 2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77" h="221">
                  <a:moveTo>
                    <a:pt x="1677" y="0"/>
                  </a:moveTo>
                  <a:lnTo>
                    <a:pt x="0" y="0"/>
                  </a:lnTo>
                  <a:lnTo>
                    <a:pt x="0" y="221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14" name="Freeform 94"/>
            <p:cNvSpPr>
              <a:spLocks/>
            </p:cNvSpPr>
            <p:nvPr/>
          </p:nvSpPr>
          <p:spPr bwMode="auto">
            <a:xfrm>
              <a:off x="705" y="1130"/>
              <a:ext cx="256" cy="35"/>
            </a:xfrm>
            <a:custGeom>
              <a:avLst/>
              <a:gdLst>
                <a:gd name="T0" fmla="*/ 2093 w 2093"/>
                <a:gd name="T1" fmla="*/ 0 h 220"/>
                <a:gd name="T2" fmla="*/ 0 w 2093"/>
                <a:gd name="T3" fmla="*/ 0 h 220"/>
                <a:gd name="T4" fmla="*/ 0 w 2093"/>
                <a:gd name="T5" fmla="*/ 220 h 2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93" h="220">
                  <a:moveTo>
                    <a:pt x="2093" y="0"/>
                  </a:moveTo>
                  <a:lnTo>
                    <a:pt x="0" y="0"/>
                  </a:lnTo>
                  <a:lnTo>
                    <a:pt x="0" y="22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15" name="Freeform 95"/>
            <p:cNvSpPr>
              <a:spLocks/>
            </p:cNvSpPr>
            <p:nvPr/>
          </p:nvSpPr>
          <p:spPr bwMode="auto">
            <a:xfrm>
              <a:off x="705" y="1165"/>
              <a:ext cx="333" cy="35"/>
            </a:xfrm>
            <a:custGeom>
              <a:avLst/>
              <a:gdLst>
                <a:gd name="T0" fmla="*/ 2721 w 2721"/>
                <a:gd name="T1" fmla="*/ 221 h 221"/>
                <a:gd name="T2" fmla="*/ 0 w 2721"/>
                <a:gd name="T3" fmla="*/ 221 h 221"/>
                <a:gd name="T4" fmla="*/ 0 w 2721"/>
                <a:gd name="T5" fmla="*/ 0 h 2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21" h="221">
                  <a:moveTo>
                    <a:pt x="2721" y="221"/>
                  </a:moveTo>
                  <a:lnTo>
                    <a:pt x="0" y="221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16" name="Freeform 96"/>
            <p:cNvSpPr>
              <a:spLocks/>
            </p:cNvSpPr>
            <p:nvPr/>
          </p:nvSpPr>
          <p:spPr bwMode="auto">
            <a:xfrm>
              <a:off x="2693" y="4127"/>
              <a:ext cx="141" cy="36"/>
            </a:xfrm>
            <a:custGeom>
              <a:avLst/>
              <a:gdLst>
                <a:gd name="T0" fmla="*/ 1151 w 1151"/>
                <a:gd name="T1" fmla="*/ 221 h 221"/>
                <a:gd name="T2" fmla="*/ 0 w 1151"/>
                <a:gd name="T3" fmla="*/ 221 h 221"/>
                <a:gd name="T4" fmla="*/ 0 w 1151"/>
                <a:gd name="T5" fmla="*/ 0 h 2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51" h="221">
                  <a:moveTo>
                    <a:pt x="1151" y="221"/>
                  </a:moveTo>
                  <a:lnTo>
                    <a:pt x="0" y="221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17" name="Freeform 97"/>
            <p:cNvSpPr>
              <a:spLocks/>
            </p:cNvSpPr>
            <p:nvPr/>
          </p:nvSpPr>
          <p:spPr bwMode="auto">
            <a:xfrm>
              <a:off x="2056" y="5564"/>
              <a:ext cx="119" cy="137"/>
            </a:xfrm>
            <a:custGeom>
              <a:avLst/>
              <a:gdLst>
                <a:gd name="T0" fmla="*/ 971 w 971"/>
                <a:gd name="T1" fmla="*/ 0 h 854"/>
                <a:gd name="T2" fmla="*/ 0 w 971"/>
                <a:gd name="T3" fmla="*/ 0 h 854"/>
                <a:gd name="T4" fmla="*/ 0 w 971"/>
                <a:gd name="T5" fmla="*/ 854 h 8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71" h="854">
                  <a:moveTo>
                    <a:pt x="971" y="0"/>
                  </a:moveTo>
                  <a:lnTo>
                    <a:pt x="0" y="0"/>
                  </a:lnTo>
                  <a:lnTo>
                    <a:pt x="0" y="854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18" name="Freeform 98"/>
            <p:cNvSpPr>
              <a:spLocks/>
            </p:cNvSpPr>
            <p:nvPr/>
          </p:nvSpPr>
          <p:spPr bwMode="auto">
            <a:xfrm>
              <a:off x="2295" y="1654"/>
              <a:ext cx="417" cy="111"/>
            </a:xfrm>
            <a:custGeom>
              <a:avLst/>
              <a:gdLst>
                <a:gd name="T0" fmla="*/ 3407 w 3407"/>
                <a:gd name="T1" fmla="*/ 689 h 689"/>
                <a:gd name="T2" fmla="*/ 0 w 3407"/>
                <a:gd name="T3" fmla="*/ 689 h 689"/>
                <a:gd name="T4" fmla="*/ 0 w 3407"/>
                <a:gd name="T5" fmla="*/ 0 h 6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07" h="689">
                  <a:moveTo>
                    <a:pt x="3407" y="689"/>
                  </a:moveTo>
                  <a:lnTo>
                    <a:pt x="0" y="689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19" name="Freeform 99"/>
            <p:cNvSpPr>
              <a:spLocks/>
            </p:cNvSpPr>
            <p:nvPr/>
          </p:nvSpPr>
          <p:spPr bwMode="auto">
            <a:xfrm>
              <a:off x="1799" y="3506"/>
              <a:ext cx="0" cy="83"/>
            </a:xfrm>
            <a:custGeom>
              <a:avLst/>
              <a:gdLst>
                <a:gd name="T0" fmla="*/ 524 h 524"/>
                <a:gd name="T1" fmla="*/ 524 h 524"/>
                <a:gd name="T2" fmla="*/ 0 h 52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24">
                  <a:moveTo>
                    <a:pt x="0" y="524"/>
                  </a:moveTo>
                  <a:lnTo>
                    <a:pt x="0" y="524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20" name="Freeform 100"/>
            <p:cNvSpPr>
              <a:spLocks/>
            </p:cNvSpPr>
            <p:nvPr/>
          </p:nvSpPr>
          <p:spPr bwMode="auto">
            <a:xfrm>
              <a:off x="2162" y="5837"/>
              <a:ext cx="141" cy="53"/>
            </a:xfrm>
            <a:custGeom>
              <a:avLst/>
              <a:gdLst>
                <a:gd name="T0" fmla="*/ 1155 w 1155"/>
                <a:gd name="T1" fmla="*/ 331 h 331"/>
                <a:gd name="T2" fmla="*/ 0 w 1155"/>
                <a:gd name="T3" fmla="*/ 331 h 331"/>
                <a:gd name="T4" fmla="*/ 0 w 1155"/>
                <a:gd name="T5" fmla="*/ 0 h 3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55" h="331">
                  <a:moveTo>
                    <a:pt x="1155" y="331"/>
                  </a:moveTo>
                  <a:lnTo>
                    <a:pt x="0" y="331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21" name="Freeform 101"/>
            <p:cNvSpPr>
              <a:spLocks/>
            </p:cNvSpPr>
            <p:nvPr/>
          </p:nvSpPr>
          <p:spPr bwMode="auto">
            <a:xfrm>
              <a:off x="339" y="1110"/>
              <a:ext cx="58" cy="473"/>
            </a:xfrm>
            <a:custGeom>
              <a:avLst/>
              <a:gdLst>
                <a:gd name="T0" fmla="*/ 466 w 466"/>
                <a:gd name="T1" fmla="*/ 2960 h 2960"/>
                <a:gd name="T2" fmla="*/ 0 w 466"/>
                <a:gd name="T3" fmla="*/ 2960 h 2960"/>
                <a:gd name="T4" fmla="*/ 0 w 466"/>
                <a:gd name="T5" fmla="*/ 0 h 29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66" h="2960">
                  <a:moveTo>
                    <a:pt x="466" y="2960"/>
                  </a:moveTo>
                  <a:lnTo>
                    <a:pt x="0" y="2960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22" name="Freeform 102"/>
            <p:cNvSpPr>
              <a:spLocks/>
            </p:cNvSpPr>
            <p:nvPr/>
          </p:nvSpPr>
          <p:spPr bwMode="auto">
            <a:xfrm>
              <a:off x="637" y="1112"/>
              <a:ext cx="68" cy="53"/>
            </a:xfrm>
            <a:custGeom>
              <a:avLst/>
              <a:gdLst>
                <a:gd name="T0" fmla="*/ 552 w 552"/>
                <a:gd name="T1" fmla="*/ 330 h 330"/>
                <a:gd name="T2" fmla="*/ 0 w 552"/>
                <a:gd name="T3" fmla="*/ 330 h 330"/>
                <a:gd name="T4" fmla="*/ 0 w 552"/>
                <a:gd name="T5" fmla="*/ 0 h 3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52" h="330">
                  <a:moveTo>
                    <a:pt x="552" y="330"/>
                  </a:moveTo>
                  <a:lnTo>
                    <a:pt x="0" y="330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23" name="Freeform 103"/>
            <p:cNvSpPr>
              <a:spLocks/>
            </p:cNvSpPr>
            <p:nvPr/>
          </p:nvSpPr>
          <p:spPr bwMode="auto">
            <a:xfrm>
              <a:off x="2693" y="1906"/>
              <a:ext cx="758" cy="61"/>
            </a:xfrm>
            <a:custGeom>
              <a:avLst/>
              <a:gdLst>
                <a:gd name="T0" fmla="*/ 6194 w 6194"/>
                <a:gd name="T1" fmla="*/ 0 h 386"/>
                <a:gd name="T2" fmla="*/ 0 w 6194"/>
                <a:gd name="T3" fmla="*/ 0 h 386"/>
                <a:gd name="T4" fmla="*/ 0 w 6194"/>
                <a:gd name="T5" fmla="*/ 386 h 3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194" h="386">
                  <a:moveTo>
                    <a:pt x="6194" y="0"/>
                  </a:moveTo>
                  <a:lnTo>
                    <a:pt x="0" y="0"/>
                  </a:lnTo>
                  <a:lnTo>
                    <a:pt x="0" y="386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24" name="Freeform 104"/>
            <p:cNvSpPr>
              <a:spLocks/>
            </p:cNvSpPr>
            <p:nvPr/>
          </p:nvSpPr>
          <p:spPr bwMode="auto">
            <a:xfrm>
              <a:off x="3284" y="5079"/>
              <a:ext cx="71" cy="36"/>
            </a:xfrm>
            <a:custGeom>
              <a:avLst/>
              <a:gdLst>
                <a:gd name="T0" fmla="*/ 575 w 575"/>
                <a:gd name="T1" fmla="*/ 0 h 221"/>
                <a:gd name="T2" fmla="*/ 0 w 575"/>
                <a:gd name="T3" fmla="*/ 0 h 221"/>
                <a:gd name="T4" fmla="*/ 0 w 575"/>
                <a:gd name="T5" fmla="*/ 221 h 2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75" h="221">
                  <a:moveTo>
                    <a:pt x="575" y="0"/>
                  </a:moveTo>
                  <a:lnTo>
                    <a:pt x="0" y="0"/>
                  </a:lnTo>
                  <a:lnTo>
                    <a:pt x="0" y="221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25" name="Freeform 105"/>
            <p:cNvSpPr>
              <a:spLocks/>
            </p:cNvSpPr>
            <p:nvPr/>
          </p:nvSpPr>
          <p:spPr bwMode="auto">
            <a:xfrm>
              <a:off x="2492" y="5009"/>
              <a:ext cx="235" cy="143"/>
            </a:xfrm>
            <a:custGeom>
              <a:avLst/>
              <a:gdLst>
                <a:gd name="T0" fmla="*/ 1923 w 1923"/>
                <a:gd name="T1" fmla="*/ 0 h 896"/>
                <a:gd name="T2" fmla="*/ 0 w 1923"/>
                <a:gd name="T3" fmla="*/ 0 h 896"/>
                <a:gd name="T4" fmla="*/ 0 w 1923"/>
                <a:gd name="T5" fmla="*/ 896 h 8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23" h="896">
                  <a:moveTo>
                    <a:pt x="1923" y="0"/>
                  </a:moveTo>
                  <a:lnTo>
                    <a:pt x="0" y="0"/>
                  </a:lnTo>
                  <a:lnTo>
                    <a:pt x="0" y="896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26" name="Freeform 106"/>
            <p:cNvSpPr>
              <a:spLocks/>
            </p:cNvSpPr>
            <p:nvPr/>
          </p:nvSpPr>
          <p:spPr bwMode="auto">
            <a:xfrm>
              <a:off x="2885" y="1659"/>
              <a:ext cx="136" cy="35"/>
            </a:xfrm>
            <a:custGeom>
              <a:avLst/>
              <a:gdLst>
                <a:gd name="T0" fmla="*/ 1116 w 1116"/>
                <a:gd name="T1" fmla="*/ 220 h 220"/>
                <a:gd name="T2" fmla="*/ 0 w 1116"/>
                <a:gd name="T3" fmla="*/ 220 h 220"/>
                <a:gd name="T4" fmla="*/ 0 w 1116"/>
                <a:gd name="T5" fmla="*/ 0 h 2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16" h="220">
                  <a:moveTo>
                    <a:pt x="1116" y="220"/>
                  </a:moveTo>
                  <a:lnTo>
                    <a:pt x="0" y="220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27" name="Freeform 107"/>
            <p:cNvSpPr>
              <a:spLocks/>
            </p:cNvSpPr>
            <p:nvPr/>
          </p:nvSpPr>
          <p:spPr bwMode="auto">
            <a:xfrm>
              <a:off x="1906" y="3422"/>
              <a:ext cx="330" cy="35"/>
            </a:xfrm>
            <a:custGeom>
              <a:avLst/>
              <a:gdLst>
                <a:gd name="T0" fmla="*/ 2697 w 2697"/>
                <a:gd name="T1" fmla="*/ 220 h 220"/>
                <a:gd name="T2" fmla="*/ 0 w 2697"/>
                <a:gd name="T3" fmla="*/ 220 h 220"/>
                <a:gd name="T4" fmla="*/ 0 w 2697"/>
                <a:gd name="T5" fmla="*/ 0 h 2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97" h="220">
                  <a:moveTo>
                    <a:pt x="2697" y="220"/>
                  </a:moveTo>
                  <a:lnTo>
                    <a:pt x="0" y="220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28" name="Freeform 108"/>
            <p:cNvSpPr>
              <a:spLocks/>
            </p:cNvSpPr>
            <p:nvPr/>
          </p:nvSpPr>
          <p:spPr bwMode="auto">
            <a:xfrm>
              <a:off x="2637" y="1967"/>
              <a:ext cx="56" cy="111"/>
            </a:xfrm>
            <a:custGeom>
              <a:avLst/>
              <a:gdLst>
                <a:gd name="T0" fmla="*/ 461 w 461"/>
                <a:gd name="T1" fmla="*/ 0 h 689"/>
                <a:gd name="T2" fmla="*/ 0 w 461"/>
                <a:gd name="T3" fmla="*/ 0 h 689"/>
                <a:gd name="T4" fmla="*/ 0 w 461"/>
                <a:gd name="T5" fmla="*/ 689 h 6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61" h="689">
                  <a:moveTo>
                    <a:pt x="461" y="0"/>
                  </a:moveTo>
                  <a:lnTo>
                    <a:pt x="0" y="0"/>
                  </a:lnTo>
                  <a:lnTo>
                    <a:pt x="0" y="689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29" name="Freeform 109"/>
            <p:cNvSpPr>
              <a:spLocks/>
            </p:cNvSpPr>
            <p:nvPr/>
          </p:nvSpPr>
          <p:spPr bwMode="auto">
            <a:xfrm>
              <a:off x="1238" y="3509"/>
              <a:ext cx="199" cy="537"/>
            </a:xfrm>
            <a:custGeom>
              <a:avLst/>
              <a:gdLst>
                <a:gd name="T0" fmla="*/ 1626 w 1626"/>
                <a:gd name="T1" fmla="*/ 0 h 3358"/>
                <a:gd name="T2" fmla="*/ 0 w 1626"/>
                <a:gd name="T3" fmla="*/ 0 h 3358"/>
                <a:gd name="T4" fmla="*/ 0 w 1626"/>
                <a:gd name="T5" fmla="*/ 3358 h 33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26" h="3358">
                  <a:moveTo>
                    <a:pt x="1626" y="0"/>
                  </a:moveTo>
                  <a:lnTo>
                    <a:pt x="0" y="0"/>
                  </a:lnTo>
                  <a:lnTo>
                    <a:pt x="0" y="3358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30" name="Freeform 110"/>
            <p:cNvSpPr>
              <a:spLocks/>
            </p:cNvSpPr>
            <p:nvPr/>
          </p:nvSpPr>
          <p:spPr bwMode="auto">
            <a:xfrm>
              <a:off x="232" y="143"/>
              <a:ext cx="693" cy="483"/>
            </a:xfrm>
            <a:custGeom>
              <a:avLst/>
              <a:gdLst>
                <a:gd name="T0" fmla="*/ 5661 w 5661"/>
                <a:gd name="T1" fmla="*/ 0 h 3023"/>
                <a:gd name="T2" fmla="*/ 0 w 5661"/>
                <a:gd name="T3" fmla="*/ 0 h 3023"/>
                <a:gd name="T4" fmla="*/ 0 w 5661"/>
                <a:gd name="T5" fmla="*/ 3023 h 30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661" h="3023">
                  <a:moveTo>
                    <a:pt x="5661" y="0"/>
                  </a:moveTo>
                  <a:lnTo>
                    <a:pt x="0" y="0"/>
                  </a:lnTo>
                  <a:lnTo>
                    <a:pt x="0" y="3023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31" name="Freeform 111"/>
            <p:cNvSpPr>
              <a:spLocks/>
            </p:cNvSpPr>
            <p:nvPr/>
          </p:nvSpPr>
          <p:spPr bwMode="auto">
            <a:xfrm>
              <a:off x="2895" y="2576"/>
              <a:ext cx="170" cy="247"/>
            </a:xfrm>
            <a:custGeom>
              <a:avLst/>
              <a:gdLst>
                <a:gd name="T0" fmla="*/ 1388 w 1388"/>
                <a:gd name="T1" fmla="*/ 1544 h 1544"/>
                <a:gd name="T2" fmla="*/ 0 w 1388"/>
                <a:gd name="T3" fmla="*/ 1544 h 1544"/>
                <a:gd name="T4" fmla="*/ 0 w 1388"/>
                <a:gd name="T5" fmla="*/ 0 h 15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88" h="1544">
                  <a:moveTo>
                    <a:pt x="1388" y="1544"/>
                  </a:moveTo>
                  <a:lnTo>
                    <a:pt x="0" y="1544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32" name="Freeform 112"/>
            <p:cNvSpPr>
              <a:spLocks/>
            </p:cNvSpPr>
            <p:nvPr/>
          </p:nvSpPr>
          <p:spPr bwMode="auto">
            <a:xfrm>
              <a:off x="2637" y="2078"/>
              <a:ext cx="357" cy="110"/>
            </a:xfrm>
            <a:custGeom>
              <a:avLst/>
              <a:gdLst>
                <a:gd name="T0" fmla="*/ 2923 w 2923"/>
                <a:gd name="T1" fmla="*/ 689 h 689"/>
                <a:gd name="T2" fmla="*/ 0 w 2923"/>
                <a:gd name="T3" fmla="*/ 689 h 689"/>
                <a:gd name="T4" fmla="*/ 0 w 2923"/>
                <a:gd name="T5" fmla="*/ 0 h 6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23" h="689">
                  <a:moveTo>
                    <a:pt x="2923" y="689"/>
                  </a:moveTo>
                  <a:lnTo>
                    <a:pt x="0" y="689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33" name="Freeform 113"/>
            <p:cNvSpPr>
              <a:spLocks/>
            </p:cNvSpPr>
            <p:nvPr/>
          </p:nvSpPr>
          <p:spPr bwMode="auto">
            <a:xfrm>
              <a:off x="2766" y="4268"/>
              <a:ext cx="161" cy="194"/>
            </a:xfrm>
            <a:custGeom>
              <a:avLst/>
              <a:gdLst>
                <a:gd name="T0" fmla="*/ 1314 w 1314"/>
                <a:gd name="T1" fmla="*/ 0 h 1213"/>
                <a:gd name="T2" fmla="*/ 0 w 1314"/>
                <a:gd name="T3" fmla="*/ 0 h 1213"/>
                <a:gd name="T4" fmla="*/ 0 w 1314"/>
                <a:gd name="T5" fmla="*/ 1213 h 12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14" h="1213">
                  <a:moveTo>
                    <a:pt x="1314" y="0"/>
                  </a:moveTo>
                  <a:lnTo>
                    <a:pt x="0" y="0"/>
                  </a:lnTo>
                  <a:lnTo>
                    <a:pt x="0" y="1213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34" name="Freeform 114"/>
            <p:cNvSpPr>
              <a:spLocks/>
            </p:cNvSpPr>
            <p:nvPr/>
          </p:nvSpPr>
          <p:spPr bwMode="auto">
            <a:xfrm>
              <a:off x="1689" y="3810"/>
              <a:ext cx="328" cy="35"/>
            </a:xfrm>
            <a:custGeom>
              <a:avLst/>
              <a:gdLst>
                <a:gd name="T0" fmla="*/ 2684 w 2684"/>
                <a:gd name="T1" fmla="*/ 0 h 221"/>
                <a:gd name="T2" fmla="*/ 0 w 2684"/>
                <a:gd name="T3" fmla="*/ 0 h 221"/>
                <a:gd name="T4" fmla="*/ 0 w 2684"/>
                <a:gd name="T5" fmla="*/ 221 h 2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84" h="221">
                  <a:moveTo>
                    <a:pt x="2684" y="0"/>
                  </a:moveTo>
                  <a:lnTo>
                    <a:pt x="0" y="0"/>
                  </a:lnTo>
                  <a:lnTo>
                    <a:pt x="0" y="221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35" name="Freeform 115"/>
            <p:cNvSpPr>
              <a:spLocks/>
            </p:cNvSpPr>
            <p:nvPr/>
          </p:nvSpPr>
          <p:spPr bwMode="auto">
            <a:xfrm>
              <a:off x="2303" y="5855"/>
              <a:ext cx="398" cy="35"/>
            </a:xfrm>
            <a:custGeom>
              <a:avLst/>
              <a:gdLst>
                <a:gd name="T0" fmla="*/ 3250 w 3250"/>
                <a:gd name="T1" fmla="*/ 0 h 220"/>
                <a:gd name="T2" fmla="*/ 0 w 3250"/>
                <a:gd name="T3" fmla="*/ 0 h 220"/>
                <a:gd name="T4" fmla="*/ 0 w 3250"/>
                <a:gd name="T5" fmla="*/ 220 h 2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50" h="220">
                  <a:moveTo>
                    <a:pt x="3250" y="0"/>
                  </a:moveTo>
                  <a:lnTo>
                    <a:pt x="0" y="0"/>
                  </a:lnTo>
                  <a:lnTo>
                    <a:pt x="0" y="22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36" name="Freeform 116"/>
            <p:cNvSpPr>
              <a:spLocks/>
            </p:cNvSpPr>
            <p:nvPr/>
          </p:nvSpPr>
          <p:spPr bwMode="auto">
            <a:xfrm>
              <a:off x="2492" y="1544"/>
              <a:ext cx="122" cy="62"/>
            </a:xfrm>
            <a:custGeom>
              <a:avLst/>
              <a:gdLst>
                <a:gd name="T0" fmla="*/ 997 w 997"/>
                <a:gd name="T1" fmla="*/ 386 h 386"/>
                <a:gd name="T2" fmla="*/ 0 w 997"/>
                <a:gd name="T3" fmla="*/ 386 h 386"/>
                <a:gd name="T4" fmla="*/ 0 w 997"/>
                <a:gd name="T5" fmla="*/ 0 h 3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97" h="386">
                  <a:moveTo>
                    <a:pt x="997" y="386"/>
                  </a:moveTo>
                  <a:lnTo>
                    <a:pt x="0" y="386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37" name="Freeform 117"/>
            <p:cNvSpPr>
              <a:spLocks/>
            </p:cNvSpPr>
            <p:nvPr/>
          </p:nvSpPr>
          <p:spPr bwMode="auto">
            <a:xfrm>
              <a:off x="2543" y="4127"/>
              <a:ext cx="150" cy="168"/>
            </a:xfrm>
            <a:custGeom>
              <a:avLst/>
              <a:gdLst>
                <a:gd name="T0" fmla="*/ 1229 w 1229"/>
                <a:gd name="T1" fmla="*/ 0 h 1048"/>
                <a:gd name="T2" fmla="*/ 0 w 1229"/>
                <a:gd name="T3" fmla="*/ 0 h 1048"/>
                <a:gd name="T4" fmla="*/ 0 w 1229"/>
                <a:gd name="T5" fmla="*/ 1048 h 10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29" h="1048">
                  <a:moveTo>
                    <a:pt x="1229" y="0"/>
                  </a:moveTo>
                  <a:lnTo>
                    <a:pt x="0" y="0"/>
                  </a:lnTo>
                  <a:lnTo>
                    <a:pt x="0" y="1048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38" name="Freeform 118"/>
            <p:cNvSpPr>
              <a:spLocks/>
            </p:cNvSpPr>
            <p:nvPr/>
          </p:nvSpPr>
          <p:spPr bwMode="auto">
            <a:xfrm>
              <a:off x="2766" y="4462"/>
              <a:ext cx="140" cy="194"/>
            </a:xfrm>
            <a:custGeom>
              <a:avLst/>
              <a:gdLst>
                <a:gd name="T0" fmla="*/ 1138 w 1138"/>
                <a:gd name="T1" fmla="*/ 1212 h 1212"/>
                <a:gd name="T2" fmla="*/ 0 w 1138"/>
                <a:gd name="T3" fmla="*/ 1212 h 1212"/>
                <a:gd name="T4" fmla="*/ 0 w 1138"/>
                <a:gd name="T5" fmla="*/ 0 h 12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38" h="1212">
                  <a:moveTo>
                    <a:pt x="1138" y="1212"/>
                  </a:moveTo>
                  <a:lnTo>
                    <a:pt x="0" y="1212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39" name="Freeform 119"/>
            <p:cNvSpPr>
              <a:spLocks/>
            </p:cNvSpPr>
            <p:nvPr/>
          </p:nvSpPr>
          <p:spPr bwMode="auto">
            <a:xfrm>
              <a:off x="482" y="5996"/>
              <a:ext cx="3145" cy="35"/>
            </a:xfrm>
            <a:custGeom>
              <a:avLst/>
              <a:gdLst>
                <a:gd name="T0" fmla="*/ 25705 w 25705"/>
                <a:gd name="T1" fmla="*/ 0 h 220"/>
                <a:gd name="T2" fmla="*/ 0 w 25705"/>
                <a:gd name="T3" fmla="*/ 0 h 220"/>
                <a:gd name="T4" fmla="*/ 0 w 25705"/>
                <a:gd name="T5" fmla="*/ 220 h 2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705" h="220">
                  <a:moveTo>
                    <a:pt x="25705" y="0"/>
                  </a:moveTo>
                  <a:lnTo>
                    <a:pt x="0" y="0"/>
                  </a:lnTo>
                  <a:lnTo>
                    <a:pt x="0" y="22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40" name="Freeform 120"/>
            <p:cNvSpPr>
              <a:spLocks/>
            </p:cNvSpPr>
            <p:nvPr/>
          </p:nvSpPr>
          <p:spPr bwMode="auto">
            <a:xfrm>
              <a:off x="232" y="626"/>
              <a:ext cx="107" cy="484"/>
            </a:xfrm>
            <a:custGeom>
              <a:avLst/>
              <a:gdLst>
                <a:gd name="T0" fmla="*/ 876 w 876"/>
                <a:gd name="T1" fmla="*/ 3023 h 3023"/>
                <a:gd name="T2" fmla="*/ 0 w 876"/>
                <a:gd name="T3" fmla="*/ 3023 h 3023"/>
                <a:gd name="T4" fmla="*/ 0 w 876"/>
                <a:gd name="T5" fmla="*/ 0 h 30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76" h="3023">
                  <a:moveTo>
                    <a:pt x="876" y="3023"/>
                  </a:moveTo>
                  <a:lnTo>
                    <a:pt x="0" y="3023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41" name="Freeform 121"/>
            <p:cNvSpPr>
              <a:spLocks/>
            </p:cNvSpPr>
            <p:nvPr/>
          </p:nvSpPr>
          <p:spPr bwMode="auto">
            <a:xfrm>
              <a:off x="2295" y="1544"/>
              <a:ext cx="197" cy="110"/>
            </a:xfrm>
            <a:custGeom>
              <a:avLst/>
              <a:gdLst>
                <a:gd name="T0" fmla="*/ 1608 w 1608"/>
                <a:gd name="T1" fmla="*/ 0 h 689"/>
                <a:gd name="T2" fmla="*/ 0 w 1608"/>
                <a:gd name="T3" fmla="*/ 0 h 689"/>
                <a:gd name="T4" fmla="*/ 0 w 1608"/>
                <a:gd name="T5" fmla="*/ 689 h 6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08" h="689">
                  <a:moveTo>
                    <a:pt x="1608" y="0"/>
                  </a:moveTo>
                  <a:lnTo>
                    <a:pt x="0" y="0"/>
                  </a:lnTo>
                  <a:lnTo>
                    <a:pt x="0" y="689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42" name="Freeform 122"/>
            <p:cNvSpPr>
              <a:spLocks/>
            </p:cNvSpPr>
            <p:nvPr/>
          </p:nvSpPr>
          <p:spPr bwMode="auto">
            <a:xfrm>
              <a:off x="499" y="2162"/>
              <a:ext cx="691" cy="785"/>
            </a:xfrm>
            <a:custGeom>
              <a:avLst/>
              <a:gdLst>
                <a:gd name="T0" fmla="*/ 5647 w 5647"/>
                <a:gd name="T1" fmla="*/ 4909 h 4909"/>
                <a:gd name="T2" fmla="*/ 0 w 5647"/>
                <a:gd name="T3" fmla="*/ 4909 h 4909"/>
                <a:gd name="T4" fmla="*/ 0 w 5647"/>
                <a:gd name="T5" fmla="*/ 0 h 49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647" h="4909">
                  <a:moveTo>
                    <a:pt x="5647" y="4909"/>
                  </a:moveTo>
                  <a:lnTo>
                    <a:pt x="0" y="4909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43" name="Freeform 123"/>
            <p:cNvSpPr>
              <a:spLocks/>
            </p:cNvSpPr>
            <p:nvPr/>
          </p:nvSpPr>
          <p:spPr bwMode="auto">
            <a:xfrm>
              <a:off x="1554" y="3702"/>
              <a:ext cx="86" cy="196"/>
            </a:xfrm>
            <a:custGeom>
              <a:avLst/>
              <a:gdLst>
                <a:gd name="T0" fmla="*/ 704 w 704"/>
                <a:gd name="T1" fmla="*/ 1226 h 1226"/>
                <a:gd name="T2" fmla="*/ 0 w 704"/>
                <a:gd name="T3" fmla="*/ 1226 h 1226"/>
                <a:gd name="T4" fmla="*/ 0 w 704"/>
                <a:gd name="T5" fmla="*/ 0 h 12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04" h="1226">
                  <a:moveTo>
                    <a:pt x="704" y="1226"/>
                  </a:moveTo>
                  <a:lnTo>
                    <a:pt x="0" y="1226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44" name="Freeform 124"/>
            <p:cNvSpPr>
              <a:spLocks/>
            </p:cNvSpPr>
            <p:nvPr/>
          </p:nvSpPr>
          <p:spPr bwMode="auto">
            <a:xfrm>
              <a:off x="2175" y="5564"/>
              <a:ext cx="400" cy="62"/>
            </a:xfrm>
            <a:custGeom>
              <a:avLst/>
              <a:gdLst>
                <a:gd name="T0" fmla="*/ 3267 w 3267"/>
                <a:gd name="T1" fmla="*/ 386 h 386"/>
                <a:gd name="T2" fmla="*/ 0 w 3267"/>
                <a:gd name="T3" fmla="*/ 386 h 386"/>
                <a:gd name="T4" fmla="*/ 0 w 3267"/>
                <a:gd name="T5" fmla="*/ 0 h 3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67" h="386">
                  <a:moveTo>
                    <a:pt x="3267" y="386"/>
                  </a:moveTo>
                  <a:lnTo>
                    <a:pt x="0" y="386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45" name="Freeform 125"/>
            <p:cNvSpPr>
              <a:spLocks/>
            </p:cNvSpPr>
            <p:nvPr/>
          </p:nvSpPr>
          <p:spPr bwMode="auto">
            <a:xfrm>
              <a:off x="2429" y="1835"/>
              <a:ext cx="423" cy="206"/>
            </a:xfrm>
            <a:custGeom>
              <a:avLst/>
              <a:gdLst>
                <a:gd name="T0" fmla="*/ 3456 w 3456"/>
                <a:gd name="T1" fmla="*/ 0 h 1289"/>
                <a:gd name="T2" fmla="*/ 0 w 3456"/>
                <a:gd name="T3" fmla="*/ 0 h 1289"/>
                <a:gd name="T4" fmla="*/ 0 w 3456"/>
                <a:gd name="T5" fmla="*/ 1289 h 12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56" h="1289">
                  <a:moveTo>
                    <a:pt x="3456" y="0"/>
                  </a:moveTo>
                  <a:lnTo>
                    <a:pt x="0" y="0"/>
                  </a:lnTo>
                  <a:lnTo>
                    <a:pt x="0" y="1289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46" name="Freeform 126"/>
            <p:cNvSpPr>
              <a:spLocks/>
            </p:cNvSpPr>
            <p:nvPr/>
          </p:nvSpPr>
          <p:spPr bwMode="auto">
            <a:xfrm>
              <a:off x="2162" y="5785"/>
              <a:ext cx="472" cy="52"/>
            </a:xfrm>
            <a:custGeom>
              <a:avLst/>
              <a:gdLst>
                <a:gd name="T0" fmla="*/ 3855 w 3855"/>
                <a:gd name="T1" fmla="*/ 0 h 330"/>
                <a:gd name="T2" fmla="*/ 0 w 3855"/>
                <a:gd name="T3" fmla="*/ 0 h 330"/>
                <a:gd name="T4" fmla="*/ 0 w 3855"/>
                <a:gd name="T5" fmla="*/ 330 h 3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855" h="330">
                  <a:moveTo>
                    <a:pt x="3855" y="0"/>
                  </a:moveTo>
                  <a:lnTo>
                    <a:pt x="0" y="0"/>
                  </a:lnTo>
                  <a:lnTo>
                    <a:pt x="0" y="33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47" name="Freeform 127"/>
            <p:cNvSpPr>
              <a:spLocks/>
            </p:cNvSpPr>
            <p:nvPr/>
          </p:nvSpPr>
          <p:spPr bwMode="auto">
            <a:xfrm>
              <a:off x="2175" y="5503"/>
              <a:ext cx="340" cy="61"/>
            </a:xfrm>
            <a:custGeom>
              <a:avLst/>
              <a:gdLst>
                <a:gd name="T0" fmla="*/ 2776 w 2776"/>
                <a:gd name="T1" fmla="*/ 0 h 386"/>
                <a:gd name="T2" fmla="*/ 0 w 2776"/>
                <a:gd name="T3" fmla="*/ 0 h 386"/>
                <a:gd name="T4" fmla="*/ 0 w 2776"/>
                <a:gd name="T5" fmla="*/ 386 h 3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76" h="386">
                  <a:moveTo>
                    <a:pt x="2776" y="0"/>
                  </a:moveTo>
                  <a:lnTo>
                    <a:pt x="0" y="0"/>
                  </a:lnTo>
                  <a:lnTo>
                    <a:pt x="0" y="386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48" name="Freeform 128"/>
            <p:cNvSpPr>
              <a:spLocks/>
            </p:cNvSpPr>
            <p:nvPr/>
          </p:nvSpPr>
          <p:spPr bwMode="auto">
            <a:xfrm>
              <a:off x="1298" y="4021"/>
              <a:ext cx="1751" cy="562"/>
            </a:xfrm>
            <a:custGeom>
              <a:avLst/>
              <a:gdLst>
                <a:gd name="T0" fmla="*/ 14315 w 14315"/>
                <a:gd name="T1" fmla="*/ 0 h 3512"/>
                <a:gd name="T2" fmla="*/ 0 w 14315"/>
                <a:gd name="T3" fmla="*/ 0 h 3512"/>
                <a:gd name="T4" fmla="*/ 0 w 14315"/>
                <a:gd name="T5" fmla="*/ 3512 h 35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315" h="3512">
                  <a:moveTo>
                    <a:pt x="14315" y="0"/>
                  </a:moveTo>
                  <a:lnTo>
                    <a:pt x="0" y="0"/>
                  </a:lnTo>
                  <a:lnTo>
                    <a:pt x="0" y="3512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49" name="Freeform 129"/>
            <p:cNvSpPr>
              <a:spLocks/>
            </p:cNvSpPr>
            <p:nvPr/>
          </p:nvSpPr>
          <p:spPr bwMode="auto">
            <a:xfrm>
              <a:off x="2734" y="5115"/>
              <a:ext cx="550" cy="52"/>
            </a:xfrm>
            <a:custGeom>
              <a:avLst/>
              <a:gdLst>
                <a:gd name="T0" fmla="*/ 4497 w 4497"/>
                <a:gd name="T1" fmla="*/ 0 h 330"/>
                <a:gd name="T2" fmla="*/ 0 w 4497"/>
                <a:gd name="T3" fmla="*/ 0 h 330"/>
                <a:gd name="T4" fmla="*/ 0 w 4497"/>
                <a:gd name="T5" fmla="*/ 330 h 3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497" h="330">
                  <a:moveTo>
                    <a:pt x="4497" y="0"/>
                  </a:moveTo>
                  <a:lnTo>
                    <a:pt x="0" y="0"/>
                  </a:lnTo>
                  <a:lnTo>
                    <a:pt x="0" y="33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50" name="Freeform 130"/>
            <p:cNvSpPr>
              <a:spLocks/>
            </p:cNvSpPr>
            <p:nvPr/>
          </p:nvSpPr>
          <p:spPr bwMode="auto">
            <a:xfrm>
              <a:off x="2544" y="5229"/>
              <a:ext cx="46" cy="66"/>
            </a:xfrm>
            <a:custGeom>
              <a:avLst/>
              <a:gdLst>
                <a:gd name="T0" fmla="*/ 377 w 377"/>
                <a:gd name="T1" fmla="*/ 0 h 414"/>
                <a:gd name="T2" fmla="*/ 0 w 377"/>
                <a:gd name="T3" fmla="*/ 0 h 414"/>
                <a:gd name="T4" fmla="*/ 0 w 377"/>
                <a:gd name="T5" fmla="*/ 414 h 4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7" h="414">
                  <a:moveTo>
                    <a:pt x="377" y="0"/>
                  </a:moveTo>
                  <a:lnTo>
                    <a:pt x="0" y="0"/>
                  </a:lnTo>
                  <a:lnTo>
                    <a:pt x="0" y="414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51" name="Line 131"/>
            <p:cNvSpPr>
              <a:spLocks noChangeShapeType="1"/>
            </p:cNvSpPr>
            <p:nvPr/>
          </p:nvSpPr>
          <p:spPr bwMode="auto">
            <a:xfrm>
              <a:off x="113" y="3329"/>
              <a:ext cx="34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52" name="Freeform 132"/>
            <p:cNvSpPr>
              <a:spLocks/>
            </p:cNvSpPr>
            <p:nvPr/>
          </p:nvSpPr>
          <p:spPr bwMode="auto">
            <a:xfrm>
              <a:off x="2544" y="2078"/>
              <a:ext cx="93" cy="169"/>
            </a:xfrm>
            <a:custGeom>
              <a:avLst/>
              <a:gdLst>
                <a:gd name="T0" fmla="*/ 760 w 760"/>
                <a:gd name="T1" fmla="*/ 0 h 1061"/>
                <a:gd name="T2" fmla="*/ 0 w 760"/>
                <a:gd name="T3" fmla="*/ 0 h 1061"/>
                <a:gd name="T4" fmla="*/ 0 w 760"/>
                <a:gd name="T5" fmla="*/ 1061 h 10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60" h="1061">
                  <a:moveTo>
                    <a:pt x="760" y="0"/>
                  </a:moveTo>
                  <a:lnTo>
                    <a:pt x="0" y="0"/>
                  </a:lnTo>
                  <a:lnTo>
                    <a:pt x="0" y="1061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53" name="Freeform 133"/>
            <p:cNvSpPr>
              <a:spLocks/>
            </p:cNvSpPr>
            <p:nvPr/>
          </p:nvSpPr>
          <p:spPr bwMode="auto">
            <a:xfrm>
              <a:off x="1614" y="4723"/>
              <a:ext cx="842" cy="422"/>
            </a:xfrm>
            <a:custGeom>
              <a:avLst/>
              <a:gdLst>
                <a:gd name="T0" fmla="*/ 6882 w 6882"/>
                <a:gd name="T1" fmla="*/ 0 h 2635"/>
                <a:gd name="T2" fmla="*/ 0 w 6882"/>
                <a:gd name="T3" fmla="*/ 0 h 2635"/>
                <a:gd name="T4" fmla="*/ 0 w 6882"/>
                <a:gd name="T5" fmla="*/ 2635 h 26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882" h="2635">
                  <a:moveTo>
                    <a:pt x="6882" y="0"/>
                  </a:moveTo>
                  <a:lnTo>
                    <a:pt x="0" y="0"/>
                  </a:lnTo>
                  <a:lnTo>
                    <a:pt x="0" y="2635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54" name="Freeform 134"/>
            <p:cNvSpPr>
              <a:spLocks/>
            </p:cNvSpPr>
            <p:nvPr/>
          </p:nvSpPr>
          <p:spPr bwMode="auto">
            <a:xfrm>
              <a:off x="2543" y="4295"/>
              <a:ext cx="223" cy="167"/>
            </a:xfrm>
            <a:custGeom>
              <a:avLst/>
              <a:gdLst>
                <a:gd name="T0" fmla="*/ 1824 w 1824"/>
                <a:gd name="T1" fmla="*/ 1047 h 1047"/>
                <a:gd name="T2" fmla="*/ 0 w 1824"/>
                <a:gd name="T3" fmla="*/ 1047 h 1047"/>
                <a:gd name="T4" fmla="*/ 0 w 1824"/>
                <a:gd name="T5" fmla="*/ 0 h 10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24" h="1047">
                  <a:moveTo>
                    <a:pt x="1824" y="1047"/>
                  </a:moveTo>
                  <a:lnTo>
                    <a:pt x="0" y="1047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55" name="Freeform 135"/>
            <p:cNvSpPr>
              <a:spLocks/>
            </p:cNvSpPr>
            <p:nvPr/>
          </p:nvSpPr>
          <p:spPr bwMode="auto">
            <a:xfrm>
              <a:off x="1799" y="3589"/>
              <a:ext cx="547" cy="62"/>
            </a:xfrm>
            <a:custGeom>
              <a:avLst/>
              <a:gdLst>
                <a:gd name="T0" fmla="*/ 4472 w 4472"/>
                <a:gd name="T1" fmla="*/ 386 h 386"/>
                <a:gd name="T2" fmla="*/ 0 w 4472"/>
                <a:gd name="T3" fmla="*/ 386 h 386"/>
                <a:gd name="T4" fmla="*/ 0 w 4472"/>
                <a:gd name="T5" fmla="*/ 0 h 3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472" h="386">
                  <a:moveTo>
                    <a:pt x="4472" y="386"/>
                  </a:moveTo>
                  <a:lnTo>
                    <a:pt x="0" y="386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56" name="Freeform 136"/>
            <p:cNvSpPr>
              <a:spLocks/>
            </p:cNvSpPr>
            <p:nvPr/>
          </p:nvSpPr>
          <p:spPr bwMode="auto">
            <a:xfrm>
              <a:off x="2456" y="4723"/>
              <a:ext cx="36" cy="429"/>
            </a:xfrm>
            <a:custGeom>
              <a:avLst/>
              <a:gdLst>
                <a:gd name="T0" fmla="*/ 293 w 293"/>
                <a:gd name="T1" fmla="*/ 2680 h 2680"/>
                <a:gd name="T2" fmla="*/ 0 w 293"/>
                <a:gd name="T3" fmla="*/ 2680 h 2680"/>
                <a:gd name="T4" fmla="*/ 0 w 293"/>
                <a:gd name="T5" fmla="*/ 0 h 26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3" h="2680">
                  <a:moveTo>
                    <a:pt x="293" y="2680"/>
                  </a:moveTo>
                  <a:lnTo>
                    <a:pt x="0" y="2680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57" name="Freeform 137"/>
            <p:cNvSpPr>
              <a:spLocks/>
            </p:cNvSpPr>
            <p:nvPr/>
          </p:nvSpPr>
          <p:spPr bwMode="auto">
            <a:xfrm>
              <a:off x="1554" y="3506"/>
              <a:ext cx="245" cy="196"/>
            </a:xfrm>
            <a:custGeom>
              <a:avLst/>
              <a:gdLst>
                <a:gd name="T0" fmla="*/ 1999 w 1999"/>
                <a:gd name="T1" fmla="*/ 0 h 1227"/>
                <a:gd name="T2" fmla="*/ 0 w 1999"/>
                <a:gd name="T3" fmla="*/ 0 h 1227"/>
                <a:gd name="T4" fmla="*/ 0 w 1999"/>
                <a:gd name="T5" fmla="*/ 1227 h 12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99" h="1227">
                  <a:moveTo>
                    <a:pt x="1999" y="0"/>
                  </a:moveTo>
                  <a:lnTo>
                    <a:pt x="0" y="0"/>
                  </a:lnTo>
                  <a:lnTo>
                    <a:pt x="0" y="1227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58" name="Freeform 138"/>
            <p:cNvSpPr>
              <a:spLocks/>
            </p:cNvSpPr>
            <p:nvPr/>
          </p:nvSpPr>
          <p:spPr bwMode="auto">
            <a:xfrm>
              <a:off x="2492" y="5152"/>
              <a:ext cx="52" cy="143"/>
            </a:xfrm>
            <a:custGeom>
              <a:avLst/>
              <a:gdLst>
                <a:gd name="T0" fmla="*/ 425 w 425"/>
                <a:gd name="T1" fmla="*/ 896 h 896"/>
                <a:gd name="T2" fmla="*/ 0 w 425"/>
                <a:gd name="T3" fmla="*/ 896 h 896"/>
                <a:gd name="T4" fmla="*/ 0 w 425"/>
                <a:gd name="T5" fmla="*/ 0 h 8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25" h="896">
                  <a:moveTo>
                    <a:pt x="425" y="896"/>
                  </a:moveTo>
                  <a:lnTo>
                    <a:pt x="0" y="896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59" name="Freeform 139"/>
            <p:cNvSpPr>
              <a:spLocks/>
            </p:cNvSpPr>
            <p:nvPr/>
          </p:nvSpPr>
          <p:spPr bwMode="auto">
            <a:xfrm>
              <a:off x="2614" y="1606"/>
              <a:ext cx="271" cy="53"/>
            </a:xfrm>
            <a:custGeom>
              <a:avLst/>
              <a:gdLst>
                <a:gd name="T0" fmla="*/ 2215 w 2215"/>
                <a:gd name="T1" fmla="*/ 331 h 331"/>
                <a:gd name="T2" fmla="*/ 0 w 2215"/>
                <a:gd name="T3" fmla="*/ 331 h 331"/>
                <a:gd name="T4" fmla="*/ 0 w 2215"/>
                <a:gd name="T5" fmla="*/ 0 h 3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15" h="331">
                  <a:moveTo>
                    <a:pt x="2215" y="331"/>
                  </a:moveTo>
                  <a:lnTo>
                    <a:pt x="0" y="331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60" name="Freeform 140"/>
            <p:cNvSpPr>
              <a:spLocks/>
            </p:cNvSpPr>
            <p:nvPr/>
          </p:nvSpPr>
          <p:spPr bwMode="auto">
            <a:xfrm>
              <a:off x="147" y="3329"/>
              <a:ext cx="335" cy="2702"/>
            </a:xfrm>
            <a:custGeom>
              <a:avLst/>
              <a:gdLst>
                <a:gd name="T0" fmla="*/ 2731 w 2731"/>
                <a:gd name="T1" fmla="*/ 16898 h 16898"/>
                <a:gd name="T2" fmla="*/ 0 w 2731"/>
                <a:gd name="T3" fmla="*/ 16898 h 16898"/>
                <a:gd name="T4" fmla="*/ 0 w 2731"/>
                <a:gd name="T5" fmla="*/ 0 h 168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31" h="16898">
                  <a:moveTo>
                    <a:pt x="2731" y="16898"/>
                  </a:moveTo>
                  <a:lnTo>
                    <a:pt x="0" y="16898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61" name="Freeform 141"/>
            <p:cNvSpPr>
              <a:spLocks/>
            </p:cNvSpPr>
            <p:nvPr/>
          </p:nvSpPr>
          <p:spPr bwMode="auto">
            <a:xfrm>
              <a:off x="397" y="1583"/>
              <a:ext cx="102" cy="579"/>
            </a:xfrm>
            <a:custGeom>
              <a:avLst/>
              <a:gdLst>
                <a:gd name="T0" fmla="*/ 836 w 836"/>
                <a:gd name="T1" fmla="*/ 3619 h 3619"/>
                <a:gd name="T2" fmla="*/ 0 w 836"/>
                <a:gd name="T3" fmla="*/ 3619 h 3619"/>
                <a:gd name="T4" fmla="*/ 0 w 836"/>
                <a:gd name="T5" fmla="*/ 0 h 36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36" h="3619">
                  <a:moveTo>
                    <a:pt x="836" y="3619"/>
                  </a:moveTo>
                  <a:lnTo>
                    <a:pt x="0" y="3619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62" name="Freeform 142"/>
            <p:cNvSpPr>
              <a:spLocks/>
            </p:cNvSpPr>
            <p:nvPr/>
          </p:nvSpPr>
          <p:spPr bwMode="auto">
            <a:xfrm>
              <a:off x="3284" y="5115"/>
              <a:ext cx="258" cy="35"/>
            </a:xfrm>
            <a:custGeom>
              <a:avLst/>
              <a:gdLst>
                <a:gd name="T0" fmla="*/ 2109 w 2109"/>
                <a:gd name="T1" fmla="*/ 220 h 220"/>
                <a:gd name="T2" fmla="*/ 0 w 2109"/>
                <a:gd name="T3" fmla="*/ 220 h 220"/>
                <a:gd name="T4" fmla="*/ 0 w 2109"/>
                <a:gd name="T5" fmla="*/ 0 h 2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09" h="220">
                  <a:moveTo>
                    <a:pt x="2109" y="220"/>
                  </a:moveTo>
                  <a:lnTo>
                    <a:pt x="0" y="220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63" name="Freeform 143"/>
            <p:cNvSpPr>
              <a:spLocks/>
            </p:cNvSpPr>
            <p:nvPr/>
          </p:nvSpPr>
          <p:spPr bwMode="auto">
            <a:xfrm>
              <a:off x="1190" y="1848"/>
              <a:ext cx="1040" cy="1099"/>
            </a:xfrm>
            <a:custGeom>
              <a:avLst/>
              <a:gdLst>
                <a:gd name="T0" fmla="*/ 8500 w 8500"/>
                <a:gd name="T1" fmla="*/ 0 h 6872"/>
                <a:gd name="T2" fmla="*/ 0 w 8500"/>
                <a:gd name="T3" fmla="*/ 0 h 6872"/>
                <a:gd name="T4" fmla="*/ 0 w 8500"/>
                <a:gd name="T5" fmla="*/ 6872 h 68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500" h="6872">
                  <a:moveTo>
                    <a:pt x="8500" y="0"/>
                  </a:moveTo>
                  <a:lnTo>
                    <a:pt x="0" y="0"/>
                  </a:lnTo>
                  <a:lnTo>
                    <a:pt x="0" y="6872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64" name="Freeform 144"/>
            <p:cNvSpPr>
              <a:spLocks/>
            </p:cNvSpPr>
            <p:nvPr/>
          </p:nvSpPr>
          <p:spPr bwMode="auto">
            <a:xfrm>
              <a:off x="482" y="6031"/>
              <a:ext cx="0" cy="36"/>
            </a:xfrm>
            <a:custGeom>
              <a:avLst/>
              <a:gdLst>
                <a:gd name="T0" fmla="*/ 221 h 221"/>
                <a:gd name="T1" fmla="*/ 221 h 221"/>
                <a:gd name="T2" fmla="*/ 0 h 22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21">
                  <a:moveTo>
                    <a:pt x="0" y="221"/>
                  </a:moveTo>
                  <a:lnTo>
                    <a:pt x="0" y="221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65" name="Freeform 145"/>
            <p:cNvSpPr>
              <a:spLocks/>
            </p:cNvSpPr>
            <p:nvPr/>
          </p:nvSpPr>
          <p:spPr bwMode="auto">
            <a:xfrm>
              <a:off x="1238" y="4046"/>
              <a:ext cx="60" cy="537"/>
            </a:xfrm>
            <a:custGeom>
              <a:avLst/>
              <a:gdLst>
                <a:gd name="T0" fmla="*/ 485 w 485"/>
                <a:gd name="T1" fmla="*/ 3358 h 3358"/>
                <a:gd name="T2" fmla="*/ 0 w 485"/>
                <a:gd name="T3" fmla="*/ 3358 h 3358"/>
                <a:gd name="T4" fmla="*/ 0 w 485"/>
                <a:gd name="T5" fmla="*/ 0 h 33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85" h="3358">
                  <a:moveTo>
                    <a:pt x="485" y="3358"/>
                  </a:moveTo>
                  <a:lnTo>
                    <a:pt x="0" y="3358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66" name="Freeform 146"/>
            <p:cNvSpPr>
              <a:spLocks/>
            </p:cNvSpPr>
            <p:nvPr/>
          </p:nvSpPr>
          <p:spPr bwMode="auto">
            <a:xfrm>
              <a:off x="595" y="1112"/>
              <a:ext cx="42" cy="80"/>
            </a:xfrm>
            <a:custGeom>
              <a:avLst/>
              <a:gdLst>
                <a:gd name="T0" fmla="*/ 349 w 349"/>
                <a:gd name="T1" fmla="*/ 0 h 496"/>
                <a:gd name="T2" fmla="*/ 0 w 349"/>
                <a:gd name="T3" fmla="*/ 0 h 496"/>
                <a:gd name="T4" fmla="*/ 0 w 349"/>
                <a:gd name="T5" fmla="*/ 496 h 4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9" h="496">
                  <a:moveTo>
                    <a:pt x="349" y="0"/>
                  </a:moveTo>
                  <a:lnTo>
                    <a:pt x="0" y="0"/>
                  </a:lnTo>
                  <a:lnTo>
                    <a:pt x="0" y="496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67" name="Freeform 147"/>
            <p:cNvSpPr>
              <a:spLocks/>
            </p:cNvSpPr>
            <p:nvPr/>
          </p:nvSpPr>
          <p:spPr bwMode="auto">
            <a:xfrm>
              <a:off x="2590" y="5229"/>
              <a:ext cx="248" cy="62"/>
            </a:xfrm>
            <a:custGeom>
              <a:avLst/>
              <a:gdLst>
                <a:gd name="T0" fmla="*/ 2026 w 2026"/>
                <a:gd name="T1" fmla="*/ 386 h 386"/>
                <a:gd name="T2" fmla="*/ 0 w 2026"/>
                <a:gd name="T3" fmla="*/ 386 h 386"/>
                <a:gd name="T4" fmla="*/ 0 w 2026"/>
                <a:gd name="T5" fmla="*/ 0 h 3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26" h="386">
                  <a:moveTo>
                    <a:pt x="2026" y="386"/>
                  </a:moveTo>
                  <a:lnTo>
                    <a:pt x="0" y="386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68" name="Freeform 148"/>
            <p:cNvSpPr>
              <a:spLocks/>
            </p:cNvSpPr>
            <p:nvPr/>
          </p:nvSpPr>
          <p:spPr bwMode="auto">
            <a:xfrm>
              <a:off x="2693" y="1967"/>
              <a:ext cx="103" cy="62"/>
            </a:xfrm>
            <a:custGeom>
              <a:avLst/>
              <a:gdLst>
                <a:gd name="T0" fmla="*/ 839 w 839"/>
                <a:gd name="T1" fmla="*/ 386 h 386"/>
                <a:gd name="T2" fmla="*/ 0 w 839"/>
                <a:gd name="T3" fmla="*/ 386 h 386"/>
                <a:gd name="T4" fmla="*/ 0 w 839"/>
                <a:gd name="T5" fmla="*/ 0 h 3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39" h="386">
                  <a:moveTo>
                    <a:pt x="839" y="386"/>
                  </a:moveTo>
                  <a:lnTo>
                    <a:pt x="0" y="386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69" name="Freeform 149"/>
            <p:cNvSpPr>
              <a:spLocks/>
            </p:cNvSpPr>
            <p:nvPr/>
          </p:nvSpPr>
          <p:spPr bwMode="auto">
            <a:xfrm>
              <a:off x="2789" y="2258"/>
              <a:ext cx="447" cy="159"/>
            </a:xfrm>
            <a:custGeom>
              <a:avLst/>
              <a:gdLst>
                <a:gd name="T0" fmla="*/ 3657 w 3657"/>
                <a:gd name="T1" fmla="*/ 0 h 992"/>
                <a:gd name="T2" fmla="*/ 0 w 3657"/>
                <a:gd name="T3" fmla="*/ 0 h 992"/>
                <a:gd name="T4" fmla="*/ 0 w 3657"/>
                <a:gd name="T5" fmla="*/ 992 h 9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57" h="992">
                  <a:moveTo>
                    <a:pt x="3657" y="0"/>
                  </a:moveTo>
                  <a:lnTo>
                    <a:pt x="0" y="0"/>
                  </a:lnTo>
                  <a:lnTo>
                    <a:pt x="0" y="992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70" name="Freeform 150"/>
            <p:cNvSpPr>
              <a:spLocks/>
            </p:cNvSpPr>
            <p:nvPr/>
          </p:nvSpPr>
          <p:spPr bwMode="auto">
            <a:xfrm>
              <a:off x="1799" y="3422"/>
              <a:ext cx="107" cy="84"/>
            </a:xfrm>
            <a:custGeom>
              <a:avLst/>
              <a:gdLst>
                <a:gd name="T0" fmla="*/ 872 w 872"/>
                <a:gd name="T1" fmla="*/ 0 h 523"/>
                <a:gd name="T2" fmla="*/ 0 w 872"/>
                <a:gd name="T3" fmla="*/ 0 h 523"/>
                <a:gd name="T4" fmla="*/ 0 w 872"/>
                <a:gd name="T5" fmla="*/ 523 h 5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72" h="523">
                  <a:moveTo>
                    <a:pt x="872" y="0"/>
                  </a:moveTo>
                  <a:lnTo>
                    <a:pt x="0" y="0"/>
                  </a:lnTo>
                  <a:lnTo>
                    <a:pt x="0" y="523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71" name="Freeform 151"/>
            <p:cNvSpPr>
              <a:spLocks/>
            </p:cNvSpPr>
            <p:nvPr/>
          </p:nvSpPr>
          <p:spPr bwMode="auto">
            <a:xfrm>
              <a:off x="2885" y="1624"/>
              <a:ext cx="260" cy="35"/>
            </a:xfrm>
            <a:custGeom>
              <a:avLst/>
              <a:gdLst>
                <a:gd name="T0" fmla="*/ 2127 w 2127"/>
                <a:gd name="T1" fmla="*/ 0 h 220"/>
                <a:gd name="T2" fmla="*/ 0 w 2127"/>
                <a:gd name="T3" fmla="*/ 0 h 220"/>
                <a:gd name="T4" fmla="*/ 0 w 2127"/>
                <a:gd name="T5" fmla="*/ 220 h 2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27" h="220">
                  <a:moveTo>
                    <a:pt x="2127" y="0"/>
                  </a:moveTo>
                  <a:lnTo>
                    <a:pt x="0" y="0"/>
                  </a:lnTo>
                  <a:lnTo>
                    <a:pt x="0" y="22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72" name="Freeform 152"/>
            <p:cNvSpPr>
              <a:spLocks/>
            </p:cNvSpPr>
            <p:nvPr/>
          </p:nvSpPr>
          <p:spPr bwMode="auto">
            <a:xfrm>
              <a:off x="1298" y="4583"/>
              <a:ext cx="316" cy="562"/>
            </a:xfrm>
            <a:custGeom>
              <a:avLst/>
              <a:gdLst>
                <a:gd name="T0" fmla="*/ 2582 w 2582"/>
                <a:gd name="T1" fmla="*/ 3512 h 3512"/>
                <a:gd name="T2" fmla="*/ 0 w 2582"/>
                <a:gd name="T3" fmla="*/ 3512 h 3512"/>
                <a:gd name="T4" fmla="*/ 0 w 2582"/>
                <a:gd name="T5" fmla="*/ 0 h 35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82" h="3512">
                  <a:moveTo>
                    <a:pt x="2582" y="3512"/>
                  </a:moveTo>
                  <a:lnTo>
                    <a:pt x="0" y="3512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73" name="Freeform 153"/>
            <p:cNvSpPr>
              <a:spLocks/>
            </p:cNvSpPr>
            <p:nvPr/>
          </p:nvSpPr>
          <p:spPr bwMode="auto">
            <a:xfrm>
              <a:off x="493" y="460"/>
              <a:ext cx="181" cy="176"/>
            </a:xfrm>
            <a:custGeom>
              <a:avLst/>
              <a:gdLst>
                <a:gd name="T0" fmla="*/ 1477 w 1477"/>
                <a:gd name="T1" fmla="*/ 0 h 1102"/>
                <a:gd name="T2" fmla="*/ 0 w 1477"/>
                <a:gd name="T3" fmla="*/ 0 h 1102"/>
                <a:gd name="T4" fmla="*/ 0 w 1477"/>
                <a:gd name="T5" fmla="*/ 1102 h 11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77" h="1102">
                  <a:moveTo>
                    <a:pt x="1477" y="0"/>
                  </a:moveTo>
                  <a:lnTo>
                    <a:pt x="0" y="0"/>
                  </a:lnTo>
                  <a:lnTo>
                    <a:pt x="0" y="1102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74" name="Freeform 154"/>
            <p:cNvSpPr>
              <a:spLocks/>
            </p:cNvSpPr>
            <p:nvPr/>
          </p:nvSpPr>
          <p:spPr bwMode="auto">
            <a:xfrm>
              <a:off x="2624" y="5679"/>
              <a:ext cx="292" cy="35"/>
            </a:xfrm>
            <a:custGeom>
              <a:avLst/>
              <a:gdLst>
                <a:gd name="T0" fmla="*/ 2390 w 2390"/>
                <a:gd name="T1" fmla="*/ 221 h 221"/>
                <a:gd name="T2" fmla="*/ 0 w 2390"/>
                <a:gd name="T3" fmla="*/ 221 h 221"/>
                <a:gd name="T4" fmla="*/ 0 w 2390"/>
                <a:gd name="T5" fmla="*/ 0 h 2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90" h="221">
                  <a:moveTo>
                    <a:pt x="2390" y="221"/>
                  </a:moveTo>
                  <a:lnTo>
                    <a:pt x="0" y="221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75" name="Freeform 155"/>
            <p:cNvSpPr>
              <a:spLocks/>
            </p:cNvSpPr>
            <p:nvPr/>
          </p:nvSpPr>
          <p:spPr bwMode="auto">
            <a:xfrm>
              <a:off x="440" y="1004"/>
              <a:ext cx="72" cy="86"/>
            </a:xfrm>
            <a:custGeom>
              <a:avLst/>
              <a:gdLst>
                <a:gd name="T0" fmla="*/ 586 w 586"/>
                <a:gd name="T1" fmla="*/ 538 h 538"/>
                <a:gd name="T2" fmla="*/ 0 w 586"/>
                <a:gd name="T3" fmla="*/ 538 h 538"/>
                <a:gd name="T4" fmla="*/ 0 w 586"/>
                <a:gd name="T5" fmla="*/ 0 h 5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86" h="538">
                  <a:moveTo>
                    <a:pt x="586" y="538"/>
                  </a:moveTo>
                  <a:lnTo>
                    <a:pt x="0" y="538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76" name="Freeform 156"/>
            <p:cNvSpPr>
              <a:spLocks/>
            </p:cNvSpPr>
            <p:nvPr/>
          </p:nvSpPr>
          <p:spPr bwMode="auto">
            <a:xfrm>
              <a:off x="512" y="989"/>
              <a:ext cx="306" cy="101"/>
            </a:xfrm>
            <a:custGeom>
              <a:avLst/>
              <a:gdLst>
                <a:gd name="T0" fmla="*/ 2502 w 2502"/>
                <a:gd name="T1" fmla="*/ 0 h 634"/>
                <a:gd name="T2" fmla="*/ 0 w 2502"/>
                <a:gd name="T3" fmla="*/ 0 h 634"/>
                <a:gd name="T4" fmla="*/ 0 w 2502"/>
                <a:gd name="T5" fmla="*/ 634 h 6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02" h="634">
                  <a:moveTo>
                    <a:pt x="2502" y="0"/>
                  </a:moveTo>
                  <a:lnTo>
                    <a:pt x="0" y="0"/>
                  </a:lnTo>
                  <a:lnTo>
                    <a:pt x="0" y="634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77" name="Freeform 157"/>
            <p:cNvSpPr>
              <a:spLocks/>
            </p:cNvSpPr>
            <p:nvPr/>
          </p:nvSpPr>
          <p:spPr bwMode="auto">
            <a:xfrm>
              <a:off x="595" y="1192"/>
              <a:ext cx="371" cy="79"/>
            </a:xfrm>
            <a:custGeom>
              <a:avLst/>
              <a:gdLst>
                <a:gd name="T0" fmla="*/ 3032 w 3032"/>
                <a:gd name="T1" fmla="*/ 496 h 496"/>
                <a:gd name="T2" fmla="*/ 0 w 3032"/>
                <a:gd name="T3" fmla="*/ 496 h 496"/>
                <a:gd name="T4" fmla="*/ 0 w 3032"/>
                <a:gd name="T5" fmla="*/ 0 h 4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32" h="496">
                  <a:moveTo>
                    <a:pt x="3032" y="496"/>
                  </a:moveTo>
                  <a:lnTo>
                    <a:pt x="0" y="496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78" name="Freeform 158"/>
            <p:cNvSpPr>
              <a:spLocks/>
            </p:cNvSpPr>
            <p:nvPr/>
          </p:nvSpPr>
          <p:spPr bwMode="auto">
            <a:xfrm>
              <a:off x="2590" y="5167"/>
              <a:ext cx="144" cy="62"/>
            </a:xfrm>
            <a:custGeom>
              <a:avLst/>
              <a:gdLst>
                <a:gd name="T0" fmla="*/ 1179 w 1179"/>
                <a:gd name="T1" fmla="*/ 0 h 386"/>
                <a:gd name="T2" fmla="*/ 0 w 1179"/>
                <a:gd name="T3" fmla="*/ 0 h 386"/>
                <a:gd name="T4" fmla="*/ 0 w 1179"/>
                <a:gd name="T5" fmla="*/ 386 h 3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79" h="386">
                  <a:moveTo>
                    <a:pt x="1179" y="0"/>
                  </a:moveTo>
                  <a:lnTo>
                    <a:pt x="0" y="0"/>
                  </a:lnTo>
                  <a:lnTo>
                    <a:pt x="0" y="386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79" name="Freeform 159"/>
            <p:cNvSpPr>
              <a:spLocks/>
            </p:cNvSpPr>
            <p:nvPr/>
          </p:nvSpPr>
          <p:spPr bwMode="auto">
            <a:xfrm>
              <a:off x="2888" y="2082"/>
              <a:ext cx="205" cy="35"/>
            </a:xfrm>
            <a:custGeom>
              <a:avLst/>
              <a:gdLst>
                <a:gd name="T0" fmla="*/ 1671 w 1671"/>
                <a:gd name="T1" fmla="*/ 220 h 220"/>
                <a:gd name="T2" fmla="*/ 0 w 1671"/>
                <a:gd name="T3" fmla="*/ 220 h 220"/>
                <a:gd name="T4" fmla="*/ 0 w 1671"/>
                <a:gd name="T5" fmla="*/ 0 h 2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71" h="220">
                  <a:moveTo>
                    <a:pt x="1671" y="220"/>
                  </a:moveTo>
                  <a:lnTo>
                    <a:pt x="0" y="220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80" name="Freeform 160"/>
            <p:cNvSpPr>
              <a:spLocks/>
            </p:cNvSpPr>
            <p:nvPr/>
          </p:nvSpPr>
          <p:spPr bwMode="auto">
            <a:xfrm>
              <a:off x="2734" y="5167"/>
              <a:ext cx="304" cy="53"/>
            </a:xfrm>
            <a:custGeom>
              <a:avLst/>
              <a:gdLst>
                <a:gd name="T0" fmla="*/ 2484 w 2484"/>
                <a:gd name="T1" fmla="*/ 331 h 331"/>
                <a:gd name="T2" fmla="*/ 0 w 2484"/>
                <a:gd name="T3" fmla="*/ 331 h 331"/>
                <a:gd name="T4" fmla="*/ 0 w 2484"/>
                <a:gd name="T5" fmla="*/ 0 h 3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84" h="331">
                  <a:moveTo>
                    <a:pt x="2484" y="331"/>
                  </a:moveTo>
                  <a:lnTo>
                    <a:pt x="0" y="331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81" name="Freeform 161"/>
            <p:cNvSpPr>
              <a:spLocks/>
            </p:cNvSpPr>
            <p:nvPr/>
          </p:nvSpPr>
          <p:spPr bwMode="auto">
            <a:xfrm>
              <a:off x="440" y="918"/>
              <a:ext cx="403" cy="86"/>
            </a:xfrm>
            <a:custGeom>
              <a:avLst/>
              <a:gdLst>
                <a:gd name="T0" fmla="*/ 3293 w 3293"/>
                <a:gd name="T1" fmla="*/ 0 h 537"/>
                <a:gd name="T2" fmla="*/ 0 w 3293"/>
                <a:gd name="T3" fmla="*/ 0 h 537"/>
                <a:gd name="T4" fmla="*/ 0 w 3293"/>
                <a:gd name="T5" fmla="*/ 537 h 5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93" h="537">
                  <a:moveTo>
                    <a:pt x="3293" y="0"/>
                  </a:moveTo>
                  <a:lnTo>
                    <a:pt x="0" y="0"/>
                  </a:lnTo>
                  <a:lnTo>
                    <a:pt x="0" y="537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82" name="Freeform 162"/>
            <p:cNvSpPr>
              <a:spLocks/>
            </p:cNvSpPr>
            <p:nvPr/>
          </p:nvSpPr>
          <p:spPr bwMode="auto">
            <a:xfrm>
              <a:off x="2346" y="3598"/>
              <a:ext cx="0" cy="53"/>
            </a:xfrm>
            <a:custGeom>
              <a:avLst/>
              <a:gdLst>
                <a:gd name="T0" fmla="*/ 0 h 331"/>
                <a:gd name="T1" fmla="*/ 0 h 331"/>
                <a:gd name="T2" fmla="*/ 331 h 33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31">
                  <a:moveTo>
                    <a:pt x="0" y="0"/>
                  </a:moveTo>
                  <a:lnTo>
                    <a:pt x="0" y="0"/>
                  </a:lnTo>
                  <a:lnTo>
                    <a:pt x="0" y="331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83" name="Freeform 163"/>
            <p:cNvSpPr>
              <a:spLocks/>
            </p:cNvSpPr>
            <p:nvPr/>
          </p:nvSpPr>
          <p:spPr bwMode="auto">
            <a:xfrm>
              <a:off x="147" y="626"/>
              <a:ext cx="85" cy="2703"/>
            </a:xfrm>
            <a:custGeom>
              <a:avLst/>
              <a:gdLst>
                <a:gd name="T0" fmla="*/ 693 w 693"/>
                <a:gd name="T1" fmla="*/ 0 h 16898"/>
                <a:gd name="T2" fmla="*/ 0 w 693"/>
                <a:gd name="T3" fmla="*/ 0 h 16898"/>
                <a:gd name="T4" fmla="*/ 0 w 693"/>
                <a:gd name="T5" fmla="*/ 16898 h 168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93" h="16898">
                  <a:moveTo>
                    <a:pt x="693" y="0"/>
                  </a:moveTo>
                  <a:lnTo>
                    <a:pt x="0" y="0"/>
                  </a:lnTo>
                  <a:lnTo>
                    <a:pt x="0" y="16898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84" name="Freeform 164"/>
            <p:cNvSpPr>
              <a:spLocks/>
            </p:cNvSpPr>
            <p:nvPr/>
          </p:nvSpPr>
          <p:spPr bwMode="auto">
            <a:xfrm>
              <a:off x="637" y="1059"/>
              <a:ext cx="223" cy="53"/>
            </a:xfrm>
            <a:custGeom>
              <a:avLst/>
              <a:gdLst>
                <a:gd name="T0" fmla="*/ 1819 w 1819"/>
                <a:gd name="T1" fmla="*/ 0 h 331"/>
                <a:gd name="T2" fmla="*/ 0 w 1819"/>
                <a:gd name="T3" fmla="*/ 0 h 331"/>
                <a:gd name="T4" fmla="*/ 0 w 1819"/>
                <a:gd name="T5" fmla="*/ 331 h 3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19" h="331">
                  <a:moveTo>
                    <a:pt x="1819" y="0"/>
                  </a:moveTo>
                  <a:lnTo>
                    <a:pt x="0" y="0"/>
                  </a:lnTo>
                  <a:lnTo>
                    <a:pt x="0" y="331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85" name="Freeform 165"/>
            <p:cNvSpPr>
              <a:spLocks/>
            </p:cNvSpPr>
            <p:nvPr/>
          </p:nvSpPr>
          <p:spPr bwMode="auto">
            <a:xfrm>
              <a:off x="2796" y="1976"/>
              <a:ext cx="232" cy="53"/>
            </a:xfrm>
            <a:custGeom>
              <a:avLst/>
              <a:gdLst>
                <a:gd name="T0" fmla="*/ 1894 w 1894"/>
                <a:gd name="T1" fmla="*/ 0 h 331"/>
                <a:gd name="T2" fmla="*/ 0 w 1894"/>
                <a:gd name="T3" fmla="*/ 0 h 331"/>
                <a:gd name="T4" fmla="*/ 0 w 1894"/>
                <a:gd name="T5" fmla="*/ 331 h 3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94" h="331">
                  <a:moveTo>
                    <a:pt x="1894" y="0"/>
                  </a:moveTo>
                  <a:lnTo>
                    <a:pt x="0" y="0"/>
                  </a:lnTo>
                  <a:lnTo>
                    <a:pt x="0" y="331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86" name="Freeform 166"/>
            <p:cNvSpPr>
              <a:spLocks/>
            </p:cNvSpPr>
            <p:nvPr/>
          </p:nvSpPr>
          <p:spPr bwMode="auto">
            <a:xfrm>
              <a:off x="2429" y="2041"/>
              <a:ext cx="115" cy="206"/>
            </a:xfrm>
            <a:custGeom>
              <a:avLst/>
              <a:gdLst>
                <a:gd name="T0" fmla="*/ 936 w 936"/>
                <a:gd name="T1" fmla="*/ 1288 h 1288"/>
                <a:gd name="T2" fmla="*/ 0 w 936"/>
                <a:gd name="T3" fmla="*/ 1288 h 1288"/>
                <a:gd name="T4" fmla="*/ 0 w 936"/>
                <a:gd name="T5" fmla="*/ 0 h 12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36" h="1288">
                  <a:moveTo>
                    <a:pt x="936" y="1288"/>
                  </a:moveTo>
                  <a:lnTo>
                    <a:pt x="0" y="1288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87" name="Freeform 167"/>
            <p:cNvSpPr>
              <a:spLocks/>
            </p:cNvSpPr>
            <p:nvPr/>
          </p:nvSpPr>
          <p:spPr bwMode="auto">
            <a:xfrm>
              <a:off x="1689" y="3845"/>
              <a:ext cx="304" cy="35"/>
            </a:xfrm>
            <a:custGeom>
              <a:avLst/>
              <a:gdLst>
                <a:gd name="T0" fmla="*/ 2483 w 2483"/>
                <a:gd name="T1" fmla="*/ 220 h 220"/>
                <a:gd name="T2" fmla="*/ 0 w 2483"/>
                <a:gd name="T3" fmla="*/ 220 h 220"/>
                <a:gd name="T4" fmla="*/ 0 w 2483"/>
                <a:gd name="T5" fmla="*/ 0 h 2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83" h="220">
                  <a:moveTo>
                    <a:pt x="2483" y="220"/>
                  </a:moveTo>
                  <a:lnTo>
                    <a:pt x="0" y="220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88" name="Freeform 168"/>
            <p:cNvSpPr>
              <a:spLocks/>
            </p:cNvSpPr>
            <p:nvPr/>
          </p:nvSpPr>
          <p:spPr bwMode="auto">
            <a:xfrm>
              <a:off x="1437" y="3509"/>
              <a:ext cx="117" cy="193"/>
            </a:xfrm>
            <a:custGeom>
              <a:avLst/>
              <a:gdLst>
                <a:gd name="T0" fmla="*/ 956 w 956"/>
                <a:gd name="T1" fmla="*/ 1206 h 1206"/>
                <a:gd name="T2" fmla="*/ 0 w 956"/>
                <a:gd name="T3" fmla="*/ 1206 h 1206"/>
                <a:gd name="T4" fmla="*/ 0 w 956"/>
                <a:gd name="T5" fmla="*/ 0 h 12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56" h="1206">
                  <a:moveTo>
                    <a:pt x="956" y="1206"/>
                  </a:moveTo>
                  <a:lnTo>
                    <a:pt x="0" y="1206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89" name="Freeform 169"/>
            <p:cNvSpPr>
              <a:spLocks/>
            </p:cNvSpPr>
            <p:nvPr/>
          </p:nvSpPr>
          <p:spPr bwMode="auto">
            <a:xfrm>
              <a:off x="2544" y="2247"/>
              <a:ext cx="245" cy="170"/>
            </a:xfrm>
            <a:custGeom>
              <a:avLst/>
              <a:gdLst>
                <a:gd name="T0" fmla="*/ 2002 w 2002"/>
                <a:gd name="T1" fmla="*/ 1061 h 1061"/>
                <a:gd name="T2" fmla="*/ 0 w 2002"/>
                <a:gd name="T3" fmla="*/ 1061 h 1061"/>
                <a:gd name="T4" fmla="*/ 0 w 2002"/>
                <a:gd name="T5" fmla="*/ 0 h 10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02" h="1061">
                  <a:moveTo>
                    <a:pt x="2002" y="1061"/>
                  </a:moveTo>
                  <a:lnTo>
                    <a:pt x="0" y="1061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90" name="Freeform 170"/>
            <p:cNvSpPr>
              <a:spLocks/>
            </p:cNvSpPr>
            <p:nvPr/>
          </p:nvSpPr>
          <p:spPr bwMode="auto">
            <a:xfrm>
              <a:off x="397" y="1004"/>
              <a:ext cx="43" cy="579"/>
            </a:xfrm>
            <a:custGeom>
              <a:avLst/>
              <a:gdLst>
                <a:gd name="T0" fmla="*/ 357 w 357"/>
                <a:gd name="T1" fmla="*/ 0 h 3619"/>
                <a:gd name="T2" fmla="*/ 0 w 357"/>
                <a:gd name="T3" fmla="*/ 0 h 3619"/>
                <a:gd name="T4" fmla="*/ 0 w 357"/>
                <a:gd name="T5" fmla="*/ 3619 h 36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7" h="3619">
                  <a:moveTo>
                    <a:pt x="357" y="0"/>
                  </a:moveTo>
                  <a:lnTo>
                    <a:pt x="0" y="0"/>
                  </a:lnTo>
                  <a:lnTo>
                    <a:pt x="0" y="3619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91" name="Freeform 171"/>
            <p:cNvSpPr>
              <a:spLocks/>
            </p:cNvSpPr>
            <p:nvPr/>
          </p:nvSpPr>
          <p:spPr bwMode="auto">
            <a:xfrm>
              <a:off x="1640" y="3898"/>
              <a:ext cx="354" cy="53"/>
            </a:xfrm>
            <a:custGeom>
              <a:avLst/>
              <a:gdLst>
                <a:gd name="T0" fmla="*/ 2886 w 2886"/>
                <a:gd name="T1" fmla="*/ 331 h 331"/>
                <a:gd name="T2" fmla="*/ 0 w 2886"/>
                <a:gd name="T3" fmla="*/ 331 h 331"/>
                <a:gd name="T4" fmla="*/ 0 w 2886"/>
                <a:gd name="T5" fmla="*/ 0 h 3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86" h="331">
                  <a:moveTo>
                    <a:pt x="2886" y="331"/>
                  </a:moveTo>
                  <a:lnTo>
                    <a:pt x="0" y="331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92" name="Freeform 172"/>
            <p:cNvSpPr>
              <a:spLocks/>
            </p:cNvSpPr>
            <p:nvPr/>
          </p:nvSpPr>
          <p:spPr bwMode="auto">
            <a:xfrm>
              <a:off x="339" y="636"/>
              <a:ext cx="154" cy="474"/>
            </a:xfrm>
            <a:custGeom>
              <a:avLst/>
              <a:gdLst>
                <a:gd name="T0" fmla="*/ 1257 w 1257"/>
                <a:gd name="T1" fmla="*/ 0 h 2960"/>
                <a:gd name="T2" fmla="*/ 0 w 1257"/>
                <a:gd name="T3" fmla="*/ 0 h 2960"/>
                <a:gd name="T4" fmla="*/ 0 w 1257"/>
                <a:gd name="T5" fmla="*/ 2960 h 29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57" h="2960">
                  <a:moveTo>
                    <a:pt x="1257" y="0"/>
                  </a:moveTo>
                  <a:lnTo>
                    <a:pt x="0" y="0"/>
                  </a:lnTo>
                  <a:lnTo>
                    <a:pt x="0" y="296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93" name="Freeform 173"/>
            <p:cNvSpPr>
              <a:spLocks/>
            </p:cNvSpPr>
            <p:nvPr/>
          </p:nvSpPr>
          <p:spPr bwMode="auto">
            <a:xfrm>
              <a:off x="2346" y="3669"/>
              <a:ext cx="0" cy="35"/>
            </a:xfrm>
            <a:custGeom>
              <a:avLst/>
              <a:gdLst>
                <a:gd name="T0" fmla="*/ 0 h 221"/>
                <a:gd name="T1" fmla="*/ 0 h 221"/>
                <a:gd name="T2" fmla="*/ 221 h 22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21">
                  <a:moveTo>
                    <a:pt x="0" y="0"/>
                  </a:moveTo>
                  <a:lnTo>
                    <a:pt x="0" y="0"/>
                  </a:lnTo>
                  <a:lnTo>
                    <a:pt x="0" y="221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94" name="Freeform 174"/>
            <p:cNvSpPr>
              <a:spLocks/>
            </p:cNvSpPr>
            <p:nvPr/>
          </p:nvSpPr>
          <p:spPr bwMode="auto">
            <a:xfrm>
              <a:off x="2575" y="5573"/>
              <a:ext cx="193" cy="53"/>
            </a:xfrm>
            <a:custGeom>
              <a:avLst/>
              <a:gdLst>
                <a:gd name="T0" fmla="*/ 1577 w 1577"/>
                <a:gd name="T1" fmla="*/ 0 h 331"/>
                <a:gd name="T2" fmla="*/ 0 w 1577"/>
                <a:gd name="T3" fmla="*/ 0 h 331"/>
                <a:gd name="T4" fmla="*/ 0 w 1577"/>
                <a:gd name="T5" fmla="*/ 331 h 3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77" h="331">
                  <a:moveTo>
                    <a:pt x="1577" y="0"/>
                  </a:moveTo>
                  <a:lnTo>
                    <a:pt x="0" y="0"/>
                  </a:lnTo>
                  <a:lnTo>
                    <a:pt x="0" y="331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95" name="Freeform 175"/>
            <p:cNvSpPr>
              <a:spLocks/>
            </p:cNvSpPr>
            <p:nvPr/>
          </p:nvSpPr>
          <p:spPr bwMode="auto">
            <a:xfrm>
              <a:off x="2303" y="5890"/>
              <a:ext cx="369" cy="36"/>
            </a:xfrm>
            <a:custGeom>
              <a:avLst/>
              <a:gdLst>
                <a:gd name="T0" fmla="*/ 3018 w 3018"/>
                <a:gd name="T1" fmla="*/ 221 h 221"/>
                <a:gd name="T2" fmla="*/ 0 w 3018"/>
                <a:gd name="T3" fmla="*/ 221 h 221"/>
                <a:gd name="T4" fmla="*/ 0 w 3018"/>
                <a:gd name="T5" fmla="*/ 0 h 2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18" h="221">
                  <a:moveTo>
                    <a:pt x="3018" y="221"/>
                  </a:moveTo>
                  <a:lnTo>
                    <a:pt x="0" y="221"/>
                  </a:lnTo>
                  <a:lnTo>
                    <a:pt x="0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96" name="Freeform 176"/>
            <p:cNvSpPr>
              <a:spLocks/>
            </p:cNvSpPr>
            <p:nvPr/>
          </p:nvSpPr>
          <p:spPr bwMode="auto">
            <a:xfrm>
              <a:off x="1972" y="5432"/>
              <a:ext cx="399" cy="134"/>
            </a:xfrm>
            <a:custGeom>
              <a:avLst/>
              <a:gdLst>
                <a:gd name="T0" fmla="*/ 3257 w 3257"/>
                <a:gd name="T1" fmla="*/ 0 h 840"/>
                <a:gd name="T2" fmla="*/ 0 w 3257"/>
                <a:gd name="T3" fmla="*/ 0 h 840"/>
                <a:gd name="T4" fmla="*/ 0 w 3257"/>
                <a:gd name="T5" fmla="*/ 840 h 8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57" h="840">
                  <a:moveTo>
                    <a:pt x="3257" y="0"/>
                  </a:moveTo>
                  <a:lnTo>
                    <a:pt x="0" y="0"/>
                  </a:lnTo>
                  <a:lnTo>
                    <a:pt x="0" y="84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97" name="Freeform 177"/>
            <p:cNvSpPr>
              <a:spLocks/>
            </p:cNvSpPr>
            <p:nvPr/>
          </p:nvSpPr>
          <p:spPr bwMode="auto">
            <a:xfrm>
              <a:off x="1437" y="3316"/>
              <a:ext cx="542" cy="193"/>
            </a:xfrm>
            <a:custGeom>
              <a:avLst/>
              <a:gdLst>
                <a:gd name="T0" fmla="*/ 4428 w 4428"/>
                <a:gd name="T1" fmla="*/ 0 h 1206"/>
                <a:gd name="T2" fmla="*/ 0 w 4428"/>
                <a:gd name="T3" fmla="*/ 0 h 1206"/>
                <a:gd name="T4" fmla="*/ 0 w 4428"/>
                <a:gd name="T5" fmla="*/ 1206 h 12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428" h="1206">
                  <a:moveTo>
                    <a:pt x="4428" y="0"/>
                  </a:moveTo>
                  <a:lnTo>
                    <a:pt x="0" y="0"/>
                  </a:lnTo>
                  <a:lnTo>
                    <a:pt x="0" y="1206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98" name="Rectangle 178"/>
            <p:cNvSpPr>
              <a:spLocks noChangeArrowheads="1"/>
            </p:cNvSpPr>
            <p:nvPr/>
          </p:nvSpPr>
          <p:spPr bwMode="auto">
            <a:xfrm>
              <a:off x="2884" y="4079"/>
              <a:ext cx="38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dobe Devanagari" panose="02040503050201020203" pitchFamily="18" charset="0"/>
                </a:rPr>
                <a:t>Ce_Q7YWP5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99" name="Rectangle 179"/>
            <p:cNvSpPr>
              <a:spLocks noChangeArrowheads="1"/>
            </p:cNvSpPr>
            <p:nvPr/>
          </p:nvSpPr>
          <p:spPr bwMode="auto">
            <a:xfrm>
              <a:off x="3230" y="4221"/>
              <a:ext cx="69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dobe Devanagari" panose="02040503050201020203" pitchFamily="18" charset="0"/>
                </a:rPr>
                <a:t>Gp_GPLIN_000058100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00" name="Rectangle 180"/>
            <p:cNvSpPr>
              <a:spLocks noChangeArrowheads="1"/>
            </p:cNvSpPr>
            <p:nvPr/>
          </p:nvSpPr>
          <p:spPr bwMode="auto">
            <a:xfrm>
              <a:off x="2972" y="4503"/>
              <a:ext cx="72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dobe Devanagari" panose="02040503050201020203" pitchFamily="18" charset="0"/>
                </a:rPr>
                <a:t>Mi_Minc3s00046g02525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01" name="Rectangle 181"/>
            <p:cNvSpPr>
              <a:spLocks noChangeArrowheads="1"/>
            </p:cNvSpPr>
            <p:nvPr/>
          </p:nvSpPr>
          <p:spPr bwMode="auto">
            <a:xfrm>
              <a:off x="2864" y="1823"/>
              <a:ext cx="350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dobe Devanagari" panose="02040503050201020203" pitchFamily="18" charset="0"/>
                </a:rPr>
                <a:t>At_Q9SA98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02" name="Rectangle 182"/>
            <p:cNvSpPr>
              <a:spLocks noChangeArrowheads="1"/>
            </p:cNvSpPr>
            <p:nvPr/>
          </p:nvSpPr>
          <p:spPr bwMode="auto">
            <a:xfrm>
              <a:off x="797" y="765"/>
              <a:ext cx="40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dobe Devanagari" panose="02040503050201020203" pitchFamily="18" charset="0"/>
                </a:rPr>
                <a:t>Gr_g12013.t1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03" name="Rectangle 183"/>
            <p:cNvSpPr>
              <a:spLocks noChangeArrowheads="1"/>
            </p:cNvSpPr>
            <p:nvPr/>
          </p:nvSpPr>
          <p:spPr bwMode="auto">
            <a:xfrm>
              <a:off x="2972" y="4573"/>
              <a:ext cx="763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dobe Devanagari" panose="02040503050201020203" pitchFamily="18" charset="0"/>
                </a:rPr>
                <a:t>Mj_Mjav1s07141g046905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04" name="Rectangle 184"/>
            <p:cNvSpPr>
              <a:spLocks noChangeArrowheads="1"/>
            </p:cNvSpPr>
            <p:nvPr/>
          </p:nvSpPr>
          <p:spPr bwMode="auto">
            <a:xfrm>
              <a:off x="739" y="271"/>
              <a:ext cx="763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dobe Devanagari" panose="02040503050201020203" pitchFamily="18" charset="0"/>
                </a:rPr>
                <a:t>Mj_Mjav1s00555g007563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05" name="Rectangle 185"/>
            <p:cNvSpPr>
              <a:spLocks noChangeArrowheads="1"/>
            </p:cNvSpPr>
            <p:nvPr/>
          </p:nvSpPr>
          <p:spPr bwMode="auto">
            <a:xfrm>
              <a:off x="2646" y="5772"/>
              <a:ext cx="35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dobe Devanagari" panose="02040503050201020203" pitchFamily="18" charset="0"/>
                </a:rPr>
                <a:t>Ts_E5SCT1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06" name="Rectangle 186"/>
            <p:cNvSpPr>
              <a:spLocks noChangeArrowheads="1"/>
            </p:cNvSpPr>
            <p:nvPr/>
          </p:nvSpPr>
          <p:spPr bwMode="auto">
            <a:xfrm>
              <a:off x="2527" y="5490"/>
              <a:ext cx="401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dobe Devanagari" panose="02040503050201020203" pitchFamily="18" charset="0"/>
                </a:rPr>
                <a:t>Hs_Q9NXW9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07" name="Rectangle 187"/>
            <p:cNvSpPr>
              <a:spLocks noChangeArrowheads="1"/>
            </p:cNvSpPr>
            <p:nvPr/>
          </p:nvSpPr>
          <p:spPr bwMode="auto">
            <a:xfrm>
              <a:off x="3062" y="4009"/>
              <a:ext cx="329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dobe Devanagari" panose="02040503050201020203" pitchFamily="18" charset="0"/>
                </a:rPr>
                <a:t>Pf_Q8IJC4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08" name="Rectangle 188"/>
            <p:cNvSpPr>
              <a:spLocks noChangeArrowheads="1"/>
            </p:cNvSpPr>
            <p:nvPr/>
          </p:nvSpPr>
          <p:spPr bwMode="auto">
            <a:xfrm>
              <a:off x="739" y="342"/>
              <a:ext cx="72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dobe Devanagari" panose="02040503050201020203" pitchFamily="18" charset="0"/>
                </a:rPr>
                <a:t>Mi_Minc3s00059g03029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09" name="Rectangle 189"/>
            <p:cNvSpPr>
              <a:spLocks noChangeArrowheads="1"/>
            </p:cNvSpPr>
            <p:nvPr/>
          </p:nvSpPr>
          <p:spPr bwMode="auto">
            <a:xfrm>
              <a:off x="739" y="553"/>
              <a:ext cx="763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dobe Devanagari" panose="02040503050201020203" pitchFamily="18" charset="0"/>
                </a:rPr>
                <a:t>Mj_Mjav1s00839g010426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10" name="Rectangle 190"/>
            <p:cNvSpPr>
              <a:spLocks noChangeArrowheads="1"/>
            </p:cNvSpPr>
            <p:nvPr/>
          </p:nvSpPr>
          <p:spPr bwMode="auto">
            <a:xfrm>
              <a:off x="2830" y="1470"/>
              <a:ext cx="358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dobe Devanagari" panose="02040503050201020203" pitchFamily="18" charset="0"/>
                </a:rPr>
                <a:t>Bc_G2YA08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11" name="Rectangle 191"/>
            <p:cNvSpPr>
              <a:spLocks noChangeArrowheads="1"/>
            </p:cNvSpPr>
            <p:nvPr/>
          </p:nvSpPr>
          <p:spPr bwMode="auto">
            <a:xfrm>
              <a:off x="2850" y="5631"/>
              <a:ext cx="390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dobe Devanagari" panose="02040503050201020203" pitchFamily="18" charset="0"/>
                </a:rPr>
                <a:t>Dm_Q9VL81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12" name="Rectangle 192"/>
            <p:cNvSpPr>
              <a:spLocks noChangeArrowheads="1"/>
            </p:cNvSpPr>
            <p:nvPr/>
          </p:nvSpPr>
          <p:spPr bwMode="auto">
            <a:xfrm>
              <a:off x="1035" y="1329"/>
              <a:ext cx="35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dobe Devanagari" panose="02040503050201020203" pitchFamily="18" charset="0"/>
                </a:rPr>
                <a:t>Bc_G2XX18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13" name="Rectangle 193"/>
            <p:cNvSpPr>
              <a:spLocks noChangeArrowheads="1"/>
            </p:cNvSpPr>
            <p:nvPr/>
          </p:nvSpPr>
          <p:spPr bwMode="auto">
            <a:xfrm>
              <a:off x="2972" y="4855"/>
              <a:ext cx="763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dobe Devanagari" panose="02040503050201020203" pitchFamily="18" charset="0"/>
                </a:rPr>
                <a:t>Mj_Mjav1s20063g081974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14" name="Rectangle 194"/>
            <p:cNvSpPr>
              <a:spLocks noChangeArrowheads="1"/>
            </p:cNvSpPr>
            <p:nvPr/>
          </p:nvSpPr>
          <p:spPr bwMode="auto">
            <a:xfrm>
              <a:off x="2263" y="3374"/>
              <a:ext cx="36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dobe Devanagari" panose="02040503050201020203" pitchFamily="18" charset="0"/>
                </a:rPr>
                <a:t>Ce_Q9U3P9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15" name="Rectangle 195"/>
            <p:cNvSpPr>
              <a:spLocks noChangeArrowheads="1"/>
            </p:cNvSpPr>
            <p:nvPr/>
          </p:nvSpPr>
          <p:spPr bwMode="auto">
            <a:xfrm>
              <a:off x="739" y="624"/>
              <a:ext cx="788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dobe Devanagari" panose="02040503050201020203" pitchFamily="18" charset="0"/>
                </a:rPr>
                <a:t>Ma_Mare1s01181g020195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16" name="Rectangle 196"/>
            <p:cNvSpPr>
              <a:spLocks noChangeArrowheads="1"/>
            </p:cNvSpPr>
            <p:nvPr/>
          </p:nvSpPr>
          <p:spPr bwMode="auto">
            <a:xfrm>
              <a:off x="3126" y="2669"/>
              <a:ext cx="624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dobe Devanagari" panose="02040503050201020203" pitchFamily="18" charset="0"/>
                </a:rPr>
                <a:t>Mj_Mjav1s10852g060040</a:t>
              </a:r>
              <a:endParaRPr kumimoji="0" lang="fr-FR" altLang="fr-FR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17" name="Rectangle 197"/>
            <p:cNvSpPr>
              <a:spLocks noChangeArrowheads="1"/>
            </p:cNvSpPr>
            <p:nvPr/>
          </p:nvSpPr>
          <p:spPr bwMode="auto">
            <a:xfrm>
              <a:off x="3126" y="2739"/>
              <a:ext cx="72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dobe Devanagari" panose="02040503050201020203" pitchFamily="18" charset="0"/>
                </a:rPr>
                <a:t>Mi_Minc3s03688g34529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18" name="Rectangle 198"/>
            <p:cNvSpPr>
              <a:spLocks noChangeArrowheads="1"/>
            </p:cNvSpPr>
            <p:nvPr/>
          </p:nvSpPr>
          <p:spPr bwMode="auto">
            <a:xfrm>
              <a:off x="3126" y="2881"/>
              <a:ext cx="72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dobe Devanagari" panose="02040503050201020203" pitchFamily="18" charset="0"/>
                </a:rPr>
                <a:t>Mi_Minc3s01189g21540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19" name="Rectangle 199"/>
            <p:cNvSpPr>
              <a:spLocks noChangeArrowheads="1"/>
            </p:cNvSpPr>
            <p:nvPr/>
          </p:nvSpPr>
          <p:spPr bwMode="auto">
            <a:xfrm>
              <a:off x="2972" y="4362"/>
              <a:ext cx="734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dobe Devanagari" panose="02040503050201020203" pitchFamily="18" charset="0"/>
                </a:rPr>
                <a:t>Mh_Mhap1s0368g10670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20" name="Rectangle 200"/>
            <p:cNvSpPr>
              <a:spLocks noChangeArrowheads="1"/>
            </p:cNvSpPr>
            <p:nvPr/>
          </p:nvSpPr>
          <p:spPr bwMode="auto">
            <a:xfrm>
              <a:off x="1109" y="1399"/>
              <a:ext cx="379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dobe Devanagari" panose="02040503050201020203" pitchFamily="18" charset="0"/>
                </a:rPr>
                <a:t>Lm_E4ZK87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21" name="Rectangle 201"/>
            <p:cNvSpPr>
              <a:spLocks noChangeArrowheads="1"/>
            </p:cNvSpPr>
            <p:nvPr/>
          </p:nvSpPr>
          <p:spPr bwMode="auto">
            <a:xfrm>
              <a:off x="2358" y="3727"/>
              <a:ext cx="35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dobe Devanagari" panose="02040503050201020203" pitchFamily="18" charset="0"/>
                </a:rPr>
                <a:t>Ts_E5T2N3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22" name="Rectangle 202"/>
            <p:cNvSpPr>
              <a:spLocks noChangeArrowheads="1"/>
            </p:cNvSpPr>
            <p:nvPr/>
          </p:nvSpPr>
          <p:spPr bwMode="auto">
            <a:xfrm>
              <a:off x="797" y="835"/>
              <a:ext cx="69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dobe Devanagari" panose="02040503050201020203" pitchFamily="18" charset="0"/>
                </a:rPr>
                <a:t>Gp_GPLIN_001148200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23" name="Rectangle 203"/>
            <p:cNvSpPr>
              <a:spLocks noChangeArrowheads="1"/>
            </p:cNvSpPr>
            <p:nvPr/>
          </p:nvSpPr>
          <p:spPr bwMode="auto">
            <a:xfrm>
              <a:off x="3555" y="5137"/>
              <a:ext cx="380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dobe Devanagari" panose="02040503050201020203" pitchFamily="18" charset="0"/>
                </a:rPr>
                <a:t>Sm_G4LV61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24" name="Rectangle 204"/>
            <p:cNvSpPr>
              <a:spLocks noChangeArrowheads="1"/>
            </p:cNvSpPr>
            <p:nvPr/>
          </p:nvSpPr>
          <p:spPr bwMode="auto">
            <a:xfrm>
              <a:off x="3126" y="2598"/>
              <a:ext cx="788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dobe Devanagari" panose="02040503050201020203" pitchFamily="18" charset="0"/>
                </a:rPr>
                <a:t>Ma_Mare1s00563g011810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</p:grpSp>
      <p:sp>
        <p:nvSpPr>
          <p:cNvPr id="8" name="Rectangle 206"/>
          <p:cNvSpPr>
            <a:spLocks noChangeArrowheads="1"/>
          </p:cNvSpPr>
          <p:nvPr/>
        </p:nvSpPr>
        <p:spPr bwMode="auto">
          <a:xfrm>
            <a:off x="784225" y="9610726"/>
            <a:ext cx="604333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Ce_Ce_Q17527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9" name="Rectangle 207"/>
          <p:cNvSpPr>
            <a:spLocks noChangeArrowheads="1"/>
          </p:cNvSpPr>
          <p:nvPr/>
        </p:nvSpPr>
        <p:spPr bwMode="auto">
          <a:xfrm>
            <a:off x="4606925" y="2446338"/>
            <a:ext cx="60593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Lm_E5A5V6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" name="Rectangle 208"/>
          <p:cNvSpPr>
            <a:spLocks noChangeArrowheads="1"/>
          </p:cNvSpPr>
          <p:nvPr/>
        </p:nvSpPr>
        <p:spPr bwMode="auto">
          <a:xfrm>
            <a:off x="5051425" y="3676651"/>
            <a:ext cx="588303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Gr_g8563.t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1" name="Rectangle 209"/>
          <p:cNvSpPr>
            <a:spLocks noChangeArrowheads="1"/>
          </p:cNvSpPr>
          <p:nvPr/>
        </p:nvSpPr>
        <p:spPr bwMode="auto">
          <a:xfrm>
            <a:off x="4524375" y="8378826"/>
            <a:ext cx="860813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Am_A0A087ZYC3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2" name="Rectangle 210"/>
          <p:cNvSpPr>
            <a:spLocks noChangeArrowheads="1"/>
          </p:cNvSpPr>
          <p:nvPr/>
        </p:nvSpPr>
        <p:spPr bwMode="auto">
          <a:xfrm>
            <a:off x="4718050" y="7483476"/>
            <a:ext cx="125034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Ma_Mare1s00753g014659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3" name="Rectangle 211"/>
          <p:cNvSpPr>
            <a:spLocks noChangeArrowheads="1"/>
          </p:cNvSpPr>
          <p:nvPr/>
        </p:nvSpPr>
        <p:spPr bwMode="auto">
          <a:xfrm>
            <a:off x="4656138" y="8491538"/>
            <a:ext cx="53700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Ap_J9JS50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4" name="Rectangle 212"/>
          <p:cNvSpPr>
            <a:spLocks noChangeArrowheads="1"/>
          </p:cNvSpPr>
          <p:nvPr/>
        </p:nvSpPr>
        <p:spPr bwMode="auto">
          <a:xfrm>
            <a:off x="3409950" y="5580063"/>
            <a:ext cx="59792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As_U1NH08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5" name="Rectangle 213"/>
          <p:cNvSpPr>
            <a:spLocks noChangeArrowheads="1"/>
          </p:cNvSpPr>
          <p:nvPr/>
        </p:nvSpPr>
        <p:spPr bwMode="auto">
          <a:xfrm>
            <a:off x="1173163" y="766763"/>
            <a:ext cx="12118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Mj_Mjav1s06782g045418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6" name="Rectangle 214"/>
          <p:cNvSpPr>
            <a:spLocks noChangeArrowheads="1"/>
          </p:cNvSpPr>
          <p:nvPr/>
        </p:nvSpPr>
        <p:spPr bwMode="auto">
          <a:xfrm>
            <a:off x="5157788" y="3565526"/>
            <a:ext cx="588303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Ce_E0DBL0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7" name="Rectangle 215"/>
          <p:cNvSpPr>
            <a:spLocks noChangeArrowheads="1"/>
          </p:cNvSpPr>
          <p:nvPr/>
        </p:nvSpPr>
        <p:spPr bwMode="auto">
          <a:xfrm>
            <a:off x="4930775" y="3228976"/>
            <a:ext cx="583493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Ap_J9JMY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8" name="Rectangle 216"/>
          <p:cNvSpPr>
            <a:spLocks noChangeArrowheads="1"/>
          </p:cNvSpPr>
          <p:nvPr/>
        </p:nvSpPr>
        <p:spPr bwMode="auto">
          <a:xfrm>
            <a:off x="1544638" y="1773238"/>
            <a:ext cx="84798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Am_A0A088AIQ9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9" name="Rectangle 217"/>
          <p:cNvSpPr>
            <a:spLocks noChangeArrowheads="1"/>
          </p:cNvSpPr>
          <p:nvPr/>
        </p:nvSpPr>
        <p:spPr bwMode="auto">
          <a:xfrm>
            <a:off x="1666875" y="1885951"/>
            <a:ext cx="57066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Ap_J9JXU0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0" name="Rectangle 218"/>
          <p:cNvSpPr>
            <a:spLocks noChangeArrowheads="1"/>
          </p:cNvSpPr>
          <p:nvPr/>
        </p:nvSpPr>
        <p:spPr bwMode="auto">
          <a:xfrm>
            <a:off x="4519613" y="6588126"/>
            <a:ext cx="60914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As_U1N8M7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1" name="Rectangle 219"/>
          <p:cNvSpPr>
            <a:spLocks noChangeArrowheads="1"/>
          </p:cNvSpPr>
          <p:nvPr/>
        </p:nvSpPr>
        <p:spPr bwMode="auto">
          <a:xfrm>
            <a:off x="4962525" y="3900488"/>
            <a:ext cx="99065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Mj_Mjav1s19213g080347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2" name="Rectangle 220"/>
          <p:cNvSpPr>
            <a:spLocks noChangeArrowheads="1"/>
          </p:cNvSpPr>
          <p:nvPr/>
        </p:nvSpPr>
        <p:spPr bwMode="auto">
          <a:xfrm>
            <a:off x="5011738" y="2557463"/>
            <a:ext cx="615553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Lm_E4ZYQ4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3" name="Rectangle 221"/>
          <p:cNvSpPr>
            <a:spLocks noChangeArrowheads="1"/>
          </p:cNvSpPr>
          <p:nvPr/>
        </p:nvSpPr>
        <p:spPr bwMode="auto">
          <a:xfrm>
            <a:off x="4324350" y="2781301"/>
            <a:ext cx="54341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Sp_O60066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4" name="Rectangle 222"/>
          <p:cNvSpPr>
            <a:spLocks noChangeArrowheads="1"/>
          </p:cNvSpPr>
          <p:nvPr/>
        </p:nvSpPr>
        <p:spPr bwMode="auto">
          <a:xfrm>
            <a:off x="4648200" y="9051926"/>
            <a:ext cx="88004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Am_A0A088AJM4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5" name="Rectangle 223"/>
          <p:cNvSpPr>
            <a:spLocks noChangeArrowheads="1"/>
          </p:cNvSpPr>
          <p:nvPr/>
        </p:nvSpPr>
        <p:spPr bwMode="auto">
          <a:xfrm>
            <a:off x="4962525" y="4908551"/>
            <a:ext cx="115256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Mi_Minc3s00266g08980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6" name="Rectangle 224"/>
          <p:cNvSpPr>
            <a:spLocks noChangeArrowheads="1"/>
          </p:cNvSpPr>
          <p:nvPr/>
        </p:nvSpPr>
        <p:spPr bwMode="auto">
          <a:xfrm>
            <a:off x="4962525" y="3789363"/>
            <a:ext cx="116538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Mh_Mhap1s0149g07006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7" name="Rectangle 225"/>
          <p:cNvSpPr>
            <a:spLocks noChangeArrowheads="1"/>
          </p:cNvSpPr>
          <p:nvPr/>
        </p:nvSpPr>
        <p:spPr bwMode="auto">
          <a:xfrm>
            <a:off x="4962525" y="4460876"/>
            <a:ext cx="125034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Ma_Mare1s02006g029182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8" name="Rectangle 226"/>
          <p:cNvSpPr>
            <a:spLocks noChangeArrowheads="1"/>
          </p:cNvSpPr>
          <p:nvPr/>
        </p:nvSpPr>
        <p:spPr bwMode="auto">
          <a:xfrm>
            <a:off x="1317625" y="1549401"/>
            <a:ext cx="60753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Hs_Q3KRA9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29" name="Rectangle 227"/>
          <p:cNvSpPr>
            <a:spLocks noChangeArrowheads="1"/>
          </p:cNvSpPr>
          <p:nvPr/>
        </p:nvSpPr>
        <p:spPr bwMode="auto">
          <a:xfrm>
            <a:off x="5497513" y="2970466"/>
            <a:ext cx="67326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Sm_G4LWW8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30" name="Rectangle 228"/>
          <p:cNvSpPr>
            <a:spLocks noChangeArrowheads="1"/>
          </p:cNvSpPr>
          <p:nvPr/>
        </p:nvSpPr>
        <p:spPr bwMode="auto">
          <a:xfrm>
            <a:off x="4718050" y="7596188"/>
            <a:ext cx="12118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Mj_Mjav1s04847g036617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31" name="Rectangle 229"/>
          <p:cNvSpPr>
            <a:spLocks noChangeArrowheads="1"/>
          </p:cNvSpPr>
          <p:nvPr/>
        </p:nvSpPr>
        <p:spPr bwMode="auto">
          <a:xfrm>
            <a:off x="5345113" y="8043863"/>
            <a:ext cx="57547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Sm_G4LZI6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32" name="Rectangle 230"/>
          <p:cNvSpPr>
            <a:spLocks noChangeArrowheads="1"/>
          </p:cNvSpPr>
          <p:nvPr/>
        </p:nvSpPr>
        <p:spPr bwMode="auto">
          <a:xfrm>
            <a:off x="1552575" y="1997076"/>
            <a:ext cx="61715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Sm_C4QU63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33" name="Rectangle 231"/>
          <p:cNvSpPr>
            <a:spLocks noChangeArrowheads="1"/>
          </p:cNvSpPr>
          <p:nvPr/>
        </p:nvSpPr>
        <p:spPr bwMode="auto">
          <a:xfrm>
            <a:off x="5127625" y="6811963"/>
            <a:ext cx="588303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Gr_g5876.t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34" name="Rectangle 232"/>
          <p:cNvSpPr>
            <a:spLocks noChangeArrowheads="1"/>
          </p:cNvSpPr>
          <p:nvPr/>
        </p:nvSpPr>
        <p:spPr bwMode="auto">
          <a:xfrm>
            <a:off x="4348163" y="7931151"/>
            <a:ext cx="62998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Dm_Q9VTP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35" name="Rectangle 233"/>
          <p:cNvSpPr>
            <a:spLocks noChangeArrowheads="1"/>
          </p:cNvSpPr>
          <p:nvPr/>
        </p:nvSpPr>
        <p:spPr bwMode="auto">
          <a:xfrm>
            <a:off x="4929188" y="3341688"/>
            <a:ext cx="85279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Am_A0A088AP16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36" name="Rectangle 234"/>
          <p:cNvSpPr>
            <a:spLocks noChangeArrowheads="1"/>
          </p:cNvSpPr>
          <p:nvPr/>
        </p:nvSpPr>
        <p:spPr bwMode="auto">
          <a:xfrm>
            <a:off x="4962525" y="4684713"/>
            <a:ext cx="125034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Ma_Mare1s00499g010760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37" name="Rectangle 235"/>
          <p:cNvSpPr>
            <a:spLocks noChangeArrowheads="1"/>
          </p:cNvSpPr>
          <p:nvPr/>
        </p:nvSpPr>
        <p:spPr bwMode="auto">
          <a:xfrm>
            <a:off x="4841875" y="8267701"/>
            <a:ext cx="58028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Hs_Q9BT30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38" name="Rectangle 236"/>
          <p:cNvSpPr>
            <a:spLocks noChangeArrowheads="1"/>
          </p:cNvSpPr>
          <p:nvPr/>
        </p:nvSpPr>
        <p:spPr bwMode="auto">
          <a:xfrm>
            <a:off x="4814888" y="2670176"/>
            <a:ext cx="56425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Bc_G2XT34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39" name="Rectangle 237"/>
          <p:cNvSpPr>
            <a:spLocks noChangeArrowheads="1"/>
          </p:cNvSpPr>
          <p:nvPr/>
        </p:nvSpPr>
        <p:spPr bwMode="auto">
          <a:xfrm>
            <a:off x="3568700" y="5468938"/>
            <a:ext cx="53059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Gr_g601.t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40" name="Rectangle 238"/>
          <p:cNvSpPr>
            <a:spLocks noChangeArrowheads="1"/>
          </p:cNvSpPr>
          <p:nvPr/>
        </p:nvSpPr>
        <p:spPr bwMode="auto">
          <a:xfrm>
            <a:off x="1358900" y="1438276"/>
            <a:ext cx="57708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At_Q9SUP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41" name="Rectangle 239"/>
          <p:cNvSpPr>
            <a:spLocks noChangeArrowheads="1"/>
          </p:cNvSpPr>
          <p:nvPr/>
        </p:nvSpPr>
        <p:spPr bwMode="auto">
          <a:xfrm>
            <a:off x="4962525" y="4013201"/>
            <a:ext cx="12118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Mj_Mjav1s19213g080346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42" name="Rectangle 240"/>
          <p:cNvSpPr>
            <a:spLocks noChangeArrowheads="1"/>
          </p:cNvSpPr>
          <p:nvPr/>
        </p:nvSpPr>
        <p:spPr bwMode="auto">
          <a:xfrm>
            <a:off x="3743325" y="5692776"/>
            <a:ext cx="55784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Ts_E5T7R2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43" name="Rectangle 241"/>
          <p:cNvSpPr>
            <a:spLocks noChangeArrowheads="1"/>
          </p:cNvSpPr>
          <p:nvPr/>
        </p:nvSpPr>
        <p:spPr bwMode="auto">
          <a:xfrm>
            <a:off x="1384300" y="1662113"/>
            <a:ext cx="65562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Dm_Q9VKU5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44" name="Rectangle 242"/>
          <p:cNvSpPr>
            <a:spLocks noChangeArrowheads="1"/>
          </p:cNvSpPr>
          <p:nvPr/>
        </p:nvSpPr>
        <p:spPr bwMode="auto">
          <a:xfrm>
            <a:off x="4826000" y="3117851"/>
            <a:ext cx="64440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Dm_Q7KUZ2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45" name="Rectangle 243"/>
          <p:cNvSpPr>
            <a:spLocks noChangeArrowheads="1"/>
          </p:cNvSpPr>
          <p:nvPr/>
        </p:nvSpPr>
        <p:spPr bwMode="auto">
          <a:xfrm>
            <a:off x="1173163" y="319088"/>
            <a:ext cx="115256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Mi_Minc3s00931g19005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46" name="Rectangle 244"/>
          <p:cNvSpPr>
            <a:spLocks noChangeArrowheads="1"/>
          </p:cNvSpPr>
          <p:nvPr/>
        </p:nvSpPr>
        <p:spPr bwMode="auto">
          <a:xfrm>
            <a:off x="1173163" y="654051"/>
            <a:ext cx="101470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Ma_Mare1s00675g013507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47" name="Rectangle 245"/>
          <p:cNvSpPr>
            <a:spLocks noChangeArrowheads="1"/>
          </p:cNvSpPr>
          <p:nvPr/>
        </p:nvSpPr>
        <p:spPr bwMode="auto">
          <a:xfrm>
            <a:off x="1173163" y="1101726"/>
            <a:ext cx="125034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Ma_Mare1s07138g062010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48" name="Rectangle 246"/>
          <p:cNvSpPr>
            <a:spLocks noChangeArrowheads="1"/>
          </p:cNvSpPr>
          <p:nvPr/>
        </p:nvSpPr>
        <p:spPr bwMode="auto">
          <a:xfrm>
            <a:off x="4718050" y="7372351"/>
            <a:ext cx="115256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Mi_Minc3s01928g27264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49" name="Rectangle 247"/>
          <p:cNvSpPr>
            <a:spLocks noChangeArrowheads="1"/>
          </p:cNvSpPr>
          <p:nvPr/>
        </p:nvSpPr>
        <p:spPr bwMode="auto">
          <a:xfrm>
            <a:off x="4718050" y="7035801"/>
            <a:ext cx="125034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Ma_Mare1s04883g050812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50" name="Rectangle 248"/>
          <p:cNvSpPr>
            <a:spLocks noChangeArrowheads="1"/>
          </p:cNvSpPr>
          <p:nvPr/>
        </p:nvSpPr>
        <p:spPr bwMode="auto">
          <a:xfrm>
            <a:off x="1487488" y="206376"/>
            <a:ext cx="56906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Ts_E5SCB2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51" name="Rectangle 249"/>
          <p:cNvSpPr>
            <a:spLocks noChangeArrowheads="1"/>
          </p:cNvSpPr>
          <p:nvPr/>
        </p:nvSpPr>
        <p:spPr bwMode="auto">
          <a:xfrm>
            <a:off x="3182938" y="6140451"/>
            <a:ext cx="58028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Hs_Q96BT7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52" name="Rectangle 250"/>
          <p:cNvSpPr>
            <a:spLocks noChangeArrowheads="1"/>
          </p:cNvSpPr>
          <p:nvPr/>
        </p:nvSpPr>
        <p:spPr bwMode="auto">
          <a:xfrm>
            <a:off x="4773613" y="3452813"/>
            <a:ext cx="55303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Hs_Q13686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53" name="Rectangle 251"/>
          <p:cNvSpPr>
            <a:spLocks noChangeArrowheads="1"/>
          </p:cNvSpPr>
          <p:nvPr/>
        </p:nvSpPr>
        <p:spPr bwMode="auto">
          <a:xfrm>
            <a:off x="4962525" y="4797426"/>
            <a:ext cx="12118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Mj_Mjav1s16308g074302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54" name="Rectangle 252"/>
          <p:cNvSpPr>
            <a:spLocks noChangeArrowheads="1"/>
          </p:cNvSpPr>
          <p:nvPr/>
        </p:nvSpPr>
        <p:spPr bwMode="auto">
          <a:xfrm>
            <a:off x="3222625" y="6027738"/>
            <a:ext cx="85600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Am_A0A088A8Y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55" name="Rectangle 253"/>
          <p:cNvSpPr>
            <a:spLocks noChangeArrowheads="1"/>
          </p:cNvSpPr>
          <p:nvPr/>
        </p:nvSpPr>
        <p:spPr bwMode="auto">
          <a:xfrm>
            <a:off x="4306888" y="9275763"/>
            <a:ext cx="65402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Ce_Q8MNT9</a:t>
            </a:r>
            <a:endParaRPr kumimoji="0" lang="fr-FR" altLang="fr-FR" sz="8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56" name="Rectangle 254"/>
          <p:cNvSpPr>
            <a:spLocks noChangeArrowheads="1"/>
          </p:cNvSpPr>
          <p:nvPr/>
        </p:nvSpPr>
        <p:spPr bwMode="auto">
          <a:xfrm>
            <a:off x="5778500" y="9499601"/>
            <a:ext cx="54983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At_Q94A09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57" name="Rectangle 255"/>
          <p:cNvSpPr>
            <a:spLocks noChangeArrowheads="1"/>
          </p:cNvSpPr>
          <p:nvPr/>
        </p:nvSpPr>
        <p:spPr bwMode="auto">
          <a:xfrm>
            <a:off x="4962525" y="5021263"/>
            <a:ext cx="125034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Ma_Mare1s00499g010762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58" name="Rectangle 256"/>
          <p:cNvSpPr>
            <a:spLocks noChangeArrowheads="1"/>
          </p:cNvSpPr>
          <p:nvPr/>
        </p:nvSpPr>
        <p:spPr bwMode="auto">
          <a:xfrm>
            <a:off x="3184525" y="6251576"/>
            <a:ext cx="63478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Dm_Q9W232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59" name="Rectangle 257"/>
          <p:cNvSpPr>
            <a:spLocks noChangeArrowheads="1"/>
          </p:cNvSpPr>
          <p:nvPr/>
        </p:nvSpPr>
        <p:spPr bwMode="auto">
          <a:xfrm>
            <a:off x="4718050" y="7820026"/>
            <a:ext cx="125034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Ma_Mare1s19422g093799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0" name="Rectangle 258"/>
          <p:cNvSpPr>
            <a:spLocks noChangeArrowheads="1"/>
          </p:cNvSpPr>
          <p:nvPr/>
        </p:nvSpPr>
        <p:spPr bwMode="auto">
          <a:xfrm>
            <a:off x="3743325" y="5803901"/>
            <a:ext cx="55944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Ts_E5SPP6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1" name="Rectangle 259"/>
          <p:cNvSpPr>
            <a:spLocks noChangeArrowheads="1"/>
          </p:cNvSpPr>
          <p:nvPr/>
        </p:nvSpPr>
        <p:spPr bwMode="auto">
          <a:xfrm>
            <a:off x="4413250" y="8828088"/>
            <a:ext cx="55784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Ap_J9K6Z3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2" name="Rectangle 260"/>
          <p:cNvSpPr>
            <a:spLocks noChangeArrowheads="1"/>
          </p:cNvSpPr>
          <p:nvPr/>
        </p:nvSpPr>
        <p:spPr bwMode="auto">
          <a:xfrm>
            <a:off x="3783013" y="8602663"/>
            <a:ext cx="61395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Sm_C4QTP7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3" name="Rectangle 261"/>
          <p:cNvSpPr>
            <a:spLocks noChangeArrowheads="1"/>
          </p:cNvSpPr>
          <p:nvPr/>
        </p:nvSpPr>
        <p:spPr bwMode="auto">
          <a:xfrm>
            <a:off x="4262438" y="9386888"/>
            <a:ext cx="11044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Gp_GPLIN_000727000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4" name="Rectangle 262"/>
          <p:cNvSpPr>
            <a:spLocks noChangeArrowheads="1"/>
          </p:cNvSpPr>
          <p:nvPr/>
        </p:nvSpPr>
        <p:spPr bwMode="auto">
          <a:xfrm>
            <a:off x="4962525" y="5132388"/>
            <a:ext cx="12118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Mj_Mjav1s08702g052984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5" name="Rectangle 263"/>
          <p:cNvSpPr>
            <a:spLocks noChangeArrowheads="1"/>
          </p:cNvSpPr>
          <p:nvPr/>
        </p:nvSpPr>
        <p:spPr bwMode="auto">
          <a:xfrm>
            <a:off x="3160713" y="5245101"/>
            <a:ext cx="60753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At_Q8RWY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6" name="Rectangle 264"/>
          <p:cNvSpPr>
            <a:spLocks noChangeArrowheads="1"/>
          </p:cNvSpPr>
          <p:nvPr/>
        </p:nvSpPr>
        <p:spPr bwMode="auto">
          <a:xfrm>
            <a:off x="2493169" y="6092032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61993D"/>
                </a:solidFill>
                <a:effectLst/>
                <a:latin typeface="Adobe Devanagari" panose="02040503050201020203" pitchFamily="18" charset="0"/>
              </a:rPr>
              <a:t>32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7" name="Rectangle 265"/>
          <p:cNvSpPr>
            <a:spLocks noChangeArrowheads="1"/>
          </p:cNvSpPr>
          <p:nvPr/>
        </p:nvSpPr>
        <p:spPr bwMode="auto">
          <a:xfrm>
            <a:off x="3987800" y="8835231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993D7D"/>
                </a:solidFill>
                <a:effectLst/>
                <a:latin typeface="Adobe Devanagari" panose="02040503050201020203" pitchFamily="18" charset="0"/>
              </a:rPr>
              <a:t>96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8" name="Rectangle 266"/>
          <p:cNvSpPr>
            <a:spLocks noChangeArrowheads="1"/>
          </p:cNvSpPr>
          <p:nvPr/>
        </p:nvSpPr>
        <p:spPr bwMode="auto">
          <a:xfrm>
            <a:off x="5110163" y="8016876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CC526E"/>
                </a:solidFill>
                <a:effectLst/>
                <a:latin typeface="Adobe Devanagari" panose="02040503050201020203" pitchFamily="18" charset="0"/>
              </a:rPr>
              <a:t>99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9" name="Rectangle 267"/>
          <p:cNvSpPr>
            <a:spLocks noChangeArrowheads="1"/>
          </p:cNvSpPr>
          <p:nvPr/>
        </p:nvSpPr>
        <p:spPr bwMode="auto">
          <a:xfrm>
            <a:off x="4021138" y="8201819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8B993D"/>
                </a:solidFill>
                <a:effectLst/>
                <a:latin typeface="Adobe Devanagari" panose="02040503050201020203" pitchFamily="18" charset="0"/>
              </a:rPr>
              <a:t>25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70" name="Rectangle 268"/>
          <p:cNvSpPr>
            <a:spLocks noChangeArrowheads="1"/>
          </p:cNvSpPr>
          <p:nvPr/>
        </p:nvSpPr>
        <p:spPr bwMode="auto">
          <a:xfrm>
            <a:off x="3652837" y="5857876"/>
            <a:ext cx="13946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993D52"/>
                </a:solidFill>
                <a:effectLst/>
                <a:latin typeface="Adobe Devanagari" panose="02040503050201020203" pitchFamily="18" charset="0"/>
              </a:rPr>
              <a:t>100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71" name="Rectangle 269"/>
          <p:cNvSpPr>
            <a:spLocks noChangeArrowheads="1"/>
          </p:cNvSpPr>
          <p:nvPr/>
        </p:nvSpPr>
        <p:spPr bwMode="auto">
          <a:xfrm>
            <a:off x="3158332" y="8954294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81CC52"/>
                </a:solidFill>
                <a:effectLst/>
                <a:latin typeface="Adobe Devanagari" panose="02040503050201020203" pitchFamily="18" charset="0"/>
              </a:rPr>
              <a:t>28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72" name="Rectangle 270"/>
          <p:cNvSpPr>
            <a:spLocks noChangeArrowheads="1"/>
          </p:cNvSpPr>
          <p:nvPr/>
        </p:nvSpPr>
        <p:spPr bwMode="auto">
          <a:xfrm>
            <a:off x="4071938" y="3195638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3D9959"/>
                </a:solidFill>
                <a:effectLst/>
                <a:latin typeface="Adobe Devanagari" panose="02040503050201020203" pitchFamily="18" charset="0"/>
              </a:rPr>
              <a:t>45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73" name="Rectangle 271"/>
          <p:cNvSpPr>
            <a:spLocks noChangeArrowheads="1"/>
          </p:cNvSpPr>
          <p:nvPr/>
        </p:nvSpPr>
        <p:spPr bwMode="auto">
          <a:xfrm>
            <a:off x="3796507" y="7396163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993D92"/>
                </a:solidFill>
                <a:effectLst/>
                <a:latin typeface="Adobe Devanagari" panose="02040503050201020203" pitchFamily="18" charset="0"/>
              </a:rPr>
              <a:t>92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74" name="Rectangle 272"/>
          <p:cNvSpPr>
            <a:spLocks noChangeArrowheads="1"/>
          </p:cNvSpPr>
          <p:nvPr/>
        </p:nvSpPr>
        <p:spPr bwMode="auto">
          <a:xfrm>
            <a:off x="3748882" y="3131344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B952CC"/>
                </a:solidFill>
                <a:effectLst/>
                <a:latin typeface="Adobe Devanagari" panose="02040503050201020203" pitchFamily="18" charset="0"/>
              </a:rPr>
              <a:t>87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75" name="Rectangle 273"/>
          <p:cNvSpPr>
            <a:spLocks noChangeArrowheads="1"/>
          </p:cNvSpPr>
          <p:nvPr/>
        </p:nvSpPr>
        <p:spPr bwMode="auto">
          <a:xfrm>
            <a:off x="4285457" y="6974682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CC52A6"/>
                </a:solidFill>
                <a:effectLst/>
                <a:latin typeface="Adobe Devanagari" panose="02040503050201020203" pitchFamily="18" charset="0"/>
              </a:rPr>
              <a:t>95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76" name="Rectangle 274"/>
          <p:cNvSpPr>
            <a:spLocks noChangeArrowheads="1"/>
          </p:cNvSpPr>
          <p:nvPr/>
        </p:nvSpPr>
        <p:spPr bwMode="auto">
          <a:xfrm>
            <a:off x="4067969" y="8921751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52CCCC"/>
                </a:solidFill>
                <a:effectLst/>
                <a:latin typeface="Adobe Devanagari" panose="02040503050201020203" pitchFamily="18" charset="0"/>
              </a:rPr>
              <a:t>53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77" name="Rectangle 275"/>
          <p:cNvSpPr>
            <a:spLocks noChangeArrowheads="1"/>
          </p:cNvSpPr>
          <p:nvPr/>
        </p:nvSpPr>
        <p:spPr bwMode="auto">
          <a:xfrm>
            <a:off x="1083469" y="1192213"/>
            <a:ext cx="13946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993D52"/>
                </a:solidFill>
                <a:effectLst/>
                <a:latin typeface="Adobe Devanagari" panose="02040503050201020203" pitchFamily="18" charset="0"/>
              </a:rPr>
              <a:t>100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78" name="Rectangle 276"/>
          <p:cNvSpPr>
            <a:spLocks noChangeArrowheads="1"/>
          </p:cNvSpPr>
          <p:nvPr/>
        </p:nvSpPr>
        <p:spPr bwMode="auto">
          <a:xfrm>
            <a:off x="846931" y="1793876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3D9944"/>
                </a:solidFill>
                <a:effectLst/>
                <a:latin typeface="Adobe Devanagari" panose="02040503050201020203" pitchFamily="18" charset="0"/>
              </a:rPr>
              <a:t>4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79" name="Rectangle 277"/>
          <p:cNvSpPr>
            <a:spLocks noChangeArrowheads="1"/>
          </p:cNvSpPr>
          <p:nvPr/>
        </p:nvSpPr>
        <p:spPr bwMode="auto">
          <a:xfrm>
            <a:off x="3574256" y="5703094"/>
            <a:ext cx="13946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993D52"/>
                </a:solidFill>
                <a:effectLst/>
                <a:latin typeface="Adobe Devanagari" panose="02040503050201020203" pitchFamily="18" charset="0"/>
              </a:rPr>
              <a:t>100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80" name="Rectangle 278"/>
          <p:cNvSpPr>
            <a:spLocks noChangeArrowheads="1"/>
          </p:cNvSpPr>
          <p:nvPr/>
        </p:nvSpPr>
        <p:spPr bwMode="auto">
          <a:xfrm>
            <a:off x="3863181" y="8085138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9DCC52"/>
                </a:solidFill>
                <a:effectLst/>
                <a:latin typeface="Adobe Devanagari" panose="02040503050201020203" pitchFamily="18" charset="0"/>
              </a:rPr>
              <a:t>26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81" name="Rectangle 279"/>
          <p:cNvSpPr>
            <a:spLocks noChangeArrowheads="1"/>
          </p:cNvSpPr>
          <p:nvPr/>
        </p:nvSpPr>
        <p:spPr bwMode="auto">
          <a:xfrm>
            <a:off x="2743994" y="5467351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6452CC"/>
                </a:solidFill>
                <a:effectLst/>
                <a:latin typeface="Adobe Devanagari" panose="02040503050201020203" pitchFamily="18" charset="0"/>
              </a:rPr>
              <a:t>70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82" name="Rectangle 280"/>
          <p:cNvSpPr>
            <a:spLocks noChangeArrowheads="1"/>
          </p:cNvSpPr>
          <p:nvPr/>
        </p:nvSpPr>
        <p:spPr bwMode="auto">
          <a:xfrm>
            <a:off x="3948112" y="8306594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997D3D"/>
                </a:solidFill>
                <a:effectLst/>
                <a:latin typeface="Adobe Devanagari" panose="02040503050201020203" pitchFamily="18" charset="0"/>
              </a:rPr>
              <a:t>17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83" name="Rectangle 281"/>
          <p:cNvSpPr>
            <a:spLocks noChangeArrowheads="1"/>
          </p:cNvSpPr>
          <p:nvPr/>
        </p:nvSpPr>
        <p:spPr bwMode="auto">
          <a:xfrm>
            <a:off x="4425156" y="2532857"/>
            <a:ext cx="13946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993D52"/>
                </a:solidFill>
                <a:effectLst/>
                <a:latin typeface="Adobe Devanagari" panose="02040503050201020203" pitchFamily="18" charset="0"/>
              </a:rPr>
              <a:t>100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84" name="Rectangle 282"/>
          <p:cNvSpPr>
            <a:spLocks noChangeArrowheads="1"/>
          </p:cNvSpPr>
          <p:nvPr/>
        </p:nvSpPr>
        <p:spPr bwMode="auto">
          <a:xfrm>
            <a:off x="653257" y="9472613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CCA652"/>
                </a:solidFill>
                <a:effectLst/>
                <a:latin typeface="Adobe Devanagari" panose="02040503050201020203" pitchFamily="18" charset="0"/>
              </a:rPr>
              <a:t>16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85" name="Rectangle 283"/>
          <p:cNvSpPr>
            <a:spLocks noChangeArrowheads="1"/>
          </p:cNvSpPr>
          <p:nvPr/>
        </p:nvSpPr>
        <p:spPr bwMode="auto">
          <a:xfrm>
            <a:off x="3332163" y="9167019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3D996F"/>
                </a:solidFill>
                <a:effectLst/>
                <a:latin typeface="Adobe Devanagari" panose="02040503050201020203" pitchFamily="18" charset="0"/>
              </a:rPr>
              <a:t>48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86" name="Rectangle 284"/>
          <p:cNvSpPr>
            <a:spLocks noChangeArrowheads="1"/>
          </p:cNvSpPr>
          <p:nvPr/>
        </p:nvSpPr>
        <p:spPr bwMode="auto">
          <a:xfrm>
            <a:off x="682626" y="3314701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99683D"/>
                </a:solidFill>
                <a:effectLst/>
                <a:latin typeface="Adobe Devanagari" panose="02040503050201020203" pitchFamily="18" charset="0"/>
              </a:rPr>
              <a:t>14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87" name="Rectangle 285"/>
          <p:cNvSpPr>
            <a:spLocks noChangeArrowheads="1"/>
          </p:cNvSpPr>
          <p:nvPr/>
        </p:nvSpPr>
        <p:spPr bwMode="auto">
          <a:xfrm>
            <a:off x="2581276" y="6010276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99923D"/>
                </a:solidFill>
                <a:effectLst/>
                <a:latin typeface="Adobe Devanagari" panose="02040503050201020203" pitchFamily="18" charset="0"/>
              </a:rPr>
              <a:t>20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88" name="Rectangle 286"/>
          <p:cNvSpPr>
            <a:spLocks noChangeArrowheads="1"/>
          </p:cNvSpPr>
          <p:nvPr/>
        </p:nvSpPr>
        <p:spPr bwMode="auto">
          <a:xfrm>
            <a:off x="3378200" y="2828131"/>
            <a:ext cx="13946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993D52"/>
                </a:solidFill>
                <a:effectLst/>
                <a:latin typeface="Adobe Devanagari" panose="02040503050201020203" pitchFamily="18" charset="0"/>
              </a:rPr>
              <a:t>100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89" name="Rectangle 287"/>
          <p:cNvSpPr>
            <a:spLocks noChangeArrowheads="1"/>
          </p:cNvSpPr>
          <p:nvPr/>
        </p:nvSpPr>
        <p:spPr bwMode="auto">
          <a:xfrm>
            <a:off x="3937001" y="6700839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763D99"/>
                </a:solidFill>
                <a:effectLst/>
                <a:latin typeface="Adobe Devanagari" panose="02040503050201020203" pitchFamily="18" charset="0"/>
              </a:rPr>
              <a:t>85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90" name="Rectangle 288"/>
          <p:cNvSpPr>
            <a:spLocks noChangeArrowheads="1"/>
          </p:cNvSpPr>
          <p:nvPr/>
        </p:nvSpPr>
        <p:spPr bwMode="auto">
          <a:xfrm>
            <a:off x="1965325" y="7168357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9DCC52"/>
                </a:solidFill>
                <a:effectLst/>
                <a:latin typeface="Adobe Devanagari" panose="02040503050201020203" pitchFamily="18" charset="0"/>
              </a:rPr>
              <a:t>26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91" name="Rectangle 289"/>
          <p:cNvSpPr>
            <a:spLocks noChangeArrowheads="1"/>
          </p:cNvSpPr>
          <p:nvPr/>
        </p:nvSpPr>
        <p:spPr bwMode="auto">
          <a:xfrm>
            <a:off x="922338" y="1658938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3D9944"/>
                </a:solidFill>
                <a:effectLst/>
                <a:latin typeface="Adobe Devanagari" panose="02040503050201020203" pitchFamily="18" charset="0"/>
              </a:rPr>
              <a:t>4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92" name="Rectangle 290"/>
          <p:cNvSpPr>
            <a:spLocks noChangeArrowheads="1"/>
          </p:cNvSpPr>
          <p:nvPr/>
        </p:nvSpPr>
        <p:spPr bwMode="auto">
          <a:xfrm>
            <a:off x="4489450" y="3995738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8B3D99"/>
                </a:solidFill>
                <a:effectLst/>
                <a:latin typeface="Adobe Devanagari" panose="02040503050201020203" pitchFamily="18" charset="0"/>
              </a:rPr>
              <a:t>88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93" name="Rectangle 291"/>
          <p:cNvSpPr>
            <a:spLocks noChangeArrowheads="1"/>
          </p:cNvSpPr>
          <p:nvPr/>
        </p:nvSpPr>
        <p:spPr bwMode="auto">
          <a:xfrm>
            <a:off x="3025775" y="8727283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613D99"/>
                </a:solidFill>
                <a:effectLst/>
                <a:latin typeface="Adobe Devanagari" panose="02040503050201020203" pitchFamily="18" charset="0"/>
              </a:rPr>
              <a:t>74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94" name="Rectangle 292"/>
          <p:cNvSpPr>
            <a:spLocks noChangeArrowheads="1"/>
          </p:cNvSpPr>
          <p:nvPr/>
        </p:nvSpPr>
        <p:spPr bwMode="auto">
          <a:xfrm>
            <a:off x="1170782" y="2075657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CC528A"/>
                </a:solidFill>
                <a:effectLst/>
                <a:latin typeface="Adobe Devanagari" panose="02040503050201020203" pitchFamily="18" charset="0"/>
              </a:rPr>
              <a:t>97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95" name="Rectangle 293"/>
          <p:cNvSpPr>
            <a:spLocks noChangeArrowheads="1"/>
          </p:cNvSpPr>
          <p:nvPr/>
        </p:nvSpPr>
        <p:spPr bwMode="auto">
          <a:xfrm>
            <a:off x="1881188" y="6322220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99523D"/>
                </a:solidFill>
                <a:effectLst/>
                <a:latin typeface="Adobe Devanagari" panose="02040503050201020203" pitchFamily="18" charset="0"/>
              </a:rPr>
              <a:t>1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96" name="Rectangle 294"/>
          <p:cNvSpPr>
            <a:spLocks noChangeArrowheads="1"/>
          </p:cNvSpPr>
          <p:nvPr/>
        </p:nvSpPr>
        <p:spPr bwMode="auto">
          <a:xfrm>
            <a:off x="3543300" y="2519364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3D9999"/>
                </a:solidFill>
                <a:effectLst/>
                <a:latin typeface="Adobe Devanagari" panose="02040503050201020203" pitchFamily="18" charset="0"/>
              </a:rPr>
              <a:t>55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97" name="Rectangle 295"/>
          <p:cNvSpPr>
            <a:spLocks noChangeArrowheads="1"/>
          </p:cNvSpPr>
          <p:nvPr/>
        </p:nvSpPr>
        <p:spPr bwMode="auto">
          <a:xfrm>
            <a:off x="4474369" y="3204369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3D5999"/>
                </a:solidFill>
                <a:effectLst/>
                <a:latin typeface="Adobe Devanagari" panose="02040503050201020203" pitchFamily="18" charset="0"/>
              </a:rPr>
              <a:t>64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98" name="Rectangle 296"/>
          <p:cNvSpPr>
            <a:spLocks noChangeArrowheads="1"/>
          </p:cNvSpPr>
          <p:nvPr/>
        </p:nvSpPr>
        <p:spPr bwMode="auto">
          <a:xfrm>
            <a:off x="4324350" y="3124995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525BCC"/>
                </a:solidFill>
                <a:effectLst/>
                <a:latin typeface="Adobe Devanagari" panose="02040503050201020203" pitchFamily="18" charset="0"/>
              </a:rPr>
              <a:t>66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99" name="Rectangle 297"/>
          <p:cNvSpPr>
            <a:spLocks noChangeArrowheads="1"/>
          </p:cNvSpPr>
          <p:nvPr/>
        </p:nvSpPr>
        <p:spPr bwMode="auto">
          <a:xfrm>
            <a:off x="2923381" y="5319713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52CCCC"/>
                </a:solidFill>
                <a:effectLst/>
                <a:latin typeface="Adobe Devanagari" panose="02040503050201020203" pitchFamily="18" charset="0"/>
              </a:rPr>
              <a:t>53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0" name="Rectangle 298"/>
          <p:cNvSpPr>
            <a:spLocks noChangeArrowheads="1"/>
          </p:cNvSpPr>
          <p:nvPr/>
        </p:nvSpPr>
        <p:spPr bwMode="auto">
          <a:xfrm>
            <a:off x="3354387" y="8724107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5277CC"/>
                </a:solidFill>
                <a:effectLst/>
                <a:latin typeface="Adobe Devanagari" panose="02040503050201020203" pitchFamily="18" charset="0"/>
              </a:rPr>
              <a:t>63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1" name="Rectangle 299"/>
          <p:cNvSpPr>
            <a:spLocks noChangeArrowheads="1"/>
          </p:cNvSpPr>
          <p:nvPr/>
        </p:nvSpPr>
        <p:spPr bwMode="auto">
          <a:xfrm>
            <a:off x="2462213" y="8054976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525BCC"/>
                </a:solidFill>
                <a:effectLst/>
                <a:latin typeface="Adobe Devanagari" panose="02040503050201020203" pitchFamily="18" charset="0"/>
              </a:rPr>
              <a:t>66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2" name="Rectangle 300"/>
          <p:cNvSpPr>
            <a:spLocks noChangeArrowheads="1"/>
          </p:cNvSpPr>
          <p:nvPr/>
        </p:nvSpPr>
        <p:spPr bwMode="auto">
          <a:xfrm>
            <a:off x="984250" y="622301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CC528A"/>
                </a:solidFill>
                <a:effectLst/>
                <a:latin typeface="Adobe Devanagari" panose="02040503050201020203" pitchFamily="18" charset="0"/>
              </a:rPr>
              <a:t>97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3" name="Rectangle 301"/>
          <p:cNvSpPr>
            <a:spLocks noChangeArrowheads="1"/>
          </p:cNvSpPr>
          <p:nvPr/>
        </p:nvSpPr>
        <p:spPr bwMode="auto">
          <a:xfrm>
            <a:off x="2767807" y="5629275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4B993D"/>
                </a:solidFill>
                <a:effectLst/>
                <a:latin typeface="Adobe Devanagari" panose="02040503050201020203" pitchFamily="18" charset="0"/>
              </a:rPr>
              <a:t>38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4" name="Rectangle 302"/>
          <p:cNvSpPr>
            <a:spLocks noChangeArrowheads="1"/>
          </p:cNvSpPr>
          <p:nvPr/>
        </p:nvSpPr>
        <p:spPr bwMode="auto">
          <a:xfrm>
            <a:off x="3560763" y="9253538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8B3D99"/>
                </a:solidFill>
                <a:effectLst/>
                <a:latin typeface="Adobe Devanagari" panose="02040503050201020203" pitchFamily="18" charset="0"/>
              </a:rPr>
              <a:t>88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5" name="Rectangle 303"/>
          <p:cNvSpPr>
            <a:spLocks noChangeArrowheads="1"/>
          </p:cNvSpPr>
          <p:nvPr/>
        </p:nvSpPr>
        <p:spPr bwMode="auto">
          <a:xfrm>
            <a:off x="715169" y="1626395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3D8499"/>
                </a:solidFill>
                <a:effectLst/>
                <a:latin typeface="Adobe Devanagari" panose="02040503050201020203" pitchFamily="18" charset="0"/>
              </a:rPr>
              <a:t>58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6" name="Rectangle 304"/>
          <p:cNvSpPr>
            <a:spLocks noChangeArrowheads="1"/>
          </p:cNvSpPr>
          <p:nvPr/>
        </p:nvSpPr>
        <p:spPr bwMode="auto">
          <a:xfrm>
            <a:off x="565945" y="2414588"/>
            <a:ext cx="4648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993D3D"/>
                </a:solidFill>
                <a:effectLst/>
                <a:latin typeface="Adobe Devanagari" panose="02040503050201020203" pitchFamily="18" charset="0"/>
              </a:rPr>
              <a:t>8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7" name="Rectangle 305"/>
          <p:cNvSpPr>
            <a:spLocks noChangeArrowheads="1"/>
          </p:cNvSpPr>
          <p:nvPr/>
        </p:nvSpPr>
        <p:spPr bwMode="auto">
          <a:xfrm>
            <a:off x="1026320" y="1749425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52CC94"/>
                </a:solidFill>
                <a:effectLst/>
                <a:latin typeface="Adobe Devanagari" panose="02040503050201020203" pitchFamily="18" charset="0"/>
              </a:rPr>
              <a:t>47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8" name="Rectangle 306"/>
          <p:cNvSpPr>
            <a:spLocks noChangeArrowheads="1"/>
          </p:cNvSpPr>
          <p:nvPr/>
        </p:nvSpPr>
        <p:spPr bwMode="auto">
          <a:xfrm>
            <a:off x="4237831" y="8098632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5294CC"/>
                </a:solidFill>
                <a:effectLst/>
                <a:latin typeface="Adobe Devanagari" panose="02040503050201020203" pitchFamily="18" charset="0"/>
              </a:rPr>
              <a:t>59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9" name="Rectangle 307"/>
          <p:cNvSpPr>
            <a:spLocks noChangeArrowheads="1"/>
          </p:cNvSpPr>
          <p:nvPr/>
        </p:nvSpPr>
        <p:spPr bwMode="auto">
          <a:xfrm>
            <a:off x="257969" y="883444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CCA652"/>
                </a:solidFill>
                <a:effectLst/>
                <a:latin typeface="Adobe Devanagari" panose="02040503050201020203" pitchFamily="18" charset="0"/>
              </a:rPr>
              <a:t>16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10" name="Rectangle 308"/>
          <p:cNvSpPr>
            <a:spLocks noChangeArrowheads="1"/>
          </p:cNvSpPr>
          <p:nvPr/>
        </p:nvSpPr>
        <p:spPr bwMode="auto">
          <a:xfrm>
            <a:off x="4172744" y="3013870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81CC52"/>
                </a:solidFill>
                <a:effectLst/>
                <a:latin typeface="Adobe Devanagari" panose="02040503050201020203" pitchFamily="18" charset="0"/>
              </a:rPr>
              <a:t>28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11" name="Rectangle 309"/>
          <p:cNvSpPr>
            <a:spLocks noChangeArrowheads="1"/>
          </p:cNvSpPr>
          <p:nvPr/>
        </p:nvSpPr>
        <p:spPr bwMode="auto">
          <a:xfrm>
            <a:off x="2180432" y="5448301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64CC52"/>
                </a:solidFill>
                <a:effectLst/>
                <a:latin typeface="Adobe Devanagari" panose="02040503050201020203" pitchFamily="18" charset="0"/>
              </a:rPr>
              <a:t>33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12" name="Rectangle 310"/>
          <p:cNvSpPr>
            <a:spLocks noChangeArrowheads="1"/>
          </p:cNvSpPr>
          <p:nvPr/>
        </p:nvSpPr>
        <p:spPr bwMode="auto">
          <a:xfrm>
            <a:off x="3943350" y="3455988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52CCB0"/>
                </a:solidFill>
                <a:effectLst/>
                <a:latin typeface="Adobe Devanagari" panose="02040503050201020203" pitchFamily="18" charset="0"/>
              </a:rPr>
              <a:t>5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13" name="Rectangle 311"/>
          <p:cNvSpPr>
            <a:spLocks noChangeArrowheads="1"/>
          </p:cNvSpPr>
          <p:nvPr/>
        </p:nvSpPr>
        <p:spPr bwMode="auto">
          <a:xfrm>
            <a:off x="4757738" y="4375151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993D68"/>
                </a:solidFill>
                <a:effectLst/>
                <a:latin typeface="Adobe Devanagari" panose="02040503050201020203" pitchFamily="18" charset="0"/>
              </a:rPr>
              <a:t>98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14" name="Rectangle 312"/>
          <p:cNvSpPr>
            <a:spLocks noChangeArrowheads="1"/>
          </p:cNvSpPr>
          <p:nvPr/>
        </p:nvSpPr>
        <p:spPr bwMode="auto">
          <a:xfrm>
            <a:off x="2361407" y="5778500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81CC52"/>
                </a:solidFill>
                <a:effectLst/>
                <a:latin typeface="Adobe Devanagari" panose="02040503050201020203" pitchFamily="18" charset="0"/>
              </a:rPr>
              <a:t>28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15" name="Rectangle 313"/>
          <p:cNvSpPr>
            <a:spLocks noChangeArrowheads="1"/>
          </p:cNvSpPr>
          <p:nvPr/>
        </p:nvSpPr>
        <p:spPr bwMode="auto">
          <a:xfrm>
            <a:off x="4529932" y="6678614"/>
            <a:ext cx="13946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993D52"/>
                </a:solidFill>
                <a:effectLst/>
                <a:latin typeface="Adobe Devanagari" panose="02040503050201020203" pitchFamily="18" charset="0"/>
              </a:rPr>
              <a:t>100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16" name="Rectangle 314"/>
          <p:cNvSpPr>
            <a:spLocks noChangeArrowheads="1"/>
          </p:cNvSpPr>
          <p:nvPr/>
        </p:nvSpPr>
        <p:spPr bwMode="auto">
          <a:xfrm>
            <a:off x="4033044" y="2446338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993D92"/>
                </a:solidFill>
                <a:effectLst/>
                <a:latin typeface="Adobe Devanagari" panose="02040503050201020203" pitchFamily="18" charset="0"/>
              </a:rPr>
              <a:t>92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17" name="Rectangle 315"/>
          <p:cNvSpPr>
            <a:spLocks noChangeArrowheads="1"/>
          </p:cNvSpPr>
          <p:nvPr/>
        </p:nvSpPr>
        <p:spPr bwMode="auto">
          <a:xfrm>
            <a:off x="4316413" y="3733801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993D68"/>
                </a:solidFill>
                <a:effectLst/>
                <a:latin typeface="Adobe Devanagari" panose="02040503050201020203" pitchFamily="18" charset="0"/>
              </a:rPr>
              <a:t>98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18" name="Rectangle 316"/>
          <p:cNvSpPr>
            <a:spLocks noChangeArrowheads="1"/>
          </p:cNvSpPr>
          <p:nvPr/>
        </p:nvSpPr>
        <p:spPr bwMode="auto">
          <a:xfrm>
            <a:off x="4171950" y="6447632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993D68"/>
                </a:solidFill>
                <a:effectLst/>
                <a:latin typeface="Adobe Devanagari" panose="02040503050201020203" pitchFamily="18" charset="0"/>
              </a:rPr>
              <a:t>98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19" name="Rectangle 317"/>
          <p:cNvSpPr>
            <a:spLocks noChangeArrowheads="1"/>
          </p:cNvSpPr>
          <p:nvPr/>
        </p:nvSpPr>
        <p:spPr bwMode="auto">
          <a:xfrm>
            <a:off x="608012" y="1482726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B9CC52"/>
                </a:solidFill>
                <a:effectLst/>
                <a:latin typeface="Adobe Devanagari" panose="02040503050201020203" pitchFamily="18" charset="0"/>
              </a:rPr>
              <a:t>24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20" name="Rectangle 318"/>
          <p:cNvSpPr>
            <a:spLocks noChangeArrowheads="1"/>
          </p:cNvSpPr>
          <p:nvPr/>
        </p:nvSpPr>
        <p:spPr bwMode="auto">
          <a:xfrm>
            <a:off x="4513262" y="7281864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CC52C3"/>
                </a:solidFill>
                <a:effectLst/>
                <a:latin typeface="Adobe Devanagari" panose="02040503050201020203" pitchFamily="18" charset="0"/>
              </a:rPr>
              <a:t>90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21" name="Rectangle 319"/>
          <p:cNvSpPr>
            <a:spLocks noChangeArrowheads="1"/>
          </p:cNvSpPr>
          <p:nvPr/>
        </p:nvSpPr>
        <p:spPr bwMode="auto">
          <a:xfrm>
            <a:off x="688975" y="900114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763D99"/>
                </a:solidFill>
                <a:effectLst/>
                <a:latin typeface="Adobe Devanagari" panose="02040503050201020203" pitchFamily="18" charset="0"/>
              </a:rPr>
              <a:t>85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22" name="Rectangle 320"/>
          <p:cNvSpPr>
            <a:spLocks noChangeArrowheads="1"/>
          </p:cNvSpPr>
          <p:nvPr/>
        </p:nvSpPr>
        <p:spPr bwMode="auto">
          <a:xfrm>
            <a:off x="446882" y="1658938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CC6E52"/>
                </a:solidFill>
                <a:effectLst/>
                <a:latin typeface="Adobe Devanagari" panose="02040503050201020203" pitchFamily="18" charset="0"/>
              </a:rPr>
              <a:t>10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23" name="Rectangle 321"/>
          <p:cNvSpPr>
            <a:spLocks noChangeArrowheads="1"/>
          </p:cNvSpPr>
          <p:nvPr/>
        </p:nvSpPr>
        <p:spPr bwMode="auto">
          <a:xfrm>
            <a:off x="3839369" y="2344739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993D68"/>
                </a:solidFill>
                <a:effectLst/>
                <a:latin typeface="Adobe Devanagari" panose="02040503050201020203" pitchFamily="18" charset="0"/>
              </a:rPr>
              <a:t>98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24" name="Rectangle 322"/>
          <p:cNvSpPr>
            <a:spLocks noChangeArrowheads="1"/>
          </p:cNvSpPr>
          <p:nvPr/>
        </p:nvSpPr>
        <p:spPr bwMode="auto">
          <a:xfrm>
            <a:off x="1743075" y="4552951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52CC77"/>
                </a:solidFill>
                <a:effectLst/>
                <a:latin typeface="Adobe Devanagari" panose="02040503050201020203" pitchFamily="18" charset="0"/>
              </a:rPr>
              <a:t>43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325" name="ZoneTexte 324"/>
          <p:cNvSpPr txBox="1"/>
          <p:nvPr/>
        </p:nvSpPr>
        <p:spPr>
          <a:xfrm>
            <a:off x="5165726" y="461963"/>
            <a:ext cx="1482725" cy="138499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1200" b="1" dirty="0" smtClean="0"/>
              <a:t>6mA </a:t>
            </a:r>
            <a:r>
              <a:rPr lang="fr-FR" sz="1200" b="1" dirty="0" err="1" smtClean="0"/>
              <a:t>demethylase</a:t>
            </a:r>
            <a:endParaRPr lang="fr-FR" sz="1200" b="1" dirty="0" smtClean="0"/>
          </a:p>
          <a:p>
            <a:r>
              <a:rPr lang="fr-FR" sz="1200" b="1" dirty="0" err="1" smtClean="0"/>
              <a:t>AlKB</a:t>
            </a:r>
            <a:endParaRPr lang="fr-FR" sz="1200" b="1" dirty="0" smtClean="0"/>
          </a:p>
          <a:p>
            <a:r>
              <a:rPr lang="fr-FR" sz="1200" dirty="0" smtClean="0"/>
              <a:t>RAXML</a:t>
            </a:r>
          </a:p>
          <a:p>
            <a:r>
              <a:rPr lang="fr-FR" sz="1200" dirty="0" err="1" smtClean="0"/>
              <a:t>Trimal</a:t>
            </a:r>
            <a:r>
              <a:rPr lang="fr-FR" sz="1200" dirty="0" smtClean="0"/>
              <a:t> gt 0.5</a:t>
            </a:r>
          </a:p>
          <a:p>
            <a:r>
              <a:rPr lang="fr-FR" sz="1200" dirty="0" smtClean="0"/>
              <a:t>PROTGAMMAUTO</a:t>
            </a:r>
          </a:p>
          <a:p>
            <a:r>
              <a:rPr lang="fr-FR" sz="1200" dirty="0" smtClean="0"/>
              <a:t>800 </a:t>
            </a:r>
            <a:r>
              <a:rPr lang="fr-FR" sz="1200" dirty="0" err="1" smtClean="0"/>
              <a:t>bootstrap</a:t>
            </a:r>
            <a:endParaRPr lang="fr-FR" sz="1200" dirty="0" smtClean="0"/>
          </a:p>
          <a:p>
            <a:r>
              <a:rPr lang="fr-FR" sz="1200" dirty="0" smtClean="0"/>
              <a:t>Best model = LG</a:t>
            </a:r>
            <a:endParaRPr lang="fr-FR" dirty="0"/>
          </a:p>
        </p:txBody>
      </p:sp>
      <p:sp>
        <p:nvSpPr>
          <p:cNvPr id="326" name="Rectangle 253"/>
          <p:cNvSpPr>
            <a:spLocks noChangeArrowheads="1"/>
          </p:cNvSpPr>
          <p:nvPr/>
        </p:nvSpPr>
        <p:spPr bwMode="auto">
          <a:xfrm>
            <a:off x="5006206" y="9264427"/>
            <a:ext cx="44242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Adobe Devanagari" panose="02040503050201020203" pitchFamily="18" charset="0"/>
              </a:rPr>
              <a:t>NMAD-1</a:t>
            </a:r>
            <a:endParaRPr kumimoji="0" lang="fr-FR" altLang="fr-FR" sz="800" b="1" i="0" u="none" strike="noStrike" cap="none" normalizeH="0" baseline="0" dirty="0" smtClean="0">
              <a:ln>
                <a:noFill/>
              </a:ln>
              <a:solidFill>
                <a:srgbClr val="FF0000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79446997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1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Thème1" id="{8369EA16-FC18-420F-B65D-1B55019E0363}" vid="{80D3CE8A-49F4-4B44-AEE0-29301DB73F46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</Template>
  <TotalTime>21</TotalTime>
  <Words>160</Words>
  <Application>Microsoft Office PowerPoint</Application>
  <PresentationFormat>Format A4 (210 x 297 mm)</PresentationFormat>
  <Paragraphs>153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1</vt:lpstr>
      <vt:lpstr>Présentation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tienne Danchin</dc:creator>
  <cp:lastModifiedBy>zurletto</cp:lastModifiedBy>
  <cp:revision>11</cp:revision>
  <dcterms:created xsi:type="dcterms:W3CDTF">2018-02-13T14:22:59Z</dcterms:created>
  <dcterms:modified xsi:type="dcterms:W3CDTF">2018-02-28T08:24:59Z</dcterms:modified>
</cp:coreProperties>
</file>